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039F87-7CD1-4903-80DA-E880C5EBA5E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B33B47-7C8A-4AAA-8E06-0C35CDA02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051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B3E609A-BEE2-484C-AE0F-B55570F1C34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1772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240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120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627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187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189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564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070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877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784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029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022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CDFEF7-8EA0-44A7-A109-05ABF9CB9B7E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114ED6-35CD-497A-B887-0D9554B50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591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617118" y="424395"/>
            <a:ext cx="5662396" cy="1119919"/>
            <a:chOff x="1474788" y="2029496"/>
            <a:chExt cx="5662396" cy="1119919"/>
          </a:xfrm>
        </p:grpSpPr>
        <p:sp>
          <p:nvSpPr>
            <p:cNvPr id="4" name="Rectangle 106"/>
            <p:cNvSpPr>
              <a:spLocks noChangeArrowheads="1"/>
            </p:cNvSpPr>
            <p:nvPr/>
          </p:nvSpPr>
          <p:spPr bwMode="auto">
            <a:xfrm>
              <a:off x="1512903" y="2966937"/>
              <a:ext cx="10164" cy="43446"/>
            </a:xfrm>
            <a:prstGeom prst="rect">
              <a:avLst/>
            </a:prstGeom>
            <a:solidFill>
              <a:srgbClr val="FFFFCC"/>
            </a:solidFill>
            <a:ln w="0">
              <a:solidFill>
                <a:srgbClr val="CCCC99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5" name="Rectangle 107"/>
            <p:cNvSpPr>
              <a:spLocks noChangeArrowheads="1"/>
            </p:cNvSpPr>
            <p:nvPr/>
          </p:nvSpPr>
          <p:spPr bwMode="auto">
            <a:xfrm>
              <a:off x="1523067" y="2966937"/>
              <a:ext cx="5066693" cy="43446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6" name="Line 111"/>
            <p:cNvSpPr>
              <a:spLocks noChangeShapeType="1"/>
            </p:cNvSpPr>
            <p:nvPr/>
          </p:nvSpPr>
          <p:spPr bwMode="auto">
            <a:xfrm flipH="1">
              <a:off x="5410750" y="2570670"/>
              <a:ext cx="40656" cy="3325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7" name="Rectangle 112"/>
            <p:cNvSpPr>
              <a:spLocks noChangeArrowheads="1"/>
            </p:cNvSpPr>
            <p:nvPr/>
          </p:nvSpPr>
          <p:spPr bwMode="auto">
            <a:xfrm>
              <a:off x="5314806" y="2260609"/>
              <a:ext cx="436018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/>
                <a:t>Neo</a:t>
              </a:r>
              <a:endParaRPr lang="en-US" altLang="en-US" sz="2000" b="1" dirty="0"/>
            </a:p>
          </p:txBody>
        </p:sp>
        <p:sp>
          <p:nvSpPr>
            <p:cNvPr id="8" name="Line 114"/>
            <p:cNvSpPr>
              <a:spLocks noChangeShapeType="1"/>
            </p:cNvSpPr>
            <p:nvPr/>
          </p:nvSpPr>
          <p:spPr bwMode="auto">
            <a:xfrm flipH="1">
              <a:off x="3459124" y="2763974"/>
              <a:ext cx="2542" cy="1853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9" name="Rectangle 115"/>
            <p:cNvSpPr>
              <a:spLocks noChangeArrowheads="1"/>
            </p:cNvSpPr>
            <p:nvPr/>
          </p:nvSpPr>
          <p:spPr bwMode="auto">
            <a:xfrm>
              <a:off x="3175711" y="2421334"/>
              <a:ext cx="50654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err="1" smtClean="0"/>
                <a:t>Lig</a:t>
              </a:r>
              <a:r>
                <a:rPr lang="en-US" altLang="en-US" sz="2000" b="1" dirty="0" smtClean="0"/>
                <a:t> A</a:t>
              </a:r>
              <a:endParaRPr lang="en-US" altLang="en-US" sz="2000" b="1" dirty="0"/>
            </a:p>
          </p:txBody>
        </p:sp>
        <p:sp>
          <p:nvSpPr>
            <p:cNvPr id="10" name="Line 117"/>
            <p:cNvSpPr>
              <a:spLocks noChangeShapeType="1"/>
            </p:cNvSpPr>
            <p:nvPr/>
          </p:nvSpPr>
          <p:spPr bwMode="auto">
            <a:xfrm>
              <a:off x="1782246" y="2691770"/>
              <a:ext cx="94015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1" name="Rectangle 118"/>
            <p:cNvSpPr>
              <a:spLocks noChangeArrowheads="1"/>
            </p:cNvSpPr>
            <p:nvPr/>
          </p:nvSpPr>
          <p:spPr bwMode="auto">
            <a:xfrm>
              <a:off x="1474788" y="2462948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</a:rPr>
                <a:t>LTR</a:t>
              </a:r>
              <a:endParaRPr lang="en-US" altLang="en-US" sz="3200"/>
            </a:p>
          </p:txBody>
        </p:sp>
        <p:sp>
          <p:nvSpPr>
            <p:cNvPr id="12" name="Line 120"/>
            <p:cNvSpPr>
              <a:spLocks noChangeShapeType="1"/>
            </p:cNvSpPr>
            <p:nvPr/>
          </p:nvSpPr>
          <p:spPr bwMode="auto">
            <a:xfrm flipH="1">
              <a:off x="6804523" y="2691770"/>
              <a:ext cx="71147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3" name="Rectangle 121"/>
            <p:cNvSpPr>
              <a:spLocks noChangeArrowheads="1"/>
            </p:cNvSpPr>
            <p:nvPr/>
          </p:nvSpPr>
          <p:spPr bwMode="auto">
            <a:xfrm>
              <a:off x="6885834" y="2462948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>
                  <a:solidFill>
                    <a:srgbClr val="000000"/>
                  </a:solidFill>
                </a:rPr>
                <a:t>LTR</a:t>
              </a:r>
              <a:endParaRPr lang="en-US" altLang="en-US" sz="3200" dirty="0"/>
            </a:p>
          </p:txBody>
        </p:sp>
        <p:sp>
          <p:nvSpPr>
            <p:cNvPr id="16" name="Line 150"/>
            <p:cNvSpPr>
              <a:spLocks noChangeShapeType="1"/>
            </p:cNvSpPr>
            <p:nvPr/>
          </p:nvSpPr>
          <p:spPr bwMode="auto">
            <a:xfrm flipH="1">
              <a:off x="4818704" y="2410146"/>
              <a:ext cx="14855" cy="4930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7" name="Rectangle 151"/>
            <p:cNvSpPr>
              <a:spLocks noChangeArrowheads="1"/>
            </p:cNvSpPr>
            <p:nvPr/>
          </p:nvSpPr>
          <p:spPr bwMode="auto">
            <a:xfrm>
              <a:off x="4647739" y="2169600"/>
              <a:ext cx="3204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 smtClean="0">
                  <a:solidFill>
                    <a:srgbClr val="000000"/>
                  </a:solidFill>
                </a:rPr>
                <a:t>IRES</a:t>
              </a:r>
              <a:endParaRPr lang="en-US" altLang="en-US" sz="3200" baseline="-25000" dirty="0"/>
            </a:p>
          </p:txBody>
        </p:sp>
        <p:sp>
          <p:nvSpPr>
            <p:cNvPr id="18" name="Freeform 110" descr="Wide downward diagonal"/>
            <p:cNvSpPr>
              <a:spLocks/>
            </p:cNvSpPr>
            <p:nvPr/>
          </p:nvSpPr>
          <p:spPr bwMode="auto">
            <a:xfrm>
              <a:off x="5098210" y="2833699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wdDnDiag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9" name="Freeform 113" descr="5%"/>
            <p:cNvSpPr>
              <a:spLocks/>
            </p:cNvSpPr>
            <p:nvPr/>
          </p:nvSpPr>
          <p:spPr bwMode="auto">
            <a:xfrm>
              <a:off x="2394299" y="2833699"/>
              <a:ext cx="2134735" cy="307336"/>
            </a:xfrm>
            <a:custGeom>
              <a:avLst/>
              <a:gdLst>
                <a:gd name="T0" fmla="*/ 617436824 w 293"/>
                <a:gd name="T1" fmla="*/ 269655131 h 107"/>
                <a:gd name="T2" fmla="*/ 738404194 w 293"/>
                <a:gd name="T3" fmla="*/ 133567094 h 107"/>
                <a:gd name="T4" fmla="*/ 617436824 w 293"/>
                <a:gd name="T5" fmla="*/ 0 h 107"/>
                <a:gd name="T6" fmla="*/ 617436824 w 293"/>
                <a:gd name="T7" fmla="*/ 60483572 h 107"/>
                <a:gd name="T8" fmla="*/ 0 w 293"/>
                <a:gd name="T9" fmla="*/ 60483572 h 107"/>
                <a:gd name="T10" fmla="*/ 0 w 293"/>
                <a:gd name="T11" fmla="*/ 209171559 h 107"/>
                <a:gd name="T12" fmla="*/ 617436824 w 293"/>
                <a:gd name="T13" fmla="*/ 209171559 h 107"/>
                <a:gd name="T14" fmla="*/ 617436824 w 293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93"/>
                <a:gd name="T25" fmla="*/ 0 h 107"/>
                <a:gd name="T26" fmla="*/ 293 w 293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93" h="107">
                  <a:moveTo>
                    <a:pt x="245" y="107"/>
                  </a:moveTo>
                  <a:lnTo>
                    <a:pt x="293" y="53"/>
                  </a:lnTo>
                  <a:lnTo>
                    <a:pt x="245" y="0"/>
                  </a:lnTo>
                  <a:lnTo>
                    <a:pt x="245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45" y="83"/>
                  </a:lnTo>
                  <a:lnTo>
                    <a:pt x="245" y="107"/>
                  </a:lnTo>
                  <a:close/>
                </a:path>
              </a:pathLst>
            </a:custGeom>
            <a:pattFill prst="dkVert">
              <a:fgClr>
                <a:schemeClr val="tx1"/>
              </a:fgClr>
              <a:bgClr>
                <a:schemeClr val="bg1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20" name="Freeform 116" descr="Small grid"/>
            <p:cNvSpPr>
              <a:spLocks/>
            </p:cNvSpPr>
            <p:nvPr/>
          </p:nvSpPr>
          <p:spPr bwMode="auto">
            <a:xfrm>
              <a:off x="1495116" y="2839492"/>
              <a:ext cx="701308" cy="309923"/>
            </a:xfrm>
            <a:custGeom>
              <a:avLst/>
              <a:gdLst>
                <a:gd name="T0" fmla="*/ 574595625 w 276"/>
                <a:gd name="T1" fmla="*/ 269655131 h 107"/>
                <a:gd name="T2" fmla="*/ 695563125 w 276"/>
                <a:gd name="T3" fmla="*/ 133567094 h 107"/>
                <a:gd name="T4" fmla="*/ 574595625 w 276"/>
                <a:gd name="T5" fmla="*/ 0 h 107"/>
                <a:gd name="T6" fmla="*/ 574595625 w 276"/>
                <a:gd name="T7" fmla="*/ 60483572 h 107"/>
                <a:gd name="T8" fmla="*/ 0 w 276"/>
                <a:gd name="T9" fmla="*/ 60483572 h 107"/>
                <a:gd name="T10" fmla="*/ 0 w 276"/>
                <a:gd name="T11" fmla="*/ 209171559 h 107"/>
                <a:gd name="T12" fmla="*/ 574595625 w 276"/>
                <a:gd name="T13" fmla="*/ 209171559 h 107"/>
                <a:gd name="T14" fmla="*/ 574595625 w 27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76"/>
                <a:gd name="T25" fmla="*/ 0 h 107"/>
                <a:gd name="T26" fmla="*/ 276 w 27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76" h="107">
                  <a:moveTo>
                    <a:pt x="228" y="107"/>
                  </a:moveTo>
                  <a:lnTo>
                    <a:pt x="276" y="53"/>
                  </a:lnTo>
                  <a:lnTo>
                    <a:pt x="228" y="0"/>
                  </a:lnTo>
                  <a:lnTo>
                    <a:pt x="228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28" y="83"/>
                  </a:lnTo>
                  <a:lnTo>
                    <a:pt x="228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21" name="Freeform 119" descr="Small grid"/>
            <p:cNvSpPr>
              <a:spLocks/>
            </p:cNvSpPr>
            <p:nvPr/>
          </p:nvSpPr>
          <p:spPr bwMode="auto">
            <a:xfrm>
              <a:off x="6414603" y="2833699"/>
              <a:ext cx="714013" cy="309923"/>
            </a:xfrm>
            <a:custGeom>
              <a:avLst/>
              <a:gdLst>
                <a:gd name="T0" fmla="*/ 589717223 w 281"/>
                <a:gd name="T1" fmla="*/ 269655131 h 107"/>
                <a:gd name="T2" fmla="*/ 708165494 w 281"/>
                <a:gd name="T3" fmla="*/ 133567094 h 107"/>
                <a:gd name="T4" fmla="*/ 589717223 w 281"/>
                <a:gd name="T5" fmla="*/ 0 h 107"/>
                <a:gd name="T6" fmla="*/ 589717223 w 281"/>
                <a:gd name="T7" fmla="*/ 60483572 h 107"/>
                <a:gd name="T8" fmla="*/ 0 w 281"/>
                <a:gd name="T9" fmla="*/ 60483572 h 107"/>
                <a:gd name="T10" fmla="*/ 0 w 281"/>
                <a:gd name="T11" fmla="*/ 209171559 h 107"/>
                <a:gd name="T12" fmla="*/ 589717223 w 281"/>
                <a:gd name="T13" fmla="*/ 209171559 h 107"/>
                <a:gd name="T14" fmla="*/ 589717223 w 28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81"/>
                <a:gd name="T25" fmla="*/ 0 h 107"/>
                <a:gd name="T26" fmla="*/ 281 w 28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81" h="107">
                  <a:moveTo>
                    <a:pt x="234" y="107"/>
                  </a:moveTo>
                  <a:lnTo>
                    <a:pt x="281" y="53"/>
                  </a:lnTo>
                  <a:lnTo>
                    <a:pt x="234" y="0"/>
                  </a:lnTo>
                  <a:lnTo>
                    <a:pt x="234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34" y="83"/>
                  </a:lnTo>
                  <a:lnTo>
                    <a:pt x="234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25" name="Rectangle 24"/>
            <p:cNvSpPr/>
            <p:nvPr/>
          </p:nvSpPr>
          <p:spPr bwMode="auto">
            <a:xfrm>
              <a:off x="4609066" y="2919212"/>
              <a:ext cx="450471" cy="13889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3200"/>
            </a:p>
          </p:txBody>
        </p:sp>
        <p:sp>
          <p:nvSpPr>
            <p:cNvPr id="30" name="Freeform 110" descr="Wide downward diagonal"/>
            <p:cNvSpPr>
              <a:spLocks/>
            </p:cNvSpPr>
            <p:nvPr/>
          </p:nvSpPr>
          <p:spPr bwMode="auto">
            <a:xfrm>
              <a:off x="5757730" y="2831112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pct10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638800" y="2029496"/>
              <a:ext cx="8226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WPRE</a:t>
              </a:r>
              <a:endParaRPr lang="en-US" sz="2000" b="1" dirty="0"/>
            </a:p>
          </p:txBody>
        </p:sp>
        <p:cxnSp>
          <p:nvCxnSpPr>
            <p:cNvPr id="32" name="Straight Connector 31"/>
            <p:cNvCxnSpPr/>
            <p:nvPr/>
          </p:nvCxnSpPr>
          <p:spPr>
            <a:xfrm flipH="1">
              <a:off x="6049612" y="2361910"/>
              <a:ext cx="9175" cy="5550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TextBox 32"/>
          <p:cNvSpPr txBox="1"/>
          <p:nvPr/>
        </p:nvSpPr>
        <p:spPr>
          <a:xfrm>
            <a:off x="81185" y="3048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grpSp>
        <p:nvGrpSpPr>
          <p:cNvPr id="66" name="Group 65"/>
          <p:cNvGrpSpPr/>
          <p:nvPr/>
        </p:nvGrpSpPr>
        <p:grpSpPr>
          <a:xfrm>
            <a:off x="635781" y="1656301"/>
            <a:ext cx="5662396" cy="1119919"/>
            <a:chOff x="601676" y="2061695"/>
            <a:chExt cx="5662396" cy="1119919"/>
          </a:xfrm>
        </p:grpSpPr>
        <p:sp>
          <p:nvSpPr>
            <p:cNvPr id="35" name="Rectangle 106"/>
            <p:cNvSpPr>
              <a:spLocks noChangeArrowheads="1"/>
            </p:cNvSpPr>
            <p:nvPr/>
          </p:nvSpPr>
          <p:spPr bwMode="auto">
            <a:xfrm>
              <a:off x="639791" y="2999136"/>
              <a:ext cx="10164" cy="43446"/>
            </a:xfrm>
            <a:prstGeom prst="rect">
              <a:avLst/>
            </a:prstGeom>
            <a:solidFill>
              <a:srgbClr val="FFFFCC"/>
            </a:solidFill>
            <a:ln w="0">
              <a:solidFill>
                <a:srgbClr val="CCCC99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36" name="Rectangle 107"/>
            <p:cNvSpPr>
              <a:spLocks noChangeArrowheads="1"/>
            </p:cNvSpPr>
            <p:nvPr/>
          </p:nvSpPr>
          <p:spPr bwMode="auto">
            <a:xfrm>
              <a:off x="649955" y="2999136"/>
              <a:ext cx="5066693" cy="43446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37" name="Line 111"/>
            <p:cNvSpPr>
              <a:spLocks noChangeShapeType="1"/>
            </p:cNvSpPr>
            <p:nvPr/>
          </p:nvSpPr>
          <p:spPr bwMode="auto">
            <a:xfrm flipH="1">
              <a:off x="4537638" y="2602869"/>
              <a:ext cx="40656" cy="3325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38" name="Rectangle 112"/>
            <p:cNvSpPr>
              <a:spLocks noChangeArrowheads="1"/>
            </p:cNvSpPr>
            <p:nvPr/>
          </p:nvSpPr>
          <p:spPr bwMode="auto">
            <a:xfrm>
              <a:off x="4441694" y="2292808"/>
              <a:ext cx="436018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/>
                <a:t>Neo</a:t>
              </a:r>
              <a:endParaRPr lang="en-US" altLang="en-US" sz="2000" b="1" dirty="0"/>
            </a:p>
          </p:txBody>
        </p:sp>
        <p:sp>
          <p:nvSpPr>
            <p:cNvPr id="39" name="Line 114"/>
            <p:cNvSpPr>
              <a:spLocks noChangeShapeType="1"/>
            </p:cNvSpPr>
            <p:nvPr/>
          </p:nvSpPr>
          <p:spPr bwMode="auto">
            <a:xfrm flipH="1">
              <a:off x="2743200" y="2750038"/>
              <a:ext cx="2542" cy="1853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0" name="Rectangle 115"/>
            <p:cNvSpPr>
              <a:spLocks noChangeArrowheads="1"/>
            </p:cNvSpPr>
            <p:nvPr/>
          </p:nvSpPr>
          <p:spPr bwMode="auto">
            <a:xfrm>
              <a:off x="2483491" y="2409252"/>
              <a:ext cx="530959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400" b="1" dirty="0" smtClean="0"/>
                <a:t>Cre</a:t>
              </a:r>
              <a:endParaRPr lang="en-US" altLang="en-US" sz="2400" b="1" dirty="0"/>
            </a:p>
          </p:txBody>
        </p:sp>
        <p:sp>
          <p:nvSpPr>
            <p:cNvPr id="41" name="Line 117"/>
            <p:cNvSpPr>
              <a:spLocks noChangeShapeType="1"/>
            </p:cNvSpPr>
            <p:nvPr/>
          </p:nvSpPr>
          <p:spPr bwMode="auto">
            <a:xfrm>
              <a:off x="909134" y="2723969"/>
              <a:ext cx="94015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2" name="Rectangle 118"/>
            <p:cNvSpPr>
              <a:spLocks noChangeArrowheads="1"/>
            </p:cNvSpPr>
            <p:nvPr/>
          </p:nvSpPr>
          <p:spPr bwMode="auto">
            <a:xfrm>
              <a:off x="601676" y="2495147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</a:rPr>
                <a:t>LTR</a:t>
              </a:r>
              <a:endParaRPr lang="en-US" altLang="en-US" sz="3200"/>
            </a:p>
          </p:txBody>
        </p:sp>
        <p:sp>
          <p:nvSpPr>
            <p:cNvPr id="43" name="Line 120"/>
            <p:cNvSpPr>
              <a:spLocks noChangeShapeType="1"/>
            </p:cNvSpPr>
            <p:nvPr/>
          </p:nvSpPr>
          <p:spPr bwMode="auto">
            <a:xfrm flipH="1">
              <a:off x="5931411" y="2723969"/>
              <a:ext cx="71147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4" name="Rectangle 121"/>
            <p:cNvSpPr>
              <a:spLocks noChangeArrowheads="1"/>
            </p:cNvSpPr>
            <p:nvPr/>
          </p:nvSpPr>
          <p:spPr bwMode="auto">
            <a:xfrm>
              <a:off x="6012722" y="2495147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>
                  <a:solidFill>
                    <a:srgbClr val="000000"/>
                  </a:solidFill>
                </a:rPr>
                <a:t>LTR</a:t>
              </a:r>
              <a:endParaRPr lang="en-US" altLang="en-US" sz="3200" dirty="0"/>
            </a:p>
          </p:txBody>
        </p:sp>
        <p:sp>
          <p:nvSpPr>
            <p:cNvPr id="45" name="Line 144"/>
            <p:cNvSpPr>
              <a:spLocks noChangeShapeType="1"/>
            </p:cNvSpPr>
            <p:nvPr/>
          </p:nvSpPr>
          <p:spPr bwMode="auto">
            <a:xfrm>
              <a:off x="1729866" y="2663144"/>
              <a:ext cx="43197" cy="27227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6" name="Rectangle 145"/>
            <p:cNvSpPr>
              <a:spLocks noChangeArrowheads="1"/>
            </p:cNvSpPr>
            <p:nvPr/>
          </p:nvSpPr>
          <p:spPr bwMode="auto">
            <a:xfrm>
              <a:off x="1450429" y="2236985"/>
              <a:ext cx="584423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>
                  <a:solidFill>
                    <a:srgbClr val="000000"/>
                  </a:solidFill>
                </a:rPr>
                <a:t>Gag</a:t>
              </a:r>
              <a:endParaRPr lang="en-US" altLang="en-US" sz="4400" dirty="0"/>
            </a:p>
          </p:txBody>
        </p:sp>
        <p:sp>
          <p:nvSpPr>
            <p:cNvPr id="47" name="Line 150"/>
            <p:cNvSpPr>
              <a:spLocks noChangeShapeType="1"/>
            </p:cNvSpPr>
            <p:nvPr/>
          </p:nvSpPr>
          <p:spPr bwMode="auto">
            <a:xfrm flipH="1">
              <a:off x="3945592" y="2442345"/>
              <a:ext cx="14855" cy="4930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8" name="Rectangle 151"/>
            <p:cNvSpPr>
              <a:spLocks noChangeArrowheads="1"/>
            </p:cNvSpPr>
            <p:nvPr/>
          </p:nvSpPr>
          <p:spPr bwMode="auto">
            <a:xfrm>
              <a:off x="3774627" y="2201799"/>
              <a:ext cx="37163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 smtClean="0">
                  <a:solidFill>
                    <a:srgbClr val="000000"/>
                  </a:solidFill>
                </a:rPr>
                <a:t>SV40</a:t>
              </a:r>
              <a:endParaRPr lang="en-US" altLang="en-US" sz="3200" baseline="-25000" dirty="0"/>
            </a:p>
          </p:txBody>
        </p:sp>
        <p:sp>
          <p:nvSpPr>
            <p:cNvPr id="49" name="Freeform 110" descr="Wide downward diagonal"/>
            <p:cNvSpPr>
              <a:spLocks/>
            </p:cNvSpPr>
            <p:nvPr/>
          </p:nvSpPr>
          <p:spPr bwMode="auto">
            <a:xfrm>
              <a:off x="4225098" y="2865898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wdDnDiag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0" name="Freeform 113" descr="5%"/>
            <p:cNvSpPr>
              <a:spLocks/>
            </p:cNvSpPr>
            <p:nvPr/>
          </p:nvSpPr>
          <p:spPr bwMode="auto">
            <a:xfrm>
              <a:off x="2483491" y="2870528"/>
              <a:ext cx="744503" cy="309923"/>
            </a:xfrm>
            <a:custGeom>
              <a:avLst/>
              <a:gdLst>
                <a:gd name="T0" fmla="*/ 617436824 w 293"/>
                <a:gd name="T1" fmla="*/ 269655131 h 107"/>
                <a:gd name="T2" fmla="*/ 738404194 w 293"/>
                <a:gd name="T3" fmla="*/ 133567094 h 107"/>
                <a:gd name="T4" fmla="*/ 617436824 w 293"/>
                <a:gd name="T5" fmla="*/ 0 h 107"/>
                <a:gd name="T6" fmla="*/ 617436824 w 293"/>
                <a:gd name="T7" fmla="*/ 60483572 h 107"/>
                <a:gd name="T8" fmla="*/ 0 w 293"/>
                <a:gd name="T9" fmla="*/ 60483572 h 107"/>
                <a:gd name="T10" fmla="*/ 0 w 293"/>
                <a:gd name="T11" fmla="*/ 209171559 h 107"/>
                <a:gd name="T12" fmla="*/ 617436824 w 293"/>
                <a:gd name="T13" fmla="*/ 209171559 h 107"/>
                <a:gd name="T14" fmla="*/ 617436824 w 293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93"/>
                <a:gd name="T25" fmla="*/ 0 h 107"/>
                <a:gd name="T26" fmla="*/ 293 w 293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93" h="107">
                  <a:moveTo>
                    <a:pt x="245" y="107"/>
                  </a:moveTo>
                  <a:lnTo>
                    <a:pt x="293" y="53"/>
                  </a:lnTo>
                  <a:lnTo>
                    <a:pt x="245" y="0"/>
                  </a:lnTo>
                  <a:lnTo>
                    <a:pt x="245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45" y="83"/>
                  </a:lnTo>
                  <a:lnTo>
                    <a:pt x="245" y="107"/>
                  </a:lnTo>
                  <a:close/>
                </a:path>
              </a:pathLst>
            </a:custGeom>
            <a:pattFill prst="pct60">
              <a:fgClr>
                <a:schemeClr val="tx1"/>
              </a:fgClr>
              <a:bgClr>
                <a:schemeClr val="bg1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1" name="Freeform 116" descr="Small grid"/>
            <p:cNvSpPr>
              <a:spLocks/>
            </p:cNvSpPr>
            <p:nvPr/>
          </p:nvSpPr>
          <p:spPr bwMode="auto">
            <a:xfrm>
              <a:off x="622004" y="2871691"/>
              <a:ext cx="701308" cy="309923"/>
            </a:xfrm>
            <a:custGeom>
              <a:avLst/>
              <a:gdLst>
                <a:gd name="T0" fmla="*/ 574595625 w 276"/>
                <a:gd name="T1" fmla="*/ 269655131 h 107"/>
                <a:gd name="T2" fmla="*/ 695563125 w 276"/>
                <a:gd name="T3" fmla="*/ 133567094 h 107"/>
                <a:gd name="T4" fmla="*/ 574595625 w 276"/>
                <a:gd name="T5" fmla="*/ 0 h 107"/>
                <a:gd name="T6" fmla="*/ 574595625 w 276"/>
                <a:gd name="T7" fmla="*/ 60483572 h 107"/>
                <a:gd name="T8" fmla="*/ 0 w 276"/>
                <a:gd name="T9" fmla="*/ 60483572 h 107"/>
                <a:gd name="T10" fmla="*/ 0 w 276"/>
                <a:gd name="T11" fmla="*/ 209171559 h 107"/>
                <a:gd name="T12" fmla="*/ 574595625 w 276"/>
                <a:gd name="T13" fmla="*/ 209171559 h 107"/>
                <a:gd name="T14" fmla="*/ 574595625 w 27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76"/>
                <a:gd name="T25" fmla="*/ 0 h 107"/>
                <a:gd name="T26" fmla="*/ 276 w 27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76" h="107">
                  <a:moveTo>
                    <a:pt x="228" y="107"/>
                  </a:moveTo>
                  <a:lnTo>
                    <a:pt x="276" y="53"/>
                  </a:lnTo>
                  <a:lnTo>
                    <a:pt x="228" y="0"/>
                  </a:lnTo>
                  <a:lnTo>
                    <a:pt x="228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28" y="83"/>
                  </a:lnTo>
                  <a:lnTo>
                    <a:pt x="228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2" name="Freeform 119" descr="Small grid"/>
            <p:cNvSpPr>
              <a:spLocks/>
            </p:cNvSpPr>
            <p:nvPr/>
          </p:nvSpPr>
          <p:spPr bwMode="auto">
            <a:xfrm>
              <a:off x="5541491" y="2865898"/>
              <a:ext cx="714013" cy="309923"/>
            </a:xfrm>
            <a:custGeom>
              <a:avLst/>
              <a:gdLst>
                <a:gd name="T0" fmla="*/ 589717223 w 281"/>
                <a:gd name="T1" fmla="*/ 269655131 h 107"/>
                <a:gd name="T2" fmla="*/ 708165494 w 281"/>
                <a:gd name="T3" fmla="*/ 133567094 h 107"/>
                <a:gd name="T4" fmla="*/ 589717223 w 281"/>
                <a:gd name="T5" fmla="*/ 0 h 107"/>
                <a:gd name="T6" fmla="*/ 589717223 w 281"/>
                <a:gd name="T7" fmla="*/ 60483572 h 107"/>
                <a:gd name="T8" fmla="*/ 0 w 281"/>
                <a:gd name="T9" fmla="*/ 60483572 h 107"/>
                <a:gd name="T10" fmla="*/ 0 w 281"/>
                <a:gd name="T11" fmla="*/ 209171559 h 107"/>
                <a:gd name="T12" fmla="*/ 589717223 w 281"/>
                <a:gd name="T13" fmla="*/ 209171559 h 107"/>
                <a:gd name="T14" fmla="*/ 589717223 w 28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81"/>
                <a:gd name="T25" fmla="*/ 0 h 107"/>
                <a:gd name="T26" fmla="*/ 281 w 28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81" h="107">
                  <a:moveTo>
                    <a:pt x="234" y="107"/>
                  </a:moveTo>
                  <a:lnTo>
                    <a:pt x="281" y="53"/>
                  </a:lnTo>
                  <a:lnTo>
                    <a:pt x="234" y="0"/>
                  </a:lnTo>
                  <a:lnTo>
                    <a:pt x="234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34" y="83"/>
                  </a:lnTo>
                  <a:lnTo>
                    <a:pt x="234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3" name="Freeform 143" descr="Light vertical"/>
            <p:cNvSpPr>
              <a:spLocks/>
            </p:cNvSpPr>
            <p:nvPr/>
          </p:nvSpPr>
          <p:spPr bwMode="auto">
            <a:xfrm>
              <a:off x="1379213" y="2865898"/>
              <a:ext cx="790242" cy="309923"/>
            </a:xfrm>
            <a:custGeom>
              <a:avLst/>
              <a:gdLst>
                <a:gd name="T0" fmla="*/ 662802559 w 311"/>
                <a:gd name="T1" fmla="*/ 269655131 h 107"/>
                <a:gd name="T2" fmla="*/ 783770181 w 311"/>
                <a:gd name="T3" fmla="*/ 133567094 h 107"/>
                <a:gd name="T4" fmla="*/ 662802559 w 311"/>
                <a:gd name="T5" fmla="*/ 0 h 107"/>
                <a:gd name="T6" fmla="*/ 662802559 w 311"/>
                <a:gd name="T7" fmla="*/ 60483572 h 107"/>
                <a:gd name="T8" fmla="*/ 0 w 311"/>
                <a:gd name="T9" fmla="*/ 60483572 h 107"/>
                <a:gd name="T10" fmla="*/ 0 w 311"/>
                <a:gd name="T11" fmla="*/ 209171559 h 107"/>
                <a:gd name="T12" fmla="*/ 662802559 w 311"/>
                <a:gd name="T13" fmla="*/ 209171559 h 107"/>
                <a:gd name="T14" fmla="*/ 662802559 w 31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311"/>
                <a:gd name="T25" fmla="*/ 0 h 107"/>
                <a:gd name="T26" fmla="*/ 311 w 31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311" h="107">
                  <a:moveTo>
                    <a:pt x="263" y="107"/>
                  </a:moveTo>
                  <a:lnTo>
                    <a:pt x="311" y="53"/>
                  </a:lnTo>
                  <a:lnTo>
                    <a:pt x="263" y="0"/>
                  </a:lnTo>
                  <a:lnTo>
                    <a:pt x="263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63" y="83"/>
                  </a:lnTo>
                  <a:lnTo>
                    <a:pt x="263" y="107"/>
                  </a:lnTo>
                  <a:close/>
                </a:path>
              </a:pathLst>
            </a:custGeom>
            <a:pattFill prst="ltVert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4" name="Freeform 149"/>
            <p:cNvSpPr>
              <a:spLocks/>
            </p:cNvSpPr>
            <p:nvPr/>
          </p:nvSpPr>
          <p:spPr bwMode="auto">
            <a:xfrm>
              <a:off x="3686413" y="2865898"/>
              <a:ext cx="523440" cy="309923"/>
            </a:xfrm>
            <a:custGeom>
              <a:avLst/>
              <a:gdLst>
                <a:gd name="T0" fmla="*/ 395665325 w 206"/>
                <a:gd name="T1" fmla="*/ 269655131 h 107"/>
                <a:gd name="T2" fmla="*/ 519152188 w 206"/>
                <a:gd name="T3" fmla="*/ 133567094 h 107"/>
                <a:gd name="T4" fmla="*/ 395665325 w 206"/>
                <a:gd name="T5" fmla="*/ 0 h 107"/>
                <a:gd name="T6" fmla="*/ 395665325 w 206"/>
                <a:gd name="T7" fmla="*/ 60483572 h 107"/>
                <a:gd name="T8" fmla="*/ 0 w 206"/>
                <a:gd name="T9" fmla="*/ 60483572 h 107"/>
                <a:gd name="T10" fmla="*/ 0 w 206"/>
                <a:gd name="T11" fmla="*/ 209171559 h 107"/>
                <a:gd name="T12" fmla="*/ 395665325 w 206"/>
                <a:gd name="T13" fmla="*/ 209171559 h 107"/>
                <a:gd name="T14" fmla="*/ 395665325 w 20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06"/>
                <a:gd name="T25" fmla="*/ 0 h 107"/>
                <a:gd name="T26" fmla="*/ 206 w 20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06" h="107">
                  <a:moveTo>
                    <a:pt x="157" y="107"/>
                  </a:moveTo>
                  <a:lnTo>
                    <a:pt x="206" y="53"/>
                  </a:lnTo>
                  <a:lnTo>
                    <a:pt x="157" y="0"/>
                  </a:lnTo>
                  <a:lnTo>
                    <a:pt x="157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57" y="83"/>
                  </a:lnTo>
                  <a:lnTo>
                    <a:pt x="157" y="107"/>
                  </a:lnTo>
                  <a:close/>
                </a:path>
              </a:pathLst>
            </a:custGeom>
            <a:solidFill>
              <a:schemeClr val="tx1"/>
            </a:solid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6" name="Rectangle 55"/>
            <p:cNvSpPr/>
            <p:nvPr/>
          </p:nvSpPr>
          <p:spPr bwMode="auto">
            <a:xfrm>
              <a:off x="3238287" y="2959023"/>
              <a:ext cx="232729" cy="13889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3200"/>
            </a:p>
          </p:txBody>
        </p:sp>
        <p:sp>
          <p:nvSpPr>
            <p:cNvPr id="61" name="Freeform 110" descr="Wide downward diagonal"/>
            <p:cNvSpPr>
              <a:spLocks/>
            </p:cNvSpPr>
            <p:nvPr/>
          </p:nvSpPr>
          <p:spPr bwMode="auto">
            <a:xfrm>
              <a:off x="4884618" y="2863311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pct10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765688" y="2061695"/>
              <a:ext cx="8226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WPRE</a:t>
              </a:r>
              <a:endParaRPr lang="en-US" sz="2000" b="1" dirty="0"/>
            </a:p>
          </p:txBody>
        </p:sp>
        <p:cxnSp>
          <p:nvCxnSpPr>
            <p:cNvPr id="63" name="Straight Connector 62"/>
            <p:cNvCxnSpPr/>
            <p:nvPr/>
          </p:nvCxnSpPr>
          <p:spPr>
            <a:xfrm flipH="1">
              <a:off x="5176500" y="2394109"/>
              <a:ext cx="9175" cy="5550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 bwMode="auto">
            <a:xfrm flipV="1">
              <a:off x="3342498" y="2442345"/>
              <a:ext cx="24120" cy="48871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Rectangle 145"/>
            <p:cNvSpPr>
              <a:spLocks noChangeArrowheads="1"/>
            </p:cNvSpPr>
            <p:nvPr/>
          </p:nvSpPr>
          <p:spPr bwMode="auto">
            <a:xfrm>
              <a:off x="3241463" y="2198495"/>
              <a:ext cx="30059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 err="1">
                  <a:solidFill>
                    <a:srgbClr val="000000"/>
                  </a:solidFill>
                </a:rPr>
                <a:t>myc</a:t>
              </a:r>
              <a:endParaRPr lang="en-US" altLang="en-US" sz="3200" dirty="0"/>
            </a:p>
          </p:txBody>
        </p:sp>
      </p:grpSp>
      <p:sp>
        <p:nvSpPr>
          <p:cNvPr id="67" name="TextBox 66"/>
          <p:cNvSpPr txBox="1"/>
          <p:nvPr/>
        </p:nvSpPr>
        <p:spPr>
          <a:xfrm>
            <a:off x="81185" y="19812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pSp>
        <p:nvGrpSpPr>
          <p:cNvPr id="117" name="Group 116"/>
          <p:cNvGrpSpPr/>
          <p:nvPr/>
        </p:nvGrpSpPr>
        <p:grpSpPr>
          <a:xfrm>
            <a:off x="660315" y="2863149"/>
            <a:ext cx="5662396" cy="1119919"/>
            <a:chOff x="601676" y="2061695"/>
            <a:chExt cx="5662396" cy="1119919"/>
          </a:xfrm>
        </p:grpSpPr>
        <p:sp>
          <p:nvSpPr>
            <p:cNvPr id="118" name="Rectangle 106"/>
            <p:cNvSpPr>
              <a:spLocks noChangeArrowheads="1"/>
            </p:cNvSpPr>
            <p:nvPr/>
          </p:nvSpPr>
          <p:spPr bwMode="auto">
            <a:xfrm>
              <a:off x="639791" y="2999136"/>
              <a:ext cx="10164" cy="43446"/>
            </a:xfrm>
            <a:prstGeom prst="rect">
              <a:avLst/>
            </a:prstGeom>
            <a:solidFill>
              <a:srgbClr val="FFFFCC"/>
            </a:solidFill>
            <a:ln w="0">
              <a:solidFill>
                <a:srgbClr val="CCCC99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119" name="Rectangle 107"/>
            <p:cNvSpPr>
              <a:spLocks noChangeArrowheads="1"/>
            </p:cNvSpPr>
            <p:nvPr/>
          </p:nvSpPr>
          <p:spPr bwMode="auto">
            <a:xfrm>
              <a:off x="649955" y="2999136"/>
              <a:ext cx="5066693" cy="43446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120" name="Line 111"/>
            <p:cNvSpPr>
              <a:spLocks noChangeShapeType="1"/>
            </p:cNvSpPr>
            <p:nvPr/>
          </p:nvSpPr>
          <p:spPr bwMode="auto">
            <a:xfrm>
              <a:off x="4532949" y="2608621"/>
              <a:ext cx="4689" cy="3267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21" name="Rectangle 112"/>
            <p:cNvSpPr>
              <a:spLocks noChangeArrowheads="1"/>
            </p:cNvSpPr>
            <p:nvPr/>
          </p:nvSpPr>
          <p:spPr bwMode="auto">
            <a:xfrm>
              <a:off x="4286021" y="2300844"/>
              <a:ext cx="43762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err="1" smtClean="0"/>
                <a:t>Hph</a:t>
              </a:r>
              <a:endParaRPr lang="en-US" altLang="en-US" sz="2000" b="1" dirty="0"/>
            </a:p>
          </p:txBody>
        </p:sp>
        <p:sp>
          <p:nvSpPr>
            <p:cNvPr id="122" name="Line 114"/>
            <p:cNvSpPr>
              <a:spLocks noChangeShapeType="1"/>
            </p:cNvSpPr>
            <p:nvPr/>
          </p:nvSpPr>
          <p:spPr bwMode="auto">
            <a:xfrm flipH="1">
              <a:off x="2743200" y="2750038"/>
              <a:ext cx="2542" cy="1853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23" name="Rectangle 115"/>
            <p:cNvSpPr>
              <a:spLocks noChangeArrowheads="1"/>
            </p:cNvSpPr>
            <p:nvPr/>
          </p:nvSpPr>
          <p:spPr bwMode="auto">
            <a:xfrm>
              <a:off x="2412404" y="2321147"/>
              <a:ext cx="121092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err="1" smtClean="0"/>
                <a:t>mLig</a:t>
              </a:r>
              <a:r>
                <a:rPr lang="en-US" altLang="en-US" sz="2000" b="1" dirty="0" smtClean="0"/>
                <a:t> 3 WT</a:t>
              </a:r>
              <a:endParaRPr lang="en-US" altLang="en-US" sz="2000" b="1" dirty="0"/>
            </a:p>
          </p:txBody>
        </p:sp>
        <p:sp>
          <p:nvSpPr>
            <p:cNvPr id="124" name="Line 117"/>
            <p:cNvSpPr>
              <a:spLocks noChangeShapeType="1"/>
            </p:cNvSpPr>
            <p:nvPr/>
          </p:nvSpPr>
          <p:spPr bwMode="auto">
            <a:xfrm>
              <a:off x="909134" y="2723969"/>
              <a:ext cx="94015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25" name="Rectangle 118"/>
            <p:cNvSpPr>
              <a:spLocks noChangeArrowheads="1"/>
            </p:cNvSpPr>
            <p:nvPr/>
          </p:nvSpPr>
          <p:spPr bwMode="auto">
            <a:xfrm>
              <a:off x="601676" y="2495147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</a:rPr>
                <a:t>LTR</a:t>
              </a:r>
              <a:endParaRPr lang="en-US" altLang="en-US" sz="3200"/>
            </a:p>
          </p:txBody>
        </p:sp>
        <p:sp>
          <p:nvSpPr>
            <p:cNvPr id="126" name="Line 120"/>
            <p:cNvSpPr>
              <a:spLocks noChangeShapeType="1"/>
            </p:cNvSpPr>
            <p:nvPr/>
          </p:nvSpPr>
          <p:spPr bwMode="auto">
            <a:xfrm flipH="1">
              <a:off x="5931411" y="2723969"/>
              <a:ext cx="71147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27" name="Rectangle 121"/>
            <p:cNvSpPr>
              <a:spLocks noChangeArrowheads="1"/>
            </p:cNvSpPr>
            <p:nvPr/>
          </p:nvSpPr>
          <p:spPr bwMode="auto">
            <a:xfrm>
              <a:off x="6012722" y="2495147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>
                  <a:solidFill>
                    <a:srgbClr val="000000"/>
                  </a:solidFill>
                </a:rPr>
                <a:t>LTR</a:t>
              </a:r>
              <a:endParaRPr lang="en-US" altLang="en-US" sz="3200" dirty="0"/>
            </a:p>
          </p:txBody>
        </p:sp>
        <p:sp>
          <p:nvSpPr>
            <p:cNvPr id="128" name="Line 144"/>
            <p:cNvSpPr>
              <a:spLocks noChangeShapeType="1"/>
            </p:cNvSpPr>
            <p:nvPr/>
          </p:nvSpPr>
          <p:spPr bwMode="auto">
            <a:xfrm>
              <a:off x="1729866" y="2663144"/>
              <a:ext cx="43197" cy="27227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29" name="Rectangle 145"/>
            <p:cNvSpPr>
              <a:spLocks noChangeArrowheads="1"/>
            </p:cNvSpPr>
            <p:nvPr/>
          </p:nvSpPr>
          <p:spPr bwMode="auto">
            <a:xfrm>
              <a:off x="1450429" y="2236985"/>
              <a:ext cx="584423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>
                  <a:solidFill>
                    <a:srgbClr val="000000"/>
                  </a:solidFill>
                </a:rPr>
                <a:t>Gag</a:t>
              </a:r>
              <a:endParaRPr lang="en-US" altLang="en-US" sz="4400" dirty="0"/>
            </a:p>
          </p:txBody>
        </p:sp>
        <p:sp>
          <p:nvSpPr>
            <p:cNvPr id="130" name="Line 150"/>
            <p:cNvSpPr>
              <a:spLocks noChangeShapeType="1"/>
            </p:cNvSpPr>
            <p:nvPr/>
          </p:nvSpPr>
          <p:spPr bwMode="auto">
            <a:xfrm flipH="1">
              <a:off x="3945592" y="2442345"/>
              <a:ext cx="14855" cy="4930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31" name="Rectangle 151"/>
            <p:cNvSpPr>
              <a:spLocks noChangeArrowheads="1"/>
            </p:cNvSpPr>
            <p:nvPr/>
          </p:nvSpPr>
          <p:spPr bwMode="auto">
            <a:xfrm>
              <a:off x="3774627" y="2201799"/>
              <a:ext cx="37163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 smtClean="0">
                  <a:solidFill>
                    <a:srgbClr val="000000"/>
                  </a:solidFill>
                </a:rPr>
                <a:t>SV40</a:t>
              </a:r>
              <a:endParaRPr lang="en-US" altLang="en-US" sz="3200" baseline="-25000" dirty="0"/>
            </a:p>
          </p:txBody>
        </p:sp>
        <p:sp>
          <p:nvSpPr>
            <p:cNvPr id="132" name="Freeform 110" descr="Wide downward diagonal"/>
            <p:cNvSpPr>
              <a:spLocks/>
            </p:cNvSpPr>
            <p:nvPr/>
          </p:nvSpPr>
          <p:spPr bwMode="auto">
            <a:xfrm>
              <a:off x="4225098" y="2865898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wdDnDiag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33" name="Freeform 113" descr="5%"/>
            <p:cNvSpPr>
              <a:spLocks/>
            </p:cNvSpPr>
            <p:nvPr/>
          </p:nvSpPr>
          <p:spPr bwMode="auto">
            <a:xfrm>
              <a:off x="2203244" y="2870528"/>
              <a:ext cx="1437824" cy="309923"/>
            </a:xfrm>
            <a:custGeom>
              <a:avLst/>
              <a:gdLst>
                <a:gd name="T0" fmla="*/ 617436824 w 293"/>
                <a:gd name="T1" fmla="*/ 269655131 h 107"/>
                <a:gd name="T2" fmla="*/ 738404194 w 293"/>
                <a:gd name="T3" fmla="*/ 133567094 h 107"/>
                <a:gd name="T4" fmla="*/ 617436824 w 293"/>
                <a:gd name="T5" fmla="*/ 0 h 107"/>
                <a:gd name="T6" fmla="*/ 617436824 w 293"/>
                <a:gd name="T7" fmla="*/ 60483572 h 107"/>
                <a:gd name="T8" fmla="*/ 0 w 293"/>
                <a:gd name="T9" fmla="*/ 60483572 h 107"/>
                <a:gd name="T10" fmla="*/ 0 w 293"/>
                <a:gd name="T11" fmla="*/ 209171559 h 107"/>
                <a:gd name="T12" fmla="*/ 617436824 w 293"/>
                <a:gd name="T13" fmla="*/ 209171559 h 107"/>
                <a:gd name="T14" fmla="*/ 617436824 w 293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93"/>
                <a:gd name="T25" fmla="*/ 0 h 107"/>
                <a:gd name="T26" fmla="*/ 293 w 293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93" h="107">
                  <a:moveTo>
                    <a:pt x="245" y="107"/>
                  </a:moveTo>
                  <a:lnTo>
                    <a:pt x="293" y="53"/>
                  </a:lnTo>
                  <a:lnTo>
                    <a:pt x="245" y="0"/>
                  </a:lnTo>
                  <a:lnTo>
                    <a:pt x="245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45" y="83"/>
                  </a:lnTo>
                  <a:lnTo>
                    <a:pt x="245" y="107"/>
                  </a:lnTo>
                  <a:close/>
                </a:path>
              </a:pathLst>
            </a:custGeom>
            <a:pattFill prst="wdUpDiag">
              <a:fgClr>
                <a:schemeClr val="tx1"/>
              </a:fgClr>
              <a:bgClr>
                <a:schemeClr val="bg1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34" name="Freeform 116" descr="Small grid"/>
            <p:cNvSpPr>
              <a:spLocks/>
            </p:cNvSpPr>
            <p:nvPr/>
          </p:nvSpPr>
          <p:spPr bwMode="auto">
            <a:xfrm>
              <a:off x="622004" y="2871691"/>
              <a:ext cx="701308" cy="309923"/>
            </a:xfrm>
            <a:custGeom>
              <a:avLst/>
              <a:gdLst>
                <a:gd name="T0" fmla="*/ 574595625 w 276"/>
                <a:gd name="T1" fmla="*/ 269655131 h 107"/>
                <a:gd name="T2" fmla="*/ 695563125 w 276"/>
                <a:gd name="T3" fmla="*/ 133567094 h 107"/>
                <a:gd name="T4" fmla="*/ 574595625 w 276"/>
                <a:gd name="T5" fmla="*/ 0 h 107"/>
                <a:gd name="T6" fmla="*/ 574595625 w 276"/>
                <a:gd name="T7" fmla="*/ 60483572 h 107"/>
                <a:gd name="T8" fmla="*/ 0 w 276"/>
                <a:gd name="T9" fmla="*/ 60483572 h 107"/>
                <a:gd name="T10" fmla="*/ 0 w 276"/>
                <a:gd name="T11" fmla="*/ 209171559 h 107"/>
                <a:gd name="T12" fmla="*/ 574595625 w 276"/>
                <a:gd name="T13" fmla="*/ 209171559 h 107"/>
                <a:gd name="T14" fmla="*/ 574595625 w 27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76"/>
                <a:gd name="T25" fmla="*/ 0 h 107"/>
                <a:gd name="T26" fmla="*/ 276 w 27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76" h="107">
                  <a:moveTo>
                    <a:pt x="228" y="107"/>
                  </a:moveTo>
                  <a:lnTo>
                    <a:pt x="276" y="53"/>
                  </a:lnTo>
                  <a:lnTo>
                    <a:pt x="228" y="0"/>
                  </a:lnTo>
                  <a:lnTo>
                    <a:pt x="228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28" y="83"/>
                  </a:lnTo>
                  <a:lnTo>
                    <a:pt x="228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35" name="Freeform 119" descr="Small grid"/>
            <p:cNvSpPr>
              <a:spLocks/>
            </p:cNvSpPr>
            <p:nvPr/>
          </p:nvSpPr>
          <p:spPr bwMode="auto">
            <a:xfrm>
              <a:off x="5541491" y="2865898"/>
              <a:ext cx="714013" cy="309923"/>
            </a:xfrm>
            <a:custGeom>
              <a:avLst/>
              <a:gdLst>
                <a:gd name="T0" fmla="*/ 589717223 w 281"/>
                <a:gd name="T1" fmla="*/ 269655131 h 107"/>
                <a:gd name="T2" fmla="*/ 708165494 w 281"/>
                <a:gd name="T3" fmla="*/ 133567094 h 107"/>
                <a:gd name="T4" fmla="*/ 589717223 w 281"/>
                <a:gd name="T5" fmla="*/ 0 h 107"/>
                <a:gd name="T6" fmla="*/ 589717223 w 281"/>
                <a:gd name="T7" fmla="*/ 60483572 h 107"/>
                <a:gd name="T8" fmla="*/ 0 w 281"/>
                <a:gd name="T9" fmla="*/ 60483572 h 107"/>
                <a:gd name="T10" fmla="*/ 0 w 281"/>
                <a:gd name="T11" fmla="*/ 209171559 h 107"/>
                <a:gd name="T12" fmla="*/ 589717223 w 281"/>
                <a:gd name="T13" fmla="*/ 209171559 h 107"/>
                <a:gd name="T14" fmla="*/ 589717223 w 28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81"/>
                <a:gd name="T25" fmla="*/ 0 h 107"/>
                <a:gd name="T26" fmla="*/ 281 w 28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81" h="107">
                  <a:moveTo>
                    <a:pt x="234" y="107"/>
                  </a:moveTo>
                  <a:lnTo>
                    <a:pt x="281" y="53"/>
                  </a:lnTo>
                  <a:lnTo>
                    <a:pt x="234" y="0"/>
                  </a:lnTo>
                  <a:lnTo>
                    <a:pt x="234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34" y="83"/>
                  </a:lnTo>
                  <a:lnTo>
                    <a:pt x="234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36" name="Freeform 143" descr="Light vertical"/>
            <p:cNvSpPr>
              <a:spLocks/>
            </p:cNvSpPr>
            <p:nvPr/>
          </p:nvSpPr>
          <p:spPr bwMode="auto">
            <a:xfrm>
              <a:off x="1379213" y="2865898"/>
              <a:ext cx="790242" cy="309923"/>
            </a:xfrm>
            <a:custGeom>
              <a:avLst/>
              <a:gdLst>
                <a:gd name="T0" fmla="*/ 662802559 w 311"/>
                <a:gd name="T1" fmla="*/ 269655131 h 107"/>
                <a:gd name="T2" fmla="*/ 783770181 w 311"/>
                <a:gd name="T3" fmla="*/ 133567094 h 107"/>
                <a:gd name="T4" fmla="*/ 662802559 w 311"/>
                <a:gd name="T5" fmla="*/ 0 h 107"/>
                <a:gd name="T6" fmla="*/ 662802559 w 311"/>
                <a:gd name="T7" fmla="*/ 60483572 h 107"/>
                <a:gd name="T8" fmla="*/ 0 w 311"/>
                <a:gd name="T9" fmla="*/ 60483572 h 107"/>
                <a:gd name="T10" fmla="*/ 0 w 311"/>
                <a:gd name="T11" fmla="*/ 209171559 h 107"/>
                <a:gd name="T12" fmla="*/ 662802559 w 311"/>
                <a:gd name="T13" fmla="*/ 209171559 h 107"/>
                <a:gd name="T14" fmla="*/ 662802559 w 31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311"/>
                <a:gd name="T25" fmla="*/ 0 h 107"/>
                <a:gd name="T26" fmla="*/ 311 w 31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311" h="107">
                  <a:moveTo>
                    <a:pt x="263" y="107"/>
                  </a:moveTo>
                  <a:lnTo>
                    <a:pt x="311" y="53"/>
                  </a:lnTo>
                  <a:lnTo>
                    <a:pt x="263" y="0"/>
                  </a:lnTo>
                  <a:lnTo>
                    <a:pt x="263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63" y="83"/>
                  </a:lnTo>
                  <a:lnTo>
                    <a:pt x="263" y="107"/>
                  </a:lnTo>
                  <a:close/>
                </a:path>
              </a:pathLst>
            </a:custGeom>
            <a:pattFill prst="ltVert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37" name="Freeform 149"/>
            <p:cNvSpPr>
              <a:spLocks/>
            </p:cNvSpPr>
            <p:nvPr/>
          </p:nvSpPr>
          <p:spPr bwMode="auto">
            <a:xfrm>
              <a:off x="3686413" y="2865898"/>
              <a:ext cx="523440" cy="309923"/>
            </a:xfrm>
            <a:custGeom>
              <a:avLst/>
              <a:gdLst>
                <a:gd name="T0" fmla="*/ 395665325 w 206"/>
                <a:gd name="T1" fmla="*/ 269655131 h 107"/>
                <a:gd name="T2" fmla="*/ 519152188 w 206"/>
                <a:gd name="T3" fmla="*/ 133567094 h 107"/>
                <a:gd name="T4" fmla="*/ 395665325 w 206"/>
                <a:gd name="T5" fmla="*/ 0 h 107"/>
                <a:gd name="T6" fmla="*/ 395665325 w 206"/>
                <a:gd name="T7" fmla="*/ 60483572 h 107"/>
                <a:gd name="T8" fmla="*/ 0 w 206"/>
                <a:gd name="T9" fmla="*/ 60483572 h 107"/>
                <a:gd name="T10" fmla="*/ 0 w 206"/>
                <a:gd name="T11" fmla="*/ 209171559 h 107"/>
                <a:gd name="T12" fmla="*/ 395665325 w 206"/>
                <a:gd name="T13" fmla="*/ 209171559 h 107"/>
                <a:gd name="T14" fmla="*/ 395665325 w 20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06"/>
                <a:gd name="T25" fmla="*/ 0 h 107"/>
                <a:gd name="T26" fmla="*/ 206 w 20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06" h="107">
                  <a:moveTo>
                    <a:pt x="157" y="107"/>
                  </a:moveTo>
                  <a:lnTo>
                    <a:pt x="206" y="53"/>
                  </a:lnTo>
                  <a:lnTo>
                    <a:pt x="157" y="0"/>
                  </a:lnTo>
                  <a:lnTo>
                    <a:pt x="157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57" y="83"/>
                  </a:lnTo>
                  <a:lnTo>
                    <a:pt x="157" y="107"/>
                  </a:lnTo>
                  <a:close/>
                </a:path>
              </a:pathLst>
            </a:custGeom>
            <a:solidFill>
              <a:schemeClr val="tx1"/>
            </a:solid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39" name="Freeform 110" descr="Wide downward diagonal"/>
            <p:cNvSpPr>
              <a:spLocks/>
            </p:cNvSpPr>
            <p:nvPr/>
          </p:nvSpPr>
          <p:spPr bwMode="auto">
            <a:xfrm>
              <a:off x="4884618" y="2863311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pct10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4765688" y="2061695"/>
              <a:ext cx="8226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WPRE</a:t>
              </a:r>
              <a:endParaRPr lang="en-US" sz="2000" b="1" dirty="0"/>
            </a:p>
          </p:txBody>
        </p:sp>
        <p:cxnSp>
          <p:nvCxnSpPr>
            <p:cNvPr id="141" name="Straight Connector 140"/>
            <p:cNvCxnSpPr/>
            <p:nvPr/>
          </p:nvCxnSpPr>
          <p:spPr>
            <a:xfrm flipH="1">
              <a:off x="5176500" y="2394109"/>
              <a:ext cx="9175" cy="5550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1" name="Group 170"/>
          <p:cNvGrpSpPr/>
          <p:nvPr/>
        </p:nvGrpSpPr>
        <p:grpSpPr>
          <a:xfrm>
            <a:off x="687876" y="4098750"/>
            <a:ext cx="5662396" cy="1119919"/>
            <a:chOff x="601676" y="2061695"/>
            <a:chExt cx="5662396" cy="1119919"/>
          </a:xfrm>
        </p:grpSpPr>
        <p:sp>
          <p:nvSpPr>
            <p:cNvPr id="172" name="Rectangle 106"/>
            <p:cNvSpPr>
              <a:spLocks noChangeArrowheads="1"/>
            </p:cNvSpPr>
            <p:nvPr/>
          </p:nvSpPr>
          <p:spPr bwMode="auto">
            <a:xfrm>
              <a:off x="639791" y="2999136"/>
              <a:ext cx="10164" cy="43446"/>
            </a:xfrm>
            <a:prstGeom prst="rect">
              <a:avLst/>
            </a:prstGeom>
            <a:solidFill>
              <a:srgbClr val="FFFFCC"/>
            </a:solidFill>
            <a:ln w="0">
              <a:solidFill>
                <a:srgbClr val="CCCC99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173" name="Rectangle 107"/>
            <p:cNvSpPr>
              <a:spLocks noChangeArrowheads="1"/>
            </p:cNvSpPr>
            <p:nvPr/>
          </p:nvSpPr>
          <p:spPr bwMode="auto">
            <a:xfrm>
              <a:off x="649955" y="2999136"/>
              <a:ext cx="5066693" cy="43446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174" name="Line 111"/>
            <p:cNvSpPr>
              <a:spLocks noChangeShapeType="1"/>
            </p:cNvSpPr>
            <p:nvPr/>
          </p:nvSpPr>
          <p:spPr bwMode="auto">
            <a:xfrm>
              <a:off x="4532949" y="2608621"/>
              <a:ext cx="4689" cy="3267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75" name="Rectangle 112"/>
            <p:cNvSpPr>
              <a:spLocks noChangeArrowheads="1"/>
            </p:cNvSpPr>
            <p:nvPr/>
          </p:nvSpPr>
          <p:spPr bwMode="auto">
            <a:xfrm>
              <a:off x="4286021" y="2300844"/>
              <a:ext cx="43762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err="1" smtClean="0"/>
                <a:t>Hph</a:t>
              </a:r>
              <a:endParaRPr lang="en-US" altLang="en-US" sz="2000" b="1" dirty="0"/>
            </a:p>
          </p:txBody>
        </p:sp>
        <p:sp>
          <p:nvSpPr>
            <p:cNvPr id="176" name="Line 114"/>
            <p:cNvSpPr>
              <a:spLocks noChangeShapeType="1"/>
            </p:cNvSpPr>
            <p:nvPr/>
          </p:nvSpPr>
          <p:spPr bwMode="auto">
            <a:xfrm flipH="1">
              <a:off x="2743200" y="2750038"/>
              <a:ext cx="2542" cy="1853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77" name="Rectangle 115"/>
            <p:cNvSpPr>
              <a:spLocks noChangeArrowheads="1"/>
            </p:cNvSpPr>
            <p:nvPr/>
          </p:nvSpPr>
          <p:spPr bwMode="auto">
            <a:xfrm>
              <a:off x="2147557" y="2408128"/>
              <a:ext cx="157497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err="1" smtClean="0"/>
                <a:t>mLig</a:t>
              </a:r>
              <a:r>
                <a:rPr lang="en-US" altLang="en-US" sz="2000" b="1" dirty="0" smtClean="0"/>
                <a:t> 3 K510V</a:t>
              </a:r>
              <a:endParaRPr lang="en-US" altLang="en-US" sz="2000" b="1" dirty="0"/>
            </a:p>
          </p:txBody>
        </p:sp>
        <p:sp>
          <p:nvSpPr>
            <p:cNvPr id="178" name="Line 117"/>
            <p:cNvSpPr>
              <a:spLocks noChangeShapeType="1"/>
            </p:cNvSpPr>
            <p:nvPr/>
          </p:nvSpPr>
          <p:spPr bwMode="auto">
            <a:xfrm>
              <a:off x="909134" y="2723969"/>
              <a:ext cx="94015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79" name="Rectangle 118"/>
            <p:cNvSpPr>
              <a:spLocks noChangeArrowheads="1"/>
            </p:cNvSpPr>
            <p:nvPr/>
          </p:nvSpPr>
          <p:spPr bwMode="auto">
            <a:xfrm>
              <a:off x="601676" y="2495147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</a:rPr>
                <a:t>LTR</a:t>
              </a:r>
              <a:endParaRPr lang="en-US" altLang="en-US" sz="3200"/>
            </a:p>
          </p:txBody>
        </p:sp>
        <p:sp>
          <p:nvSpPr>
            <p:cNvPr id="180" name="Line 120"/>
            <p:cNvSpPr>
              <a:spLocks noChangeShapeType="1"/>
            </p:cNvSpPr>
            <p:nvPr/>
          </p:nvSpPr>
          <p:spPr bwMode="auto">
            <a:xfrm flipH="1">
              <a:off x="5931411" y="2723969"/>
              <a:ext cx="71147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81" name="Rectangle 121"/>
            <p:cNvSpPr>
              <a:spLocks noChangeArrowheads="1"/>
            </p:cNvSpPr>
            <p:nvPr/>
          </p:nvSpPr>
          <p:spPr bwMode="auto">
            <a:xfrm>
              <a:off x="6012722" y="2495147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>
                  <a:solidFill>
                    <a:srgbClr val="000000"/>
                  </a:solidFill>
                </a:rPr>
                <a:t>LTR</a:t>
              </a:r>
              <a:endParaRPr lang="en-US" altLang="en-US" sz="3200" dirty="0"/>
            </a:p>
          </p:txBody>
        </p:sp>
        <p:sp>
          <p:nvSpPr>
            <p:cNvPr id="182" name="Line 144"/>
            <p:cNvSpPr>
              <a:spLocks noChangeShapeType="1"/>
            </p:cNvSpPr>
            <p:nvPr/>
          </p:nvSpPr>
          <p:spPr bwMode="auto">
            <a:xfrm>
              <a:off x="1729866" y="2663144"/>
              <a:ext cx="43197" cy="27227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83" name="Rectangle 145"/>
            <p:cNvSpPr>
              <a:spLocks noChangeArrowheads="1"/>
            </p:cNvSpPr>
            <p:nvPr/>
          </p:nvSpPr>
          <p:spPr bwMode="auto">
            <a:xfrm>
              <a:off x="1450429" y="2236985"/>
              <a:ext cx="584423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>
                  <a:solidFill>
                    <a:srgbClr val="000000"/>
                  </a:solidFill>
                </a:rPr>
                <a:t>Gag</a:t>
              </a:r>
              <a:endParaRPr lang="en-US" altLang="en-US" sz="4400" dirty="0"/>
            </a:p>
          </p:txBody>
        </p:sp>
        <p:sp>
          <p:nvSpPr>
            <p:cNvPr id="184" name="Line 150"/>
            <p:cNvSpPr>
              <a:spLocks noChangeShapeType="1"/>
            </p:cNvSpPr>
            <p:nvPr/>
          </p:nvSpPr>
          <p:spPr bwMode="auto">
            <a:xfrm flipH="1">
              <a:off x="3945592" y="2442345"/>
              <a:ext cx="14855" cy="4930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85" name="Rectangle 151"/>
            <p:cNvSpPr>
              <a:spLocks noChangeArrowheads="1"/>
            </p:cNvSpPr>
            <p:nvPr/>
          </p:nvSpPr>
          <p:spPr bwMode="auto">
            <a:xfrm>
              <a:off x="3774627" y="2201799"/>
              <a:ext cx="37163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 smtClean="0">
                  <a:solidFill>
                    <a:srgbClr val="000000"/>
                  </a:solidFill>
                </a:rPr>
                <a:t>SV40</a:t>
              </a:r>
              <a:endParaRPr lang="en-US" altLang="en-US" sz="3200" baseline="-25000" dirty="0"/>
            </a:p>
          </p:txBody>
        </p:sp>
        <p:sp>
          <p:nvSpPr>
            <p:cNvPr id="186" name="Freeform 110" descr="Wide downward diagonal"/>
            <p:cNvSpPr>
              <a:spLocks/>
            </p:cNvSpPr>
            <p:nvPr/>
          </p:nvSpPr>
          <p:spPr bwMode="auto">
            <a:xfrm>
              <a:off x="4225098" y="2865898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wdDnDiag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87" name="Freeform 113" descr="5%"/>
            <p:cNvSpPr>
              <a:spLocks/>
            </p:cNvSpPr>
            <p:nvPr/>
          </p:nvSpPr>
          <p:spPr bwMode="auto">
            <a:xfrm>
              <a:off x="2203244" y="2870528"/>
              <a:ext cx="1437824" cy="309923"/>
            </a:xfrm>
            <a:custGeom>
              <a:avLst/>
              <a:gdLst>
                <a:gd name="T0" fmla="*/ 617436824 w 293"/>
                <a:gd name="T1" fmla="*/ 269655131 h 107"/>
                <a:gd name="T2" fmla="*/ 738404194 w 293"/>
                <a:gd name="T3" fmla="*/ 133567094 h 107"/>
                <a:gd name="T4" fmla="*/ 617436824 w 293"/>
                <a:gd name="T5" fmla="*/ 0 h 107"/>
                <a:gd name="T6" fmla="*/ 617436824 w 293"/>
                <a:gd name="T7" fmla="*/ 60483572 h 107"/>
                <a:gd name="T8" fmla="*/ 0 w 293"/>
                <a:gd name="T9" fmla="*/ 60483572 h 107"/>
                <a:gd name="T10" fmla="*/ 0 w 293"/>
                <a:gd name="T11" fmla="*/ 209171559 h 107"/>
                <a:gd name="T12" fmla="*/ 617436824 w 293"/>
                <a:gd name="T13" fmla="*/ 209171559 h 107"/>
                <a:gd name="T14" fmla="*/ 617436824 w 293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93"/>
                <a:gd name="T25" fmla="*/ 0 h 107"/>
                <a:gd name="T26" fmla="*/ 293 w 293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93" h="107">
                  <a:moveTo>
                    <a:pt x="245" y="107"/>
                  </a:moveTo>
                  <a:lnTo>
                    <a:pt x="293" y="53"/>
                  </a:lnTo>
                  <a:lnTo>
                    <a:pt x="245" y="0"/>
                  </a:lnTo>
                  <a:lnTo>
                    <a:pt x="245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45" y="83"/>
                  </a:lnTo>
                  <a:lnTo>
                    <a:pt x="245" y="107"/>
                  </a:lnTo>
                  <a:close/>
                </a:path>
              </a:pathLst>
            </a:custGeom>
            <a:pattFill prst="lgGrid">
              <a:fgClr>
                <a:schemeClr val="tx1"/>
              </a:fgClr>
              <a:bgClr>
                <a:schemeClr val="bg1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88" name="Freeform 116" descr="Small grid"/>
            <p:cNvSpPr>
              <a:spLocks/>
            </p:cNvSpPr>
            <p:nvPr/>
          </p:nvSpPr>
          <p:spPr bwMode="auto">
            <a:xfrm>
              <a:off x="622004" y="2871691"/>
              <a:ext cx="701308" cy="309923"/>
            </a:xfrm>
            <a:custGeom>
              <a:avLst/>
              <a:gdLst>
                <a:gd name="T0" fmla="*/ 574595625 w 276"/>
                <a:gd name="T1" fmla="*/ 269655131 h 107"/>
                <a:gd name="T2" fmla="*/ 695563125 w 276"/>
                <a:gd name="T3" fmla="*/ 133567094 h 107"/>
                <a:gd name="T4" fmla="*/ 574595625 w 276"/>
                <a:gd name="T5" fmla="*/ 0 h 107"/>
                <a:gd name="T6" fmla="*/ 574595625 w 276"/>
                <a:gd name="T7" fmla="*/ 60483572 h 107"/>
                <a:gd name="T8" fmla="*/ 0 w 276"/>
                <a:gd name="T9" fmla="*/ 60483572 h 107"/>
                <a:gd name="T10" fmla="*/ 0 w 276"/>
                <a:gd name="T11" fmla="*/ 209171559 h 107"/>
                <a:gd name="T12" fmla="*/ 574595625 w 276"/>
                <a:gd name="T13" fmla="*/ 209171559 h 107"/>
                <a:gd name="T14" fmla="*/ 574595625 w 27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76"/>
                <a:gd name="T25" fmla="*/ 0 h 107"/>
                <a:gd name="T26" fmla="*/ 276 w 27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76" h="107">
                  <a:moveTo>
                    <a:pt x="228" y="107"/>
                  </a:moveTo>
                  <a:lnTo>
                    <a:pt x="276" y="53"/>
                  </a:lnTo>
                  <a:lnTo>
                    <a:pt x="228" y="0"/>
                  </a:lnTo>
                  <a:lnTo>
                    <a:pt x="228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28" y="83"/>
                  </a:lnTo>
                  <a:lnTo>
                    <a:pt x="228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89" name="Freeform 119" descr="Small grid"/>
            <p:cNvSpPr>
              <a:spLocks/>
            </p:cNvSpPr>
            <p:nvPr/>
          </p:nvSpPr>
          <p:spPr bwMode="auto">
            <a:xfrm>
              <a:off x="5541491" y="2865898"/>
              <a:ext cx="714013" cy="309923"/>
            </a:xfrm>
            <a:custGeom>
              <a:avLst/>
              <a:gdLst>
                <a:gd name="T0" fmla="*/ 589717223 w 281"/>
                <a:gd name="T1" fmla="*/ 269655131 h 107"/>
                <a:gd name="T2" fmla="*/ 708165494 w 281"/>
                <a:gd name="T3" fmla="*/ 133567094 h 107"/>
                <a:gd name="T4" fmla="*/ 589717223 w 281"/>
                <a:gd name="T5" fmla="*/ 0 h 107"/>
                <a:gd name="T6" fmla="*/ 589717223 w 281"/>
                <a:gd name="T7" fmla="*/ 60483572 h 107"/>
                <a:gd name="T8" fmla="*/ 0 w 281"/>
                <a:gd name="T9" fmla="*/ 60483572 h 107"/>
                <a:gd name="T10" fmla="*/ 0 w 281"/>
                <a:gd name="T11" fmla="*/ 209171559 h 107"/>
                <a:gd name="T12" fmla="*/ 589717223 w 281"/>
                <a:gd name="T13" fmla="*/ 209171559 h 107"/>
                <a:gd name="T14" fmla="*/ 589717223 w 28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81"/>
                <a:gd name="T25" fmla="*/ 0 h 107"/>
                <a:gd name="T26" fmla="*/ 281 w 28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81" h="107">
                  <a:moveTo>
                    <a:pt x="234" y="107"/>
                  </a:moveTo>
                  <a:lnTo>
                    <a:pt x="281" y="53"/>
                  </a:lnTo>
                  <a:lnTo>
                    <a:pt x="234" y="0"/>
                  </a:lnTo>
                  <a:lnTo>
                    <a:pt x="234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34" y="83"/>
                  </a:lnTo>
                  <a:lnTo>
                    <a:pt x="234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90" name="Freeform 143" descr="Light vertical"/>
            <p:cNvSpPr>
              <a:spLocks/>
            </p:cNvSpPr>
            <p:nvPr/>
          </p:nvSpPr>
          <p:spPr bwMode="auto">
            <a:xfrm>
              <a:off x="1379213" y="2865898"/>
              <a:ext cx="790242" cy="309923"/>
            </a:xfrm>
            <a:custGeom>
              <a:avLst/>
              <a:gdLst>
                <a:gd name="T0" fmla="*/ 662802559 w 311"/>
                <a:gd name="T1" fmla="*/ 269655131 h 107"/>
                <a:gd name="T2" fmla="*/ 783770181 w 311"/>
                <a:gd name="T3" fmla="*/ 133567094 h 107"/>
                <a:gd name="T4" fmla="*/ 662802559 w 311"/>
                <a:gd name="T5" fmla="*/ 0 h 107"/>
                <a:gd name="T6" fmla="*/ 662802559 w 311"/>
                <a:gd name="T7" fmla="*/ 60483572 h 107"/>
                <a:gd name="T8" fmla="*/ 0 w 311"/>
                <a:gd name="T9" fmla="*/ 60483572 h 107"/>
                <a:gd name="T10" fmla="*/ 0 w 311"/>
                <a:gd name="T11" fmla="*/ 209171559 h 107"/>
                <a:gd name="T12" fmla="*/ 662802559 w 311"/>
                <a:gd name="T13" fmla="*/ 209171559 h 107"/>
                <a:gd name="T14" fmla="*/ 662802559 w 31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311"/>
                <a:gd name="T25" fmla="*/ 0 h 107"/>
                <a:gd name="T26" fmla="*/ 311 w 31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311" h="107">
                  <a:moveTo>
                    <a:pt x="263" y="107"/>
                  </a:moveTo>
                  <a:lnTo>
                    <a:pt x="311" y="53"/>
                  </a:lnTo>
                  <a:lnTo>
                    <a:pt x="263" y="0"/>
                  </a:lnTo>
                  <a:lnTo>
                    <a:pt x="263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63" y="83"/>
                  </a:lnTo>
                  <a:lnTo>
                    <a:pt x="263" y="107"/>
                  </a:lnTo>
                  <a:close/>
                </a:path>
              </a:pathLst>
            </a:custGeom>
            <a:pattFill prst="ltVert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91" name="Freeform 149"/>
            <p:cNvSpPr>
              <a:spLocks/>
            </p:cNvSpPr>
            <p:nvPr/>
          </p:nvSpPr>
          <p:spPr bwMode="auto">
            <a:xfrm>
              <a:off x="3686413" y="2865898"/>
              <a:ext cx="523440" cy="309923"/>
            </a:xfrm>
            <a:custGeom>
              <a:avLst/>
              <a:gdLst>
                <a:gd name="T0" fmla="*/ 395665325 w 206"/>
                <a:gd name="T1" fmla="*/ 269655131 h 107"/>
                <a:gd name="T2" fmla="*/ 519152188 w 206"/>
                <a:gd name="T3" fmla="*/ 133567094 h 107"/>
                <a:gd name="T4" fmla="*/ 395665325 w 206"/>
                <a:gd name="T5" fmla="*/ 0 h 107"/>
                <a:gd name="T6" fmla="*/ 395665325 w 206"/>
                <a:gd name="T7" fmla="*/ 60483572 h 107"/>
                <a:gd name="T8" fmla="*/ 0 w 206"/>
                <a:gd name="T9" fmla="*/ 60483572 h 107"/>
                <a:gd name="T10" fmla="*/ 0 w 206"/>
                <a:gd name="T11" fmla="*/ 209171559 h 107"/>
                <a:gd name="T12" fmla="*/ 395665325 w 206"/>
                <a:gd name="T13" fmla="*/ 209171559 h 107"/>
                <a:gd name="T14" fmla="*/ 395665325 w 20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06"/>
                <a:gd name="T25" fmla="*/ 0 h 107"/>
                <a:gd name="T26" fmla="*/ 206 w 20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06" h="107">
                  <a:moveTo>
                    <a:pt x="157" y="107"/>
                  </a:moveTo>
                  <a:lnTo>
                    <a:pt x="206" y="53"/>
                  </a:lnTo>
                  <a:lnTo>
                    <a:pt x="157" y="0"/>
                  </a:lnTo>
                  <a:lnTo>
                    <a:pt x="157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57" y="83"/>
                  </a:lnTo>
                  <a:lnTo>
                    <a:pt x="157" y="107"/>
                  </a:lnTo>
                  <a:close/>
                </a:path>
              </a:pathLst>
            </a:custGeom>
            <a:solidFill>
              <a:schemeClr val="tx1"/>
            </a:solid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92" name="Freeform 110" descr="Wide downward diagonal"/>
            <p:cNvSpPr>
              <a:spLocks/>
            </p:cNvSpPr>
            <p:nvPr/>
          </p:nvSpPr>
          <p:spPr bwMode="auto">
            <a:xfrm>
              <a:off x="4884618" y="2863311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pct10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4765688" y="2061695"/>
              <a:ext cx="8226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WPRE</a:t>
              </a:r>
              <a:endParaRPr lang="en-US" sz="2000" b="1" dirty="0"/>
            </a:p>
          </p:txBody>
        </p:sp>
        <p:cxnSp>
          <p:nvCxnSpPr>
            <p:cNvPr id="194" name="Straight Connector 193"/>
            <p:cNvCxnSpPr/>
            <p:nvPr/>
          </p:nvCxnSpPr>
          <p:spPr>
            <a:xfrm flipH="1">
              <a:off x="5176500" y="2394109"/>
              <a:ext cx="9175" cy="5550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5" name="TextBox 194"/>
          <p:cNvSpPr txBox="1"/>
          <p:nvPr/>
        </p:nvSpPr>
        <p:spPr>
          <a:xfrm>
            <a:off x="81185" y="307859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81185" y="413102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89283" y="640080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1 Fig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3509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381000" y="45720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grpSp>
        <p:nvGrpSpPr>
          <p:cNvPr id="39" name="Group 38"/>
          <p:cNvGrpSpPr/>
          <p:nvPr/>
        </p:nvGrpSpPr>
        <p:grpSpPr>
          <a:xfrm>
            <a:off x="941415" y="152400"/>
            <a:ext cx="5662396" cy="1603898"/>
            <a:chOff x="941415" y="152400"/>
            <a:chExt cx="5662396" cy="1603898"/>
          </a:xfrm>
        </p:grpSpPr>
        <p:sp>
          <p:nvSpPr>
            <p:cNvPr id="3" name="Rectangle 106"/>
            <p:cNvSpPr>
              <a:spLocks noChangeArrowheads="1"/>
            </p:cNvSpPr>
            <p:nvPr/>
          </p:nvSpPr>
          <p:spPr bwMode="auto">
            <a:xfrm>
              <a:off x="979530" y="1089841"/>
              <a:ext cx="10164" cy="43446"/>
            </a:xfrm>
            <a:prstGeom prst="rect">
              <a:avLst/>
            </a:prstGeom>
            <a:solidFill>
              <a:srgbClr val="FFFFCC"/>
            </a:solidFill>
            <a:ln w="0">
              <a:solidFill>
                <a:srgbClr val="CCCC99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4" name="Rectangle 107"/>
            <p:cNvSpPr>
              <a:spLocks noChangeArrowheads="1"/>
            </p:cNvSpPr>
            <p:nvPr/>
          </p:nvSpPr>
          <p:spPr bwMode="auto">
            <a:xfrm>
              <a:off x="989694" y="1089841"/>
              <a:ext cx="5066693" cy="43446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5" name="Line 111"/>
            <p:cNvSpPr>
              <a:spLocks noChangeShapeType="1"/>
            </p:cNvSpPr>
            <p:nvPr/>
          </p:nvSpPr>
          <p:spPr bwMode="auto">
            <a:xfrm>
              <a:off x="4872688" y="699326"/>
              <a:ext cx="4689" cy="3267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6" name="Rectangle 112"/>
            <p:cNvSpPr>
              <a:spLocks noChangeArrowheads="1"/>
            </p:cNvSpPr>
            <p:nvPr/>
          </p:nvSpPr>
          <p:spPr bwMode="auto">
            <a:xfrm>
              <a:off x="4625760" y="391549"/>
              <a:ext cx="43762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err="1" smtClean="0"/>
                <a:t>Hph</a:t>
              </a:r>
              <a:endParaRPr lang="en-US" altLang="en-US" sz="2000" b="1" dirty="0"/>
            </a:p>
          </p:txBody>
        </p:sp>
        <p:sp>
          <p:nvSpPr>
            <p:cNvPr id="7" name="Line 114"/>
            <p:cNvSpPr>
              <a:spLocks noChangeShapeType="1"/>
            </p:cNvSpPr>
            <p:nvPr/>
          </p:nvSpPr>
          <p:spPr bwMode="auto">
            <a:xfrm flipH="1">
              <a:off x="3749380" y="846740"/>
              <a:ext cx="2542" cy="1853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8" name="Rectangle 115"/>
            <p:cNvSpPr>
              <a:spLocks noChangeArrowheads="1"/>
            </p:cNvSpPr>
            <p:nvPr/>
          </p:nvSpPr>
          <p:spPr bwMode="auto">
            <a:xfrm>
              <a:off x="3471570" y="589385"/>
              <a:ext cx="56070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err="1" smtClean="0"/>
                <a:t>Lig</a:t>
              </a:r>
              <a:r>
                <a:rPr lang="en-US" altLang="en-US" sz="2000" b="1" dirty="0" smtClean="0"/>
                <a:t> A</a:t>
              </a:r>
              <a:endParaRPr lang="en-US" altLang="en-US" sz="2000" b="1" dirty="0"/>
            </a:p>
          </p:txBody>
        </p:sp>
        <p:sp>
          <p:nvSpPr>
            <p:cNvPr id="9" name="Line 117"/>
            <p:cNvSpPr>
              <a:spLocks noChangeShapeType="1"/>
            </p:cNvSpPr>
            <p:nvPr/>
          </p:nvSpPr>
          <p:spPr bwMode="auto">
            <a:xfrm>
              <a:off x="1248873" y="814674"/>
              <a:ext cx="94015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0" name="Rectangle 118"/>
            <p:cNvSpPr>
              <a:spLocks noChangeArrowheads="1"/>
            </p:cNvSpPr>
            <p:nvPr/>
          </p:nvSpPr>
          <p:spPr bwMode="auto">
            <a:xfrm>
              <a:off x="941415" y="585852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</a:rPr>
                <a:t>LTR</a:t>
              </a:r>
              <a:endParaRPr lang="en-US" altLang="en-US" sz="3200"/>
            </a:p>
          </p:txBody>
        </p:sp>
        <p:sp>
          <p:nvSpPr>
            <p:cNvPr id="11" name="Line 120"/>
            <p:cNvSpPr>
              <a:spLocks noChangeShapeType="1"/>
            </p:cNvSpPr>
            <p:nvPr/>
          </p:nvSpPr>
          <p:spPr bwMode="auto">
            <a:xfrm flipH="1">
              <a:off x="6271150" y="814674"/>
              <a:ext cx="71147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2" name="Rectangle 121"/>
            <p:cNvSpPr>
              <a:spLocks noChangeArrowheads="1"/>
            </p:cNvSpPr>
            <p:nvPr/>
          </p:nvSpPr>
          <p:spPr bwMode="auto">
            <a:xfrm>
              <a:off x="6352461" y="585852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>
                  <a:solidFill>
                    <a:srgbClr val="000000"/>
                  </a:solidFill>
                </a:rPr>
                <a:t>LTR</a:t>
              </a:r>
              <a:endParaRPr lang="en-US" altLang="en-US" sz="3200" dirty="0"/>
            </a:p>
          </p:txBody>
        </p:sp>
        <p:sp>
          <p:nvSpPr>
            <p:cNvPr id="13" name="Line 144"/>
            <p:cNvSpPr>
              <a:spLocks noChangeShapeType="1"/>
            </p:cNvSpPr>
            <p:nvPr/>
          </p:nvSpPr>
          <p:spPr bwMode="auto">
            <a:xfrm>
              <a:off x="2069605" y="753849"/>
              <a:ext cx="43197" cy="27227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4" name="Rectangle 145"/>
            <p:cNvSpPr>
              <a:spLocks noChangeArrowheads="1"/>
            </p:cNvSpPr>
            <p:nvPr/>
          </p:nvSpPr>
          <p:spPr bwMode="auto">
            <a:xfrm>
              <a:off x="1761116" y="423199"/>
              <a:ext cx="584423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>
                  <a:solidFill>
                    <a:srgbClr val="000000"/>
                  </a:solidFill>
                </a:rPr>
                <a:t>Gag</a:t>
              </a:r>
              <a:endParaRPr lang="en-US" altLang="en-US" sz="4400" dirty="0"/>
            </a:p>
          </p:txBody>
        </p:sp>
        <p:sp>
          <p:nvSpPr>
            <p:cNvPr id="15" name="Line 150"/>
            <p:cNvSpPr>
              <a:spLocks noChangeShapeType="1"/>
            </p:cNvSpPr>
            <p:nvPr/>
          </p:nvSpPr>
          <p:spPr bwMode="auto">
            <a:xfrm flipH="1">
              <a:off x="4285331" y="533050"/>
              <a:ext cx="14855" cy="4930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6" name="Rectangle 151"/>
            <p:cNvSpPr>
              <a:spLocks noChangeArrowheads="1"/>
            </p:cNvSpPr>
            <p:nvPr/>
          </p:nvSpPr>
          <p:spPr bwMode="auto">
            <a:xfrm>
              <a:off x="4114366" y="292504"/>
              <a:ext cx="37163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 smtClean="0">
                  <a:solidFill>
                    <a:srgbClr val="000000"/>
                  </a:solidFill>
                </a:rPr>
                <a:t>SV40</a:t>
              </a:r>
              <a:endParaRPr lang="en-US" altLang="en-US" sz="3200" baseline="-25000" dirty="0"/>
            </a:p>
          </p:txBody>
        </p:sp>
        <p:sp>
          <p:nvSpPr>
            <p:cNvPr id="17" name="Freeform 110" descr="Wide downward diagonal"/>
            <p:cNvSpPr>
              <a:spLocks/>
            </p:cNvSpPr>
            <p:nvPr/>
          </p:nvSpPr>
          <p:spPr bwMode="auto">
            <a:xfrm>
              <a:off x="4564837" y="956603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wdDnDiag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8" name="Freeform 113" descr="5%"/>
            <p:cNvSpPr>
              <a:spLocks/>
            </p:cNvSpPr>
            <p:nvPr/>
          </p:nvSpPr>
          <p:spPr bwMode="auto">
            <a:xfrm>
              <a:off x="3523039" y="961233"/>
              <a:ext cx="457767" cy="309923"/>
            </a:xfrm>
            <a:custGeom>
              <a:avLst/>
              <a:gdLst>
                <a:gd name="T0" fmla="*/ 617436824 w 293"/>
                <a:gd name="T1" fmla="*/ 269655131 h 107"/>
                <a:gd name="T2" fmla="*/ 738404194 w 293"/>
                <a:gd name="T3" fmla="*/ 133567094 h 107"/>
                <a:gd name="T4" fmla="*/ 617436824 w 293"/>
                <a:gd name="T5" fmla="*/ 0 h 107"/>
                <a:gd name="T6" fmla="*/ 617436824 w 293"/>
                <a:gd name="T7" fmla="*/ 60483572 h 107"/>
                <a:gd name="T8" fmla="*/ 0 w 293"/>
                <a:gd name="T9" fmla="*/ 60483572 h 107"/>
                <a:gd name="T10" fmla="*/ 0 w 293"/>
                <a:gd name="T11" fmla="*/ 209171559 h 107"/>
                <a:gd name="T12" fmla="*/ 617436824 w 293"/>
                <a:gd name="T13" fmla="*/ 209171559 h 107"/>
                <a:gd name="T14" fmla="*/ 617436824 w 293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93"/>
                <a:gd name="T25" fmla="*/ 0 h 107"/>
                <a:gd name="T26" fmla="*/ 293 w 293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93" h="107">
                  <a:moveTo>
                    <a:pt x="245" y="107"/>
                  </a:moveTo>
                  <a:lnTo>
                    <a:pt x="293" y="53"/>
                  </a:lnTo>
                  <a:lnTo>
                    <a:pt x="245" y="0"/>
                  </a:lnTo>
                  <a:lnTo>
                    <a:pt x="245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45" y="83"/>
                  </a:lnTo>
                  <a:lnTo>
                    <a:pt x="245" y="107"/>
                  </a:lnTo>
                  <a:close/>
                </a:path>
              </a:pathLst>
            </a:custGeom>
            <a:pattFill prst="dkVert">
              <a:fgClr>
                <a:schemeClr val="tx1"/>
              </a:fgClr>
              <a:bgClr>
                <a:schemeClr val="bg1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9" name="Freeform 116" descr="Small grid"/>
            <p:cNvSpPr>
              <a:spLocks/>
            </p:cNvSpPr>
            <p:nvPr/>
          </p:nvSpPr>
          <p:spPr bwMode="auto">
            <a:xfrm>
              <a:off x="961743" y="962396"/>
              <a:ext cx="701308" cy="309923"/>
            </a:xfrm>
            <a:custGeom>
              <a:avLst/>
              <a:gdLst>
                <a:gd name="T0" fmla="*/ 574595625 w 276"/>
                <a:gd name="T1" fmla="*/ 269655131 h 107"/>
                <a:gd name="T2" fmla="*/ 695563125 w 276"/>
                <a:gd name="T3" fmla="*/ 133567094 h 107"/>
                <a:gd name="T4" fmla="*/ 574595625 w 276"/>
                <a:gd name="T5" fmla="*/ 0 h 107"/>
                <a:gd name="T6" fmla="*/ 574595625 w 276"/>
                <a:gd name="T7" fmla="*/ 60483572 h 107"/>
                <a:gd name="T8" fmla="*/ 0 w 276"/>
                <a:gd name="T9" fmla="*/ 60483572 h 107"/>
                <a:gd name="T10" fmla="*/ 0 w 276"/>
                <a:gd name="T11" fmla="*/ 209171559 h 107"/>
                <a:gd name="T12" fmla="*/ 574595625 w 276"/>
                <a:gd name="T13" fmla="*/ 209171559 h 107"/>
                <a:gd name="T14" fmla="*/ 574595625 w 27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76"/>
                <a:gd name="T25" fmla="*/ 0 h 107"/>
                <a:gd name="T26" fmla="*/ 276 w 27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76" h="107">
                  <a:moveTo>
                    <a:pt x="228" y="107"/>
                  </a:moveTo>
                  <a:lnTo>
                    <a:pt x="276" y="53"/>
                  </a:lnTo>
                  <a:lnTo>
                    <a:pt x="228" y="0"/>
                  </a:lnTo>
                  <a:lnTo>
                    <a:pt x="228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28" y="83"/>
                  </a:lnTo>
                  <a:lnTo>
                    <a:pt x="228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20" name="Freeform 119" descr="Small grid"/>
            <p:cNvSpPr>
              <a:spLocks/>
            </p:cNvSpPr>
            <p:nvPr/>
          </p:nvSpPr>
          <p:spPr bwMode="auto">
            <a:xfrm>
              <a:off x="5881230" y="956603"/>
              <a:ext cx="714013" cy="309923"/>
            </a:xfrm>
            <a:custGeom>
              <a:avLst/>
              <a:gdLst>
                <a:gd name="T0" fmla="*/ 589717223 w 281"/>
                <a:gd name="T1" fmla="*/ 269655131 h 107"/>
                <a:gd name="T2" fmla="*/ 708165494 w 281"/>
                <a:gd name="T3" fmla="*/ 133567094 h 107"/>
                <a:gd name="T4" fmla="*/ 589717223 w 281"/>
                <a:gd name="T5" fmla="*/ 0 h 107"/>
                <a:gd name="T6" fmla="*/ 589717223 w 281"/>
                <a:gd name="T7" fmla="*/ 60483572 h 107"/>
                <a:gd name="T8" fmla="*/ 0 w 281"/>
                <a:gd name="T9" fmla="*/ 60483572 h 107"/>
                <a:gd name="T10" fmla="*/ 0 w 281"/>
                <a:gd name="T11" fmla="*/ 209171559 h 107"/>
                <a:gd name="T12" fmla="*/ 589717223 w 281"/>
                <a:gd name="T13" fmla="*/ 209171559 h 107"/>
                <a:gd name="T14" fmla="*/ 589717223 w 28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81"/>
                <a:gd name="T25" fmla="*/ 0 h 107"/>
                <a:gd name="T26" fmla="*/ 281 w 28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81" h="107">
                  <a:moveTo>
                    <a:pt x="234" y="107"/>
                  </a:moveTo>
                  <a:lnTo>
                    <a:pt x="281" y="53"/>
                  </a:lnTo>
                  <a:lnTo>
                    <a:pt x="234" y="0"/>
                  </a:lnTo>
                  <a:lnTo>
                    <a:pt x="234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34" y="83"/>
                  </a:lnTo>
                  <a:lnTo>
                    <a:pt x="234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21" name="Freeform 143" descr="Light vertical"/>
            <p:cNvSpPr>
              <a:spLocks/>
            </p:cNvSpPr>
            <p:nvPr/>
          </p:nvSpPr>
          <p:spPr bwMode="auto">
            <a:xfrm>
              <a:off x="1718952" y="956603"/>
              <a:ext cx="790242" cy="309923"/>
            </a:xfrm>
            <a:custGeom>
              <a:avLst/>
              <a:gdLst>
                <a:gd name="T0" fmla="*/ 662802559 w 311"/>
                <a:gd name="T1" fmla="*/ 269655131 h 107"/>
                <a:gd name="T2" fmla="*/ 783770181 w 311"/>
                <a:gd name="T3" fmla="*/ 133567094 h 107"/>
                <a:gd name="T4" fmla="*/ 662802559 w 311"/>
                <a:gd name="T5" fmla="*/ 0 h 107"/>
                <a:gd name="T6" fmla="*/ 662802559 w 311"/>
                <a:gd name="T7" fmla="*/ 60483572 h 107"/>
                <a:gd name="T8" fmla="*/ 0 w 311"/>
                <a:gd name="T9" fmla="*/ 60483572 h 107"/>
                <a:gd name="T10" fmla="*/ 0 w 311"/>
                <a:gd name="T11" fmla="*/ 209171559 h 107"/>
                <a:gd name="T12" fmla="*/ 662802559 w 311"/>
                <a:gd name="T13" fmla="*/ 209171559 h 107"/>
                <a:gd name="T14" fmla="*/ 662802559 w 31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311"/>
                <a:gd name="T25" fmla="*/ 0 h 107"/>
                <a:gd name="T26" fmla="*/ 311 w 31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311" h="107">
                  <a:moveTo>
                    <a:pt x="263" y="107"/>
                  </a:moveTo>
                  <a:lnTo>
                    <a:pt x="311" y="53"/>
                  </a:lnTo>
                  <a:lnTo>
                    <a:pt x="263" y="0"/>
                  </a:lnTo>
                  <a:lnTo>
                    <a:pt x="263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63" y="83"/>
                  </a:lnTo>
                  <a:lnTo>
                    <a:pt x="263" y="107"/>
                  </a:lnTo>
                  <a:close/>
                </a:path>
              </a:pathLst>
            </a:custGeom>
            <a:pattFill prst="ltVert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22" name="Freeform 149"/>
            <p:cNvSpPr>
              <a:spLocks/>
            </p:cNvSpPr>
            <p:nvPr/>
          </p:nvSpPr>
          <p:spPr bwMode="auto">
            <a:xfrm>
              <a:off x="4026152" y="956603"/>
              <a:ext cx="523440" cy="309923"/>
            </a:xfrm>
            <a:custGeom>
              <a:avLst/>
              <a:gdLst>
                <a:gd name="T0" fmla="*/ 395665325 w 206"/>
                <a:gd name="T1" fmla="*/ 269655131 h 107"/>
                <a:gd name="T2" fmla="*/ 519152188 w 206"/>
                <a:gd name="T3" fmla="*/ 133567094 h 107"/>
                <a:gd name="T4" fmla="*/ 395665325 w 206"/>
                <a:gd name="T5" fmla="*/ 0 h 107"/>
                <a:gd name="T6" fmla="*/ 395665325 w 206"/>
                <a:gd name="T7" fmla="*/ 60483572 h 107"/>
                <a:gd name="T8" fmla="*/ 0 w 206"/>
                <a:gd name="T9" fmla="*/ 60483572 h 107"/>
                <a:gd name="T10" fmla="*/ 0 w 206"/>
                <a:gd name="T11" fmla="*/ 209171559 h 107"/>
                <a:gd name="T12" fmla="*/ 395665325 w 206"/>
                <a:gd name="T13" fmla="*/ 209171559 h 107"/>
                <a:gd name="T14" fmla="*/ 395665325 w 20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06"/>
                <a:gd name="T25" fmla="*/ 0 h 107"/>
                <a:gd name="T26" fmla="*/ 206 w 20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06" h="107">
                  <a:moveTo>
                    <a:pt x="157" y="107"/>
                  </a:moveTo>
                  <a:lnTo>
                    <a:pt x="206" y="53"/>
                  </a:lnTo>
                  <a:lnTo>
                    <a:pt x="157" y="0"/>
                  </a:lnTo>
                  <a:lnTo>
                    <a:pt x="157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57" y="83"/>
                  </a:lnTo>
                  <a:lnTo>
                    <a:pt x="157" y="107"/>
                  </a:lnTo>
                  <a:close/>
                </a:path>
              </a:pathLst>
            </a:custGeom>
            <a:solidFill>
              <a:schemeClr val="tx1"/>
            </a:solid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23" name="Freeform 110" descr="Wide downward diagonal"/>
            <p:cNvSpPr>
              <a:spLocks/>
            </p:cNvSpPr>
            <p:nvPr/>
          </p:nvSpPr>
          <p:spPr bwMode="auto">
            <a:xfrm>
              <a:off x="5224357" y="954016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pct10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105427" y="152400"/>
              <a:ext cx="8226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WPRE</a:t>
              </a:r>
              <a:endParaRPr lang="en-US" sz="2000" b="1" dirty="0"/>
            </a:p>
          </p:txBody>
        </p:sp>
        <p:cxnSp>
          <p:nvCxnSpPr>
            <p:cNvPr id="25" name="Straight Connector 24"/>
            <p:cNvCxnSpPr/>
            <p:nvPr/>
          </p:nvCxnSpPr>
          <p:spPr>
            <a:xfrm flipH="1">
              <a:off x="5516239" y="484814"/>
              <a:ext cx="9175" cy="5550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Freeform 113" descr="5%"/>
            <p:cNvSpPr>
              <a:spLocks/>
            </p:cNvSpPr>
            <p:nvPr/>
          </p:nvSpPr>
          <p:spPr bwMode="auto">
            <a:xfrm>
              <a:off x="2987862" y="962395"/>
              <a:ext cx="317314" cy="309923"/>
            </a:xfrm>
            <a:custGeom>
              <a:avLst/>
              <a:gdLst>
                <a:gd name="T0" fmla="*/ 617436824 w 293"/>
                <a:gd name="T1" fmla="*/ 269655131 h 107"/>
                <a:gd name="T2" fmla="*/ 738404194 w 293"/>
                <a:gd name="T3" fmla="*/ 133567094 h 107"/>
                <a:gd name="T4" fmla="*/ 617436824 w 293"/>
                <a:gd name="T5" fmla="*/ 0 h 107"/>
                <a:gd name="T6" fmla="*/ 617436824 w 293"/>
                <a:gd name="T7" fmla="*/ 60483572 h 107"/>
                <a:gd name="T8" fmla="*/ 0 w 293"/>
                <a:gd name="T9" fmla="*/ 60483572 h 107"/>
                <a:gd name="T10" fmla="*/ 0 w 293"/>
                <a:gd name="T11" fmla="*/ 209171559 h 107"/>
                <a:gd name="T12" fmla="*/ 617436824 w 293"/>
                <a:gd name="T13" fmla="*/ 209171559 h 107"/>
                <a:gd name="T14" fmla="*/ 617436824 w 293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93"/>
                <a:gd name="T25" fmla="*/ 0 h 107"/>
                <a:gd name="T26" fmla="*/ 293 w 293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93" h="107">
                  <a:moveTo>
                    <a:pt x="245" y="107"/>
                  </a:moveTo>
                  <a:lnTo>
                    <a:pt x="293" y="53"/>
                  </a:lnTo>
                  <a:lnTo>
                    <a:pt x="245" y="0"/>
                  </a:lnTo>
                  <a:lnTo>
                    <a:pt x="245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45" y="83"/>
                  </a:lnTo>
                  <a:lnTo>
                    <a:pt x="245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chemeClr val="bg1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28" name="Line 114"/>
            <p:cNvSpPr>
              <a:spLocks noChangeShapeType="1"/>
            </p:cNvSpPr>
            <p:nvPr/>
          </p:nvSpPr>
          <p:spPr bwMode="auto">
            <a:xfrm flipH="1">
              <a:off x="3146519" y="837196"/>
              <a:ext cx="2542" cy="1853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849716" y="484814"/>
              <a:ext cx="6083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MTS</a:t>
              </a:r>
              <a:endParaRPr lang="en-US" b="1" dirty="0"/>
            </a:p>
          </p:txBody>
        </p:sp>
        <p:sp>
          <p:nvSpPr>
            <p:cNvPr id="31" name="Rectangle 30"/>
            <p:cNvSpPr/>
            <p:nvPr/>
          </p:nvSpPr>
          <p:spPr bwMode="auto">
            <a:xfrm>
              <a:off x="3333450" y="1022571"/>
              <a:ext cx="154880" cy="16806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3200"/>
            </a:p>
          </p:txBody>
        </p:sp>
        <p:sp>
          <p:nvSpPr>
            <p:cNvPr id="32" name="Rectangle 31"/>
            <p:cNvSpPr/>
            <p:nvPr/>
          </p:nvSpPr>
          <p:spPr bwMode="auto">
            <a:xfrm>
              <a:off x="2812556" y="1022571"/>
              <a:ext cx="154880" cy="16806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3200"/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2615913" y="1190637"/>
              <a:ext cx="531877" cy="554707"/>
              <a:chOff x="2615913" y="1495437"/>
              <a:chExt cx="531877" cy="554707"/>
            </a:xfrm>
          </p:grpSpPr>
          <p:sp>
            <p:nvSpPr>
              <p:cNvPr id="33" name="Line 114"/>
              <p:cNvSpPr>
                <a:spLocks noChangeShapeType="1"/>
              </p:cNvSpPr>
              <p:nvPr/>
            </p:nvSpPr>
            <p:spPr bwMode="auto">
              <a:xfrm flipH="1">
                <a:off x="2877930" y="1495437"/>
                <a:ext cx="2542" cy="1853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320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615913" y="1680812"/>
                <a:ext cx="531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FRT</a:t>
                </a:r>
                <a:endParaRPr lang="en-US" b="1" dirty="0"/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3143096" y="1201591"/>
              <a:ext cx="531877" cy="554707"/>
              <a:chOff x="2615913" y="1495437"/>
              <a:chExt cx="531877" cy="554707"/>
            </a:xfrm>
          </p:grpSpPr>
          <p:sp>
            <p:nvSpPr>
              <p:cNvPr id="37" name="Line 114"/>
              <p:cNvSpPr>
                <a:spLocks noChangeShapeType="1"/>
              </p:cNvSpPr>
              <p:nvPr/>
            </p:nvSpPr>
            <p:spPr bwMode="auto">
              <a:xfrm flipH="1">
                <a:off x="2877930" y="1495437"/>
                <a:ext cx="2542" cy="1853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320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2615913" y="1680812"/>
                <a:ext cx="531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FRT</a:t>
                </a:r>
                <a:endParaRPr lang="en-US" b="1" dirty="0"/>
              </a:p>
            </p:txBody>
          </p:sp>
        </p:grpSp>
      </p:grpSp>
      <p:grpSp>
        <p:nvGrpSpPr>
          <p:cNvPr id="29" name="Group 28"/>
          <p:cNvGrpSpPr/>
          <p:nvPr/>
        </p:nvGrpSpPr>
        <p:grpSpPr>
          <a:xfrm>
            <a:off x="733577" y="3858826"/>
            <a:ext cx="2581375" cy="2389574"/>
            <a:chOff x="733577" y="2224088"/>
            <a:chExt cx="2581375" cy="2389574"/>
          </a:xfrm>
        </p:grpSpPr>
        <p:sp>
          <p:nvSpPr>
            <p:cNvPr id="43" name="Oval 8"/>
            <p:cNvSpPr>
              <a:spLocks noChangeArrowheads="1"/>
            </p:cNvSpPr>
            <p:nvPr/>
          </p:nvSpPr>
          <p:spPr bwMode="auto">
            <a:xfrm>
              <a:off x="1198563" y="2590800"/>
              <a:ext cx="1493837" cy="1495425"/>
            </a:xfrm>
            <a:prstGeom prst="ellips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Line 9"/>
            <p:cNvSpPr>
              <a:spLocks noChangeShapeType="1"/>
            </p:cNvSpPr>
            <p:nvPr/>
          </p:nvSpPr>
          <p:spPr bwMode="auto">
            <a:xfrm flipV="1">
              <a:off x="1957388" y="2574925"/>
              <a:ext cx="0" cy="158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Rectangle 10"/>
            <p:cNvSpPr>
              <a:spLocks noChangeArrowheads="1"/>
            </p:cNvSpPr>
            <p:nvPr/>
          </p:nvSpPr>
          <p:spPr bwMode="auto">
            <a:xfrm>
              <a:off x="1751013" y="3217863"/>
              <a:ext cx="50654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MA4014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11"/>
            <p:cNvSpPr>
              <a:spLocks noChangeArrowheads="1"/>
            </p:cNvSpPr>
            <p:nvPr/>
          </p:nvSpPr>
          <p:spPr bwMode="auto">
            <a:xfrm>
              <a:off x="1795463" y="3348038"/>
              <a:ext cx="34290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itchFamily="49" charset="0"/>
                  <a:cs typeface="Arial" pitchFamily="34" charset="0"/>
                </a:rPr>
                <a:t>6588 bp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Freeform 12"/>
            <p:cNvSpPr>
              <a:spLocks/>
            </p:cNvSpPr>
            <p:nvPr/>
          </p:nvSpPr>
          <p:spPr bwMode="auto">
            <a:xfrm>
              <a:off x="1379538" y="3846513"/>
              <a:ext cx="449262" cy="277813"/>
            </a:xfrm>
            <a:custGeom>
              <a:avLst/>
              <a:gdLst>
                <a:gd name="T0" fmla="*/ 50 w 283"/>
                <a:gd name="T1" fmla="*/ 0 h 175"/>
                <a:gd name="T2" fmla="*/ 2 w 283"/>
                <a:gd name="T3" fmla="*/ 3 h 175"/>
                <a:gd name="T4" fmla="*/ 0 w 283"/>
                <a:gd name="T5" fmla="*/ 51 h 175"/>
                <a:gd name="T6" fmla="*/ 11 w 283"/>
                <a:gd name="T7" fmla="*/ 40 h 175"/>
                <a:gd name="T8" fmla="*/ 44 w 283"/>
                <a:gd name="T9" fmla="*/ 69 h 175"/>
                <a:gd name="T10" fmla="*/ 79 w 283"/>
                <a:gd name="T11" fmla="*/ 97 h 175"/>
                <a:gd name="T12" fmla="*/ 118 w 283"/>
                <a:gd name="T13" fmla="*/ 119 h 175"/>
                <a:gd name="T14" fmla="*/ 158 w 283"/>
                <a:gd name="T15" fmla="*/ 140 h 175"/>
                <a:gd name="T16" fmla="*/ 200 w 283"/>
                <a:gd name="T17" fmla="*/ 156 h 175"/>
                <a:gd name="T18" fmla="*/ 241 w 283"/>
                <a:gd name="T19" fmla="*/ 168 h 175"/>
                <a:gd name="T20" fmla="*/ 277 w 283"/>
                <a:gd name="T21" fmla="*/ 175 h 175"/>
                <a:gd name="T22" fmla="*/ 283 w 283"/>
                <a:gd name="T23" fmla="*/ 136 h 175"/>
                <a:gd name="T24" fmla="*/ 244 w 283"/>
                <a:gd name="T25" fmla="*/ 127 h 175"/>
                <a:gd name="T26" fmla="*/ 204 w 283"/>
                <a:gd name="T27" fmla="*/ 116 h 175"/>
                <a:gd name="T28" fmla="*/ 166 w 283"/>
                <a:gd name="T29" fmla="*/ 100 h 175"/>
                <a:gd name="T30" fmla="*/ 129 w 283"/>
                <a:gd name="T31" fmla="*/ 81 h 175"/>
                <a:gd name="T32" fmla="*/ 95 w 283"/>
                <a:gd name="T33" fmla="*/ 59 h 175"/>
                <a:gd name="T34" fmla="*/ 62 w 283"/>
                <a:gd name="T35" fmla="*/ 33 h 175"/>
                <a:gd name="T36" fmla="*/ 39 w 283"/>
                <a:gd name="T37" fmla="*/ 12 h 175"/>
                <a:gd name="T38" fmla="*/ 50 w 283"/>
                <a:gd name="T39" fmla="*/ 0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283" h="175">
                  <a:moveTo>
                    <a:pt x="50" y="0"/>
                  </a:moveTo>
                  <a:lnTo>
                    <a:pt x="2" y="3"/>
                  </a:lnTo>
                  <a:lnTo>
                    <a:pt x="0" y="51"/>
                  </a:lnTo>
                  <a:lnTo>
                    <a:pt x="11" y="40"/>
                  </a:lnTo>
                  <a:lnTo>
                    <a:pt x="44" y="69"/>
                  </a:lnTo>
                  <a:lnTo>
                    <a:pt x="79" y="97"/>
                  </a:lnTo>
                  <a:lnTo>
                    <a:pt x="118" y="119"/>
                  </a:lnTo>
                  <a:lnTo>
                    <a:pt x="158" y="140"/>
                  </a:lnTo>
                  <a:lnTo>
                    <a:pt x="200" y="156"/>
                  </a:lnTo>
                  <a:lnTo>
                    <a:pt x="241" y="168"/>
                  </a:lnTo>
                  <a:lnTo>
                    <a:pt x="277" y="175"/>
                  </a:lnTo>
                  <a:lnTo>
                    <a:pt x="283" y="136"/>
                  </a:lnTo>
                  <a:lnTo>
                    <a:pt x="244" y="127"/>
                  </a:lnTo>
                  <a:lnTo>
                    <a:pt x="204" y="116"/>
                  </a:lnTo>
                  <a:lnTo>
                    <a:pt x="166" y="100"/>
                  </a:lnTo>
                  <a:lnTo>
                    <a:pt x="129" y="81"/>
                  </a:lnTo>
                  <a:lnTo>
                    <a:pt x="95" y="59"/>
                  </a:lnTo>
                  <a:lnTo>
                    <a:pt x="62" y="33"/>
                  </a:lnTo>
                  <a:lnTo>
                    <a:pt x="39" y="12"/>
                  </a:lnTo>
                  <a:lnTo>
                    <a:pt x="50" y="0"/>
                  </a:lnTo>
                  <a:close/>
                </a:path>
              </a:pathLst>
            </a:custGeom>
            <a:solidFill>
              <a:srgbClr val="FF66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Arc 13"/>
            <p:cNvSpPr>
              <a:spLocks/>
            </p:cNvSpPr>
            <p:nvPr/>
          </p:nvSpPr>
          <p:spPr bwMode="auto">
            <a:xfrm>
              <a:off x="1400175" y="3338513"/>
              <a:ext cx="546100" cy="777875"/>
            </a:xfrm>
            <a:custGeom>
              <a:avLst/>
              <a:gdLst>
                <a:gd name="G0" fmla="+- 14976 0 0"/>
                <a:gd name="G1" fmla="+- 0 0 0"/>
                <a:gd name="G2" fmla="+- 21600 0 0"/>
                <a:gd name="T0" fmla="*/ 11526 w 14976"/>
                <a:gd name="T1" fmla="*/ 21323 h 21323"/>
                <a:gd name="T2" fmla="*/ 0 w 14976"/>
                <a:gd name="T3" fmla="*/ 15566 h 21323"/>
                <a:gd name="T4" fmla="*/ 14976 w 14976"/>
                <a:gd name="T5" fmla="*/ 0 h 213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76" h="21323" fill="none" extrusionOk="0">
                  <a:moveTo>
                    <a:pt x="11526" y="21322"/>
                  </a:moveTo>
                  <a:cubicBezTo>
                    <a:pt x="7187" y="20620"/>
                    <a:pt x="3167" y="18612"/>
                    <a:pt x="0" y="15565"/>
                  </a:cubicBezTo>
                </a:path>
                <a:path w="14976" h="21323" stroke="0" extrusionOk="0">
                  <a:moveTo>
                    <a:pt x="11526" y="21322"/>
                  </a:moveTo>
                  <a:cubicBezTo>
                    <a:pt x="7187" y="20620"/>
                    <a:pt x="3167" y="18612"/>
                    <a:pt x="0" y="15565"/>
                  </a:cubicBezTo>
                  <a:lnTo>
                    <a:pt x="14976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Arc 14"/>
            <p:cNvSpPr>
              <a:spLocks/>
            </p:cNvSpPr>
            <p:nvPr/>
          </p:nvSpPr>
          <p:spPr bwMode="auto">
            <a:xfrm>
              <a:off x="1444625" y="3338513"/>
              <a:ext cx="501650" cy="714375"/>
            </a:xfrm>
            <a:custGeom>
              <a:avLst/>
              <a:gdLst>
                <a:gd name="G0" fmla="+- 14933 0 0"/>
                <a:gd name="G1" fmla="+- 0 0 0"/>
                <a:gd name="G2" fmla="+- 21600 0 0"/>
                <a:gd name="T0" fmla="*/ 11477 w 14933"/>
                <a:gd name="T1" fmla="*/ 21322 h 21322"/>
                <a:gd name="T2" fmla="*/ 0 w 14933"/>
                <a:gd name="T3" fmla="*/ 15607 h 21322"/>
                <a:gd name="T4" fmla="*/ 14933 w 14933"/>
                <a:gd name="T5" fmla="*/ 0 h 213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33" h="21322" fill="none" extrusionOk="0">
                  <a:moveTo>
                    <a:pt x="11477" y="21321"/>
                  </a:moveTo>
                  <a:cubicBezTo>
                    <a:pt x="7161" y="20622"/>
                    <a:pt x="3159" y="18629"/>
                    <a:pt x="0" y="15606"/>
                  </a:cubicBezTo>
                </a:path>
                <a:path w="14933" h="21322" stroke="0" extrusionOk="0">
                  <a:moveTo>
                    <a:pt x="11477" y="21321"/>
                  </a:moveTo>
                  <a:cubicBezTo>
                    <a:pt x="7161" y="20622"/>
                    <a:pt x="3159" y="18629"/>
                    <a:pt x="0" y="15606"/>
                  </a:cubicBezTo>
                  <a:lnTo>
                    <a:pt x="14933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Line 15"/>
            <p:cNvSpPr>
              <a:spLocks noChangeShapeType="1"/>
            </p:cNvSpPr>
            <p:nvPr/>
          </p:nvSpPr>
          <p:spPr bwMode="auto">
            <a:xfrm flipH="1">
              <a:off x="1819275" y="4062413"/>
              <a:ext cx="9525" cy="619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Freeform 16"/>
            <p:cNvSpPr>
              <a:spLocks/>
            </p:cNvSpPr>
            <p:nvPr/>
          </p:nvSpPr>
          <p:spPr bwMode="auto">
            <a:xfrm>
              <a:off x="1379538" y="3846513"/>
              <a:ext cx="79375" cy="80963"/>
            </a:xfrm>
            <a:custGeom>
              <a:avLst/>
              <a:gdLst>
                <a:gd name="T0" fmla="*/ 34 w 44"/>
                <a:gd name="T1" fmla="*/ 10 h 45"/>
                <a:gd name="T2" fmla="*/ 44 w 44"/>
                <a:gd name="T3" fmla="*/ 0 h 45"/>
                <a:gd name="T4" fmla="*/ 2 w 44"/>
                <a:gd name="T5" fmla="*/ 2 h 45"/>
                <a:gd name="T6" fmla="*/ 0 w 44"/>
                <a:gd name="T7" fmla="*/ 45 h 45"/>
                <a:gd name="T8" fmla="*/ 10 w 44"/>
                <a:gd name="T9" fmla="*/ 35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4" h="45">
                  <a:moveTo>
                    <a:pt x="34" y="10"/>
                  </a:moveTo>
                  <a:lnTo>
                    <a:pt x="44" y="0"/>
                  </a:lnTo>
                  <a:lnTo>
                    <a:pt x="2" y="2"/>
                  </a:lnTo>
                  <a:lnTo>
                    <a:pt x="0" y="45"/>
                  </a:lnTo>
                  <a:lnTo>
                    <a:pt x="10" y="35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Line 17"/>
            <p:cNvSpPr>
              <a:spLocks noChangeShapeType="1"/>
            </p:cNvSpPr>
            <p:nvPr/>
          </p:nvSpPr>
          <p:spPr bwMode="auto">
            <a:xfrm flipV="1">
              <a:off x="1408113" y="4037013"/>
              <a:ext cx="160337" cy="165100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Rectangle 18"/>
            <p:cNvSpPr>
              <a:spLocks noChangeArrowheads="1"/>
            </p:cNvSpPr>
            <p:nvPr/>
          </p:nvSpPr>
          <p:spPr bwMode="auto">
            <a:xfrm>
              <a:off x="827826" y="4203700"/>
              <a:ext cx="58028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err="1" smtClean="0">
                  <a:ln>
                    <a:noFill/>
                  </a:ln>
                  <a:solidFill>
                    <a:srgbClr val="800000"/>
                  </a:solidFill>
                  <a:effectLst/>
                  <a:latin typeface="Arial" pitchFamily="34" charset="0"/>
                  <a:cs typeface="Arial" pitchFamily="34" charset="0"/>
                </a:rPr>
                <a:t>mCherr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Freeform 19"/>
            <p:cNvSpPr>
              <a:spLocks/>
            </p:cNvSpPr>
            <p:nvPr/>
          </p:nvSpPr>
          <p:spPr bwMode="auto">
            <a:xfrm>
              <a:off x="1323975" y="2559050"/>
              <a:ext cx="538162" cy="338138"/>
            </a:xfrm>
            <a:custGeom>
              <a:avLst/>
              <a:gdLst>
                <a:gd name="T0" fmla="*/ 334 w 339"/>
                <a:gd name="T1" fmla="*/ 0 h 213"/>
                <a:gd name="T2" fmla="*/ 290 w 339"/>
                <a:gd name="T3" fmla="*/ 7 h 213"/>
                <a:gd name="T4" fmla="*/ 247 w 339"/>
                <a:gd name="T5" fmla="*/ 18 h 213"/>
                <a:gd name="T6" fmla="*/ 205 w 339"/>
                <a:gd name="T7" fmla="*/ 33 h 213"/>
                <a:gd name="T8" fmla="*/ 164 w 339"/>
                <a:gd name="T9" fmla="*/ 52 h 213"/>
                <a:gd name="T10" fmla="*/ 126 w 339"/>
                <a:gd name="T11" fmla="*/ 75 h 213"/>
                <a:gd name="T12" fmla="*/ 89 w 339"/>
                <a:gd name="T13" fmla="*/ 100 h 213"/>
                <a:gd name="T14" fmla="*/ 55 w 339"/>
                <a:gd name="T15" fmla="*/ 129 h 213"/>
                <a:gd name="T16" fmla="*/ 24 w 339"/>
                <a:gd name="T17" fmla="*/ 161 h 213"/>
                <a:gd name="T18" fmla="*/ 11 w 339"/>
                <a:gd name="T19" fmla="*/ 176 h 213"/>
                <a:gd name="T20" fmla="*/ 0 w 339"/>
                <a:gd name="T21" fmla="*/ 165 h 213"/>
                <a:gd name="T22" fmla="*/ 8 w 339"/>
                <a:gd name="T23" fmla="*/ 213 h 213"/>
                <a:gd name="T24" fmla="*/ 54 w 339"/>
                <a:gd name="T25" fmla="*/ 211 h 213"/>
                <a:gd name="T26" fmla="*/ 42 w 339"/>
                <a:gd name="T27" fmla="*/ 200 h 213"/>
                <a:gd name="T28" fmla="*/ 69 w 339"/>
                <a:gd name="T29" fmla="*/ 170 h 213"/>
                <a:gd name="T30" fmla="*/ 100 w 339"/>
                <a:gd name="T31" fmla="*/ 143 h 213"/>
                <a:gd name="T32" fmla="*/ 133 w 339"/>
                <a:gd name="T33" fmla="*/ 118 h 213"/>
                <a:gd name="T34" fmla="*/ 168 w 339"/>
                <a:gd name="T35" fmla="*/ 95 h 213"/>
                <a:gd name="T36" fmla="*/ 204 w 339"/>
                <a:gd name="T37" fmla="*/ 77 h 213"/>
                <a:gd name="T38" fmla="*/ 241 w 339"/>
                <a:gd name="T39" fmla="*/ 61 h 213"/>
                <a:gd name="T40" fmla="*/ 281 w 339"/>
                <a:gd name="T41" fmla="*/ 50 h 213"/>
                <a:gd name="T42" fmla="*/ 322 w 339"/>
                <a:gd name="T43" fmla="*/ 41 h 213"/>
                <a:gd name="T44" fmla="*/ 339 w 339"/>
                <a:gd name="T45" fmla="*/ 38 h 213"/>
                <a:gd name="T46" fmla="*/ 334 w 339"/>
                <a:gd name="T47" fmla="*/ 0 h 2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339" h="213">
                  <a:moveTo>
                    <a:pt x="334" y="0"/>
                  </a:moveTo>
                  <a:lnTo>
                    <a:pt x="290" y="7"/>
                  </a:lnTo>
                  <a:lnTo>
                    <a:pt x="247" y="18"/>
                  </a:lnTo>
                  <a:lnTo>
                    <a:pt x="205" y="33"/>
                  </a:lnTo>
                  <a:lnTo>
                    <a:pt x="164" y="52"/>
                  </a:lnTo>
                  <a:lnTo>
                    <a:pt x="126" y="75"/>
                  </a:lnTo>
                  <a:lnTo>
                    <a:pt x="89" y="100"/>
                  </a:lnTo>
                  <a:lnTo>
                    <a:pt x="55" y="129"/>
                  </a:lnTo>
                  <a:lnTo>
                    <a:pt x="24" y="161"/>
                  </a:lnTo>
                  <a:lnTo>
                    <a:pt x="11" y="176"/>
                  </a:lnTo>
                  <a:lnTo>
                    <a:pt x="0" y="165"/>
                  </a:lnTo>
                  <a:lnTo>
                    <a:pt x="8" y="213"/>
                  </a:lnTo>
                  <a:lnTo>
                    <a:pt x="54" y="211"/>
                  </a:lnTo>
                  <a:lnTo>
                    <a:pt x="42" y="200"/>
                  </a:lnTo>
                  <a:lnTo>
                    <a:pt x="69" y="170"/>
                  </a:lnTo>
                  <a:lnTo>
                    <a:pt x="100" y="143"/>
                  </a:lnTo>
                  <a:lnTo>
                    <a:pt x="133" y="118"/>
                  </a:lnTo>
                  <a:lnTo>
                    <a:pt x="168" y="95"/>
                  </a:lnTo>
                  <a:lnTo>
                    <a:pt x="204" y="77"/>
                  </a:lnTo>
                  <a:lnTo>
                    <a:pt x="241" y="61"/>
                  </a:lnTo>
                  <a:lnTo>
                    <a:pt x="281" y="50"/>
                  </a:lnTo>
                  <a:lnTo>
                    <a:pt x="322" y="41"/>
                  </a:lnTo>
                  <a:lnTo>
                    <a:pt x="339" y="38"/>
                  </a:lnTo>
                  <a:lnTo>
                    <a:pt x="334" y="0"/>
                  </a:lnTo>
                  <a:close/>
                </a:path>
              </a:pathLst>
            </a:custGeom>
            <a:solidFill>
              <a:srgbClr val="FF66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Arc 20"/>
            <p:cNvSpPr>
              <a:spLocks/>
            </p:cNvSpPr>
            <p:nvPr/>
          </p:nvSpPr>
          <p:spPr bwMode="auto">
            <a:xfrm>
              <a:off x="1339850" y="2555875"/>
              <a:ext cx="606425" cy="782638"/>
            </a:xfrm>
            <a:custGeom>
              <a:avLst/>
              <a:gdLst>
                <a:gd name="G0" fmla="+- 16654 0 0"/>
                <a:gd name="G1" fmla="+- 21451 0 0"/>
                <a:gd name="G2" fmla="+- 21600 0 0"/>
                <a:gd name="T0" fmla="*/ 0 w 16654"/>
                <a:gd name="T1" fmla="*/ 7696 h 21451"/>
                <a:gd name="T2" fmla="*/ 14118 w 16654"/>
                <a:gd name="T3" fmla="*/ 0 h 21451"/>
                <a:gd name="T4" fmla="*/ 16654 w 16654"/>
                <a:gd name="T5" fmla="*/ 21451 h 214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654" h="21451" fill="none" extrusionOk="0">
                  <a:moveTo>
                    <a:pt x="-1" y="7695"/>
                  </a:moveTo>
                  <a:cubicBezTo>
                    <a:pt x="3540" y="3409"/>
                    <a:pt x="8597" y="653"/>
                    <a:pt x="14118" y="0"/>
                  </a:cubicBezTo>
                </a:path>
                <a:path w="16654" h="21451" stroke="0" extrusionOk="0">
                  <a:moveTo>
                    <a:pt x="-1" y="7695"/>
                  </a:moveTo>
                  <a:cubicBezTo>
                    <a:pt x="3540" y="3409"/>
                    <a:pt x="8597" y="653"/>
                    <a:pt x="14118" y="0"/>
                  </a:cubicBezTo>
                  <a:lnTo>
                    <a:pt x="16654" y="2145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" name="Arc 21"/>
            <p:cNvSpPr>
              <a:spLocks/>
            </p:cNvSpPr>
            <p:nvPr/>
          </p:nvSpPr>
          <p:spPr bwMode="auto">
            <a:xfrm>
              <a:off x="1389063" y="2619375"/>
              <a:ext cx="557212" cy="719138"/>
            </a:xfrm>
            <a:custGeom>
              <a:avLst/>
              <a:gdLst>
                <a:gd name="G0" fmla="+- 16602 0 0"/>
                <a:gd name="G1" fmla="+- 21454 0 0"/>
                <a:gd name="G2" fmla="+- 21600 0 0"/>
                <a:gd name="T0" fmla="*/ 0 w 16602"/>
                <a:gd name="T1" fmla="*/ 7636 h 21454"/>
                <a:gd name="T2" fmla="*/ 14095 w 16602"/>
                <a:gd name="T3" fmla="*/ 0 h 21454"/>
                <a:gd name="T4" fmla="*/ 16602 w 16602"/>
                <a:gd name="T5" fmla="*/ 21454 h 214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602" h="21454" fill="none" extrusionOk="0">
                  <a:moveTo>
                    <a:pt x="0" y="7636"/>
                  </a:moveTo>
                  <a:cubicBezTo>
                    <a:pt x="3544" y="3376"/>
                    <a:pt x="8591" y="643"/>
                    <a:pt x="14094" y="-1"/>
                  </a:cubicBezTo>
                </a:path>
                <a:path w="16602" h="21454" stroke="0" extrusionOk="0">
                  <a:moveTo>
                    <a:pt x="0" y="7636"/>
                  </a:moveTo>
                  <a:cubicBezTo>
                    <a:pt x="3544" y="3376"/>
                    <a:pt x="8591" y="643"/>
                    <a:pt x="14094" y="-1"/>
                  </a:cubicBezTo>
                  <a:lnTo>
                    <a:pt x="16602" y="21454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Line 22"/>
            <p:cNvSpPr>
              <a:spLocks noChangeShapeType="1"/>
            </p:cNvSpPr>
            <p:nvPr/>
          </p:nvSpPr>
          <p:spPr bwMode="auto">
            <a:xfrm flipH="1" flipV="1">
              <a:off x="1854200" y="2559050"/>
              <a:ext cx="7937" cy="603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" name="Freeform 23"/>
            <p:cNvSpPr>
              <a:spLocks/>
            </p:cNvSpPr>
            <p:nvPr/>
          </p:nvSpPr>
          <p:spPr bwMode="auto">
            <a:xfrm>
              <a:off x="1323975" y="2820988"/>
              <a:ext cx="85725" cy="76200"/>
            </a:xfrm>
            <a:custGeom>
              <a:avLst/>
              <a:gdLst>
                <a:gd name="T0" fmla="*/ 37 w 48"/>
                <a:gd name="T1" fmla="*/ 31 h 42"/>
                <a:gd name="T2" fmla="*/ 48 w 48"/>
                <a:gd name="T3" fmla="*/ 40 h 42"/>
                <a:gd name="T4" fmla="*/ 7 w 48"/>
                <a:gd name="T5" fmla="*/ 42 h 42"/>
                <a:gd name="T6" fmla="*/ 0 w 48"/>
                <a:gd name="T7" fmla="*/ 0 h 42"/>
                <a:gd name="T8" fmla="*/ 10 w 48"/>
                <a:gd name="T9" fmla="*/ 9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8" h="42">
                  <a:moveTo>
                    <a:pt x="37" y="31"/>
                  </a:moveTo>
                  <a:lnTo>
                    <a:pt x="48" y="40"/>
                  </a:lnTo>
                  <a:lnTo>
                    <a:pt x="7" y="42"/>
                  </a:lnTo>
                  <a:lnTo>
                    <a:pt x="0" y="0"/>
                  </a:lnTo>
                  <a:lnTo>
                    <a:pt x="10" y="9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Line 24"/>
            <p:cNvSpPr>
              <a:spLocks noChangeShapeType="1"/>
            </p:cNvSpPr>
            <p:nvPr/>
          </p:nvSpPr>
          <p:spPr bwMode="auto">
            <a:xfrm>
              <a:off x="1384300" y="2487613"/>
              <a:ext cx="165100" cy="173038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" name="Rectangle 25"/>
            <p:cNvSpPr>
              <a:spLocks noChangeArrowheads="1"/>
            </p:cNvSpPr>
            <p:nvPr/>
          </p:nvSpPr>
          <p:spPr bwMode="auto">
            <a:xfrm>
              <a:off x="1087438" y="2349500"/>
              <a:ext cx="29014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800000"/>
                  </a:solidFill>
                  <a:effectLst/>
                  <a:latin typeface="Arial" pitchFamily="34" charset="0"/>
                  <a:cs typeface="Arial" pitchFamily="34" charset="0"/>
                </a:rPr>
                <a:t>amp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Freeform 26"/>
            <p:cNvSpPr>
              <a:spLocks/>
            </p:cNvSpPr>
            <p:nvPr/>
          </p:nvSpPr>
          <p:spPr bwMode="auto">
            <a:xfrm>
              <a:off x="2449513" y="3043238"/>
              <a:ext cx="292100" cy="876300"/>
            </a:xfrm>
            <a:custGeom>
              <a:avLst/>
              <a:gdLst>
                <a:gd name="T0" fmla="*/ 0 w 184"/>
                <a:gd name="T1" fmla="*/ 502 h 552"/>
                <a:gd name="T2" fmla="*/ 3 w 184"/>
                <a:gd name="T3" fmla="*/ 548 h 552"/>
                <a:gd name="T4" fmla="*/ 51 w 184"/>
                <a:gd name="T5" fmla="*/ 552 h 552"/>
                <a:gd name="T6" fmla="*/ 40 w 184"/>
                <a:gd name="T7" fmla="*/ 540 h 552"/>
                <a:gd name="T8" fmla="*/ 69 w 184"/>
                <a:gd name="T9" fmla="*/ 507 h 552"/>
                <a:gd name="T10" fmla="*/ 97 w 184"/>
                <a:gd name="T11" fmla="*/ 471 h 552"/>
                <a:gd name="T12" fmla="*/ 120 w 184"/>
                <a:gd name="T13" fmla="*/ 434 h 552"/>
                <a:gd name="T14" fmla="*/ 141 w 184"/>
                <a:gd name="T15" fmla="*/ 394 h 552"/>
                <a:gd name="T16" fmla="*/ 157 w 184"/>
                <a:gd name="T17" fmla="*/ 352 h 552"/>
                <a:gd name="T18" fmla="*/ 169 w 184"/>
                <a:gd name="T19" fmla="*/ 310 h 552"/>
                <a:gd name="T20" fmla="*/ 178 w 184"/>
                <a:gd name="T21" fmla="*/ 266 h 552"/>
                <a:gd name="T22" fmla="*/ 184 w 184"/>
                <a:gd name="T23" fmla="*/ 222 h 552"/>
                <a:gd name="T24" fmla="*/ 184 w 184"/>
                <a:gd name="T25" fmla="*/ 178 h 552"/>
                <a:gd name="T26" fmla="*/ 182 w 184"/>
                <a:gd name="T27" fmla="*/ 132 h 552"/>
                <a:gd name="T28" fmla="*/ 174 w 184"/>
                <a:gd name="T29" fmla="*/ 88 h 552"/>
                <a:gd name="T30" fmla="*/ 164 w 184"/>
                <a:gd name="T31" fmla="*/ 45 h 552"/>
                <a:gd name="T32" fmla="*/ 149 w 184"/>
                <a:gd name="T33" fmla="*/ 3 h 552"/>
                <a:gd name="T34" fmla="*/ 147 w 184"/>
                <a:gd name="T35" fmla="*/ 0 h 552"/>
                <a:gd name="T36" fmla="*/ 110 w 184"/>
                <a:gd name="T37" fmla="*/ 14 h 552"/>
                <a:gd name="T38" fmla="*/ 124 w 184"/>
                <a:gd name="T39" fmla="*/ 53 h 552"/>
                <a:gd name="T40" fmla="*/ 135 w 184"/>
                <a:gd name="T41" fmla="*/ 93 h 552"/>
                <a:gd name="T42" fmla="*/ 142 w 184"/>
                <a:gd name="T43" fmla="*/ 133 h 552"/>
                <a:gd name="T44" fmla="*/ 144 w 184"/>
                <a:gd name="T45" fmla="*/ 174 h 552"/>
                <a:gd name="T46" fmla="*/ 144 w 184"/>
                <a:gd name="T47" fmla="*/ 215 h 552"/>
                <a:gd name="T48" fmla="*/ 140 w 184"/>
                <a:gd name="T49" fmla="*/ 256 h 552"/>
                <a:gd name="T50" fmla="*/ 133 w 184"/>
                <a:gd name="T51" fmla="*/ 297 h 552"/>
                <a:gd name="T52" fmla="*/ 120 w 184"/>
                <a:gd name="T53" fmla="*/ 336 h 552"/>
                <a:gd name="T54" fmla="*/ 106 w 184"/>
                <a:gd name="T55" fmla="*/ 375 h 552"/>
                <a:gd name="T56" fmla="*/ 88 w 184"/>
                <a:gd name="T57" fmla="*/ 411 h 552"/>
                <a:gd name="T58" fmla="*/ 66 w 184"/>
                <a:gd name="T59" fmla="*/ 446 h 552"/>
                <a:gd name="T60" fmla="*/ 42 w 184"/>
                <a:gd name="T61" fmla="*/ 479 h 552"/>
                <a:gd name="T62" fmla="*/ 15 w 184"/>
                <a:gd name="T63" fmla="*/ 510 h 552"/>
                <a:gd name="T64" fmla="*/ 12 w 184"/>
                <a:gd name="T65" fmla="*/ 512 h 552"/>
                <a:gd name="T66" fmla="*/ 0 w 184"/>
                <a:gd name="T67" fmla="*/ 502 h 5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184" h="552">
                  <a:moveTo>
                    <a:pt x="0" y="502"/>
                  </a:moveTo>
                  <a:lnTo>
                    <a:pt x="3" y="548"/>
                  </a:lnTo>
                  <a:lnTo>
                    <a:pt x="51" y="552"/>
                  </a:lnTo>
                  <a:lnTo>
                    <a:pt x="40" y="540"/>
                  </a:lnTo>
                  <a:lnTo>
                    <a:pt x="69" y="507"/>
                  </a:lnTo>
                  <a:lnTo>
                    <a:pt x="97" y="471"/>
                  </a:lnTo>
                  <a:lnTo>
                    <a:pt x="120" y="434"/>
                  </a:lnTo>
                  <a:lnTo>
                    <a:pt x="141" y="394"/>
                  </a:lnTo>
                  <a:lnTo>
                    <a:pt x="157" y="352"/>
                  </a:lnTo>
                  <a:lnTo>
                    <a:pt x="169" y="310"/>
                  </a:lnTo>
                  <a:lnTo>
                    <a:pt x="178" y="266"/>
                  </a:lnTo>
                  <a:lnTo>
                    <a:pt x="184" y="222"/>
                  </a:lnTo>
                  <a:lnTo>
                    <a:pt x="184" y="178"/>
                  </a:lnTo>
                  <a:lnTo>
                    <a:pt x="182" y="132"/>
                  </a:lnTo>
                  <a:lnTo>
                    <a:pt x="174" y="88"/>
                  </a:lnTo>
                  <a:lnTo>
                    <a:pt x="164" y="45"/>
                  </a:lnTo>
                  <a:lnTo>
                    <a:pt x="149" y="3"/>
                  </a:lnTo>
                  <a:lnTo>
                    <a:pt x="147" y="0"/>
                  </a:lnTo>
                  <a:lnTo>
                    <a:pt x="110" y="14"/>
                  </a:lnTo>
                  <a:lnTo>
                    <a:pt x="124" y="53"/>
                  </a:lnTo>
                  <a:lnTo>
                    <a:pt x="135" y="93"/>
                  </a:lnTo>
                  <a:lnTo>
                    <a:pt x="142" y="133"/>
                  </a:lnTo>
                  <a:lnTo>
                    <a:pt x="144" y="174"/>
                  </a:lnTo>
                  <a:lnTo>
                    <a:pt x="144" y="215"/>
                  </a:lnTo>
                  <a:lnTo>
                    <a:pt x="140" y="256"/>
                  </a:lnTo>
                  <a:lnTo>
                    <a:pt x="133" y="297"/>
                  </a:lnTo>
                  <a:lnTo>
                    <a:pt x="120" y="336"/>
                  </a:lnTo>
                  <a:lnTo>
                    <a:pt x="106" y="375"/>
                  </a:lnTo>
                  <a:lnTo>
                    <a:pt x="88" y="411"/>
                  </a:lnTo>
                  <a:lnTo>
                    <a:pt x="66" y="446"/>
                  </a:lnTo>
                  <a:lnTo>
                    <a:pt x="42" y="479"/>
                  </a:lnTo>
                  <a:lnTo>
                    <a:pt x="15" y="510"/>
                  </a:lnTo>
                  <a:lnTo>
                    <a:pt x="12" y="512"/>
                  </a:lnTo>
                  <a:lnTo>
                    <a:pt x="0" y="502"/>
                  </a:lnTo>
                  <a:close/>
                </a:path>
              </a:pathLst>
            </a:custGeom>
            <a:solidFill>
              <a:srgbClr val="FF66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" name="Arc 27"/>
            <p:cNvSpPr>
              <a:spLocks/>
            </p:cNvSpPr>
            <p:nvPr/>
          </p:nvSpPr>
          <p:spPr bwMode="auto">
            <a:xfrm>
              <a:off x="1946275" y="3046413"/>
              <a:ext cx="787400" cy="846138"/>
            </a:xfrm>
            <a:custGeom>
              <a:avLst/>
              <a:gdLst>
                <a:gd name="G0" fmla="+- 0 0 0"/>
                <a:gd name="G1" fmla="+- 8030 0 0"/>
                <a:gd name="G2" fmla="+- 21600 0 0"/>
                <a:gd name="T0" fmla="*/ 20052 w 21600"/>
                <a:gd name="T1" fmla="*/ 0 h 23231"/>
                <a:gd name="T2" fmla="*/ 15345 w 21600"/>
                <a:gd name="T3" fmla="*/ 23231 h 23231"/>
                <a:gd name="T4" fmla="*/ 0 w 21600"/>
                <a:gd name="T5" fmla="*/ 8030 h 23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23231" fill="none" extrusionOk="0">
                  <a:moveTo>
                    <a:pt x="20051" y="0"/>
                  </a:moveTo>
                  <a:cubicBezTo>
                    <a:pt x="21074" y="2553"/>
                    <a:pt x="21600" y="5279"/>
                    <a:pt x="21600" y="8030"/>
                  </a:cubicBezTo>
                  <a:cubicBezTo>
                    <a:pt x="21600" y="13723"/>
                    <a:pt x="19352" y="19186"/>
                    <a:pt x="15345" y="23231"/>
                  </a:cubicBezTo>
                </a:path>
                <a:path w="21600" h="23231" stroke="0" extrusionOk="0">
                  <a:moveTo>
                    <a:pt x="20051" y="0"/>
                  </a:moveTo>
                  <a:cubicBezTo>
                    <a:pt x="21074" y="2553"/>
                    <a:pt x="21600" y="5279"/>
                    <a:pt x="21600" y="8030"/>
                  </a:cubicBezTo>
                  <a:cubicBezTo>
                    <a:pt x="21600" y="13723"/>
                    <a:pt x="19352" y="19186"/>
                    <a:pt x="15345" y="23231"/>
                  </a:cubicBezTo>
                  <a:lnTo>
                    <a:pt x="0" y="803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" name="Arc 28"/>
            <p:cNvSpPr>
              <a:spLocks/>
            </p:cNvSpPr>
            <p:nvPr/>
          </p:nvSpPr>
          <p:spPr bwMode="auto">
            <a:xfrm>
              <a:off x="1946275" y="3067050"/>
              <a:ext cx="725487" cy="781050"/>
            </a:xfrm>
            <a:custGeom>
              <a:avLst/>
              <a:gdLst>
                <a:gd name="G0" fmla="+- 0 0 0"/>
                <a:gd name="G1" fmla="+- 8078 0 0"/>
                <a:gd name="G2" fmla="+- 21600 0 0"/>
                <a:gd name="T0" fmla="*/ 20033 w 21600"/>
                <a:gd name="T1" fmla="*/ 0 h 23290"/>
                <a:gd name="T2" fmla="*/ 15335 w 21600"/>
                <a:gd name="T3" fmla="*/ 23290 h 23290"/>
                <a:gd name="T4" fmla="*/ 0 w 21600"/>
                <a:gd name="T5" fmla="*/ 8078 h 23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23290" fill="none" extrusionOk="0">
                  <a:moveTo>
                    <a:pt x="20032" y="0"/>
                  </a:moveTo>
                  <a:cubicBezTo>
                    <a:pt x="21067" y="2567"/>
                    <a:pt x="21600" y="5309"/>
                    <a:pt x="21600" y="8078"/>
                  </a:cubicBezTo>
                  <a:cubicBezTo>
                    <a:pt x="21600" y="13776"/>
                    <a:pt x="19348" y="19244"/>
                    <a:pt x="15334" y="23289"/>
                  </a:cubicBezTo>
                </a:path>
                <a:path w="21600" h="23290" stroke="0" extrusionOk="0">
                  <a:moveTo>
                    <a:pt x="20032" y="0"/>
                  </a:moveTo>
                  <a:cubicBezTo>
                    <a:pt x="21067" y="2567"/>
                    <a:pt x="21600" y="5309"/>
                    <a:pt x="21600" y="8078"/>
                  </a:cubicBezTo>
                  <a:cubicBezTo>
                    <a:pt x="21600" y="13776"/>
                    <a:pt x="19348" y="19244"/>
                    <a:pt x="15334" y="23289"/>
                  </a:cubicBezTo>
                  <a:lnTo>
                    <a:pt x="0" y="8078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0" name="Line 29"/>
            <p:cNvSpPr>
              <a:spLocks noChangeShapeType="1"/>
            </p:cNvSpPr>
            <p:nvPr/>
          </p:nvSpPr>
          <p:spPr bwMode="auto">
            <a:xfrm flipV="1">
              <a:off x="2624138" y="3043238"/>
              <a:ext cx="58737" cy="222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1" name="Freeform 30"/>
            <p:cNvSpPr>
              <a:spLocks/>
            </p:cNvSpPr>
            <p:nvPr/>
          </p:nvSpPr>
          <p:spPr bwMode="auto">
            <a:xfrm>
              <a:off x="2449513" y="3840163"/>
              <a:ext cx="80962" cy="79375"/>
            </a:xfrm>
            <a:custGeom>
              <a:avLst/>
              <a:gdLst>
                <a:gd name="T0" fmla="*/ 10 w 45"/>
                <a:gd name="T1" fmla="*/ 9 h 44"/>
                <a:gd name="T2" fmla="*/ 0 w 45"/>
                <a:gd name="T3" fmla="*/ 0 h 44"/>
                <a:gd name="T4" fmla="*/ 2 w 45"/>
                <a:gd name="T5" fmla="*/ 41 h 44"/>
                <a:gd name="T6" fmla="*/ 45 w 45"/>
                <a:gd name="T7" fmla="*/ 44 h 44"/>
                <a:gd name="T8" fmla="*/ 35 w 45"/>
                <a:gd name="T9" fmla="*/ 3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4">
                  <a:moveTo>
                    <a:pt x="10" y="9"/>
                  </a:moveTo>
                  <a:lnTo>
                    <a:pt x="0" y="0"/>
                  </a:lnTo>
                  <a:lnTo>
                    <a:pt x="2" y="41"/>
                  </a:lnTo>
                  <a:lnTo>
                    <a:pt x="45" y="44"/>
                  </a:lnTo>
                  <a:lnTo>
                    <a:pt x="35" y="34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3" name="Line 31"/>
            <p:cNvSpPr>
              <a:spLocks noChangeShapeType="1"/>
            </p:cNvSpPr>
            <p:nvPr/>
          </p:nvSpPr>
          <p:spPr bwMode="auto">
            <a:xfrm flipH="1" flipV="1">
              <a:off x="2720975" y="3522663"/>
              <a:ext cx="234950" cy="15875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4" name="Rectangle 32"/>
            <p:cNvSpPr>
              <a:spLocks noChangeArrowheads="1"/>
            </p:cNvSpPr>
            <p:nvPr/>
          </p:nvSpPr>
          <p:spPr bwMode="auto">
            <a:xfrm>
              <a:off x="2960688" y="3541713"/>
              <a:ext cx="35426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err="1" smtClean="0">
                  <a:ln>
                    <a:noFill/>
                  </a:ln>
                  <a:solidFill>
                    <a:srgbClr val="800000"/>
                  </a:solidFill>
                  <a:effectLst/>
                  <a:latin typeface="Arial" pitchFamily="34" charset="0"/>
                  <a:cs typeface="Arial" pitchFamily="34" charset="0"/>
                </a:rPr>
                <a:t>FLPo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34" name="Line 42"/>
            <p:cNvSpPr>
              <a:spLocks noChangeShapeType="1"/>
            </p:cNvSpPr>
            <p:nvPr/>
          </p:nvSpPr>
          <p:spPr bwMode="auto">
            <a:xfrm flipH="1">
              <a:off x="2598738" y="3035300"/>
              <a:ext cx="112712" cy="46038"/>
            </a:xfrm>
            <a:prstGeom prst="line">
              <a:avLst/>
            </a:prstGeom>
            <a:noFill/>
            <a:ln w="14288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7" name="Line 45"/>
            <p:cNvSpPr>
              <a:spLocks noChangeShapeType="1"/>
            </p:cNvSpPr>
            <p:nvPr/>
          </p:nvSpPr>
          <p:spPr bwMode="auto">
            <a:xfrm flipH="1">
              <a:off x="2601913" y="3041650"/>
              <a:ext cx="111125" cy="42863"/>
            </a:xfrm>
            <a:prstGeom prst="line">
              <a:avLst/>
            </a:prstGeom>
            <a:noFill/>
            <a:ln w="14288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8" name="Line 46"/>
            <p:cNvSpPr>
              <a:spLocks noChangeShapeType="1"/>
            </p:cNvSpPr>
            <p:nvPr/>
          </p:nvSpPr>
          <p:spPr bwMode="auto">
            <a:xfrm flipH="1" flipV="1">
              <a:off x="2713038" y="3041650"/>
              <a:ext cx="257175" cy="114300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9" name="Rectangle 47"/>
            <p:cNvSpPr>
              <a:spLocks noChangeArrowheads="1"/>
            </p:cNvSpPr>
            <p:nvPr/>
          </p:nvSpPr>
          <p:spPr bwMode="auto">
            <a:xfrm>
              <a:off x="2974975" y="3149600"/>
              <a:ext cx="23083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Arial" pitchFamily="34" charset="0"/>
                  <a:cs typeface="Arial" pitchFamily="34" charset="0"/>
                </a:rPr>
                <a:t>NLS</a:t>
              </a:r>
              <a:endParaRPr kumimoji="0" lang="en-US" alt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40" name="Line 48"/>
            <p:cNvSpPr>
              <a:spLocks noChangeShapeType="1"/>
            </p:cNvSpPr>
            <p:nvPr/>
          </p:nvSpPr>
          <p:spPr bwMode="auto">
            <a:xfrm flipH="1" flipV="1">
              <a:off x="2401888" y="3881438"/>
              <a:ext cx="74612" cy="88900"/>
            </a:xfrm>
            <a:prstGeom prst="line">
              <a:avLst/>
            </a:prstGeom>
            <a:noFill/>
            <a:ln w="14288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3" name="Freeform 61"/>
            <p:cNvSpPr>
              <a:spLocks/>
            </p:cNvSpPr>
            <p:nvPr/>
          </p:nvSpPr>
          <p:spPr bwMode="auto">
            <a:xfrm>
              <a:off x="1849438" y="3921125"/>
              <a:ext cx="165100" cy="111125"/>
            </a:xfrm>
            <a:custGeom>
              <a:avLst/>
              <a:gdLst>
                <a:gd name="T0" fmla="*/ 34 w 104"/>
                <a:gd name="T1" fmla="*/ 0 h 70"/>
                <a:gd name="T2" fmla="*/ 0 w 104"/>
                <a:gd name="T3" fmla="*/ 31 h 70"/>
                <a:gd name="T4" fmla="*/ 28 w 104"/>
                <a:gd name="T5" fmla="*/ 70 h 70"/>
                <a:gd name="T6" fmla="*/ 29 w 104"/>
                <a:gd name="T7" fmla="*/ 54 h 70"/>
                <a:gd name="T8" fmla="*/ 70 w 104"/>
                <a:gd name="T9" fmla="*/ 56 h 70"/>
                <a:gd name="T10" fmla="*/ 104 w 104"/>
                <a:gd name="T11" fmla="*/ 54 h 70"/>
                <a:gd name="T12" fmla="*/ 101 w 104"/>
                <a:gd name="T13" fmla="*/ 14 h 70"/>
                <a:gd name="T14" fmla="*/ 63 w 104"/>
                <a:gd name="T15" fmla="*/ 17 h 70"/>
                <a:gd name="T16" fmla="*/ 33 w 104"/>
                <a:gd name="T17" fmla="*/ 16 h 70"/>
                <a:gd name="T18" fmla="*/ 34 w 104"/>
                <a:gd name="T19" fmla="*/ 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04" h="70">
                  <a:moveTo>
                    <a:pt x="34" y="0"/>
                  </a:moveTo>
                  <a:lnTo>
                    <a:pt x="0" y="31"/>
                  </a:lnTo>
                  <a:lnTo>
                    <a:pt x="28" y="70"/>
                  </a:lnTo>
                  <a:lnTo>
                    <a:pt x="29" y="54"/>
                  </a:lnTo>
                  <a:lnTo>
                    <a:pt x="70" y="56"/>
                  </a:lnTo>
                  <a:lnTo>
                    <a:pt x="104" y="54"/>
                  </a:lnTo>
                  <a:lnTo>
                    <a:pt x="101" y="14"/>
                  </a:lnTo>
                  <a:lnTo>
                    <a:pt x="63" y="17"/>
                  </a:lnTo>
                  <a:lnTo>
                    <a:pt x="33" y="16"/>
                  </a:lnTo>
                  <a:lnTo>
                    <a:pt x="34" y="0"/>
                  </a:lnTo>
                  <a:close/>
                </a:path>
              </a:pathLst>
            </a:custGeom>
            <a:pattFill prst="openDmnd">
              <a:fgClr>
                <a:srgbClr val="000080"/>
              </a:fgClr>
              <a:bgClr>
                <a:srgbClr val="FFFFFF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4" name="Arc 62"/>
            <p:cNvSpPr>
              <a:spLocks/>
            </p:cNvSpPr>
            <p:nvPr/>
          </p:nvSpPr>
          <p:spPr bwMode="auto">
            <a:xfrm>
              <a:off x="1895475" y="3340100"/>
              <a:ext cx="117475" cy="661988"/>
            </a:xfrm>
            <a:custGeom>
              <a:avLst/>
              <a:gdLst>
                <a:gd name="G0" fmla="+- 1641 0 0"/>
                <a:gd name="G1" fmla="+- 0 0 0"/>
                <a:gd name="G2" fmla="+- 21600 0 0"/>
                <a:gd name="T0" fmla="*/ 3841 w 3841"/>
                <a:gd name="T1" fmla="*/ 21488 h 21600"/>
                <a:gd name="T2" fmla="*/ 0 w 3841"/>
                <a:gd name="T3" fmla="*/ 21538 h 21600"/>
                <a:gd name="T4" fmla="*/ 1641 w 3841"/>
                <a:gd name="T5" fmla="*/ 0 h 21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41" h="21600" fill="none" extrusionOk="0">
                  <a:moveTo>
                    <a:pt x="3840" y="21487"/>
                  </a:moveTo>
                  <a:cubicBezTo>
                    <a:pt x="3110" y="21562"/>
                    <a:pt x="2375" y="21599"/>
                    <a:pt x="1641" y="21600"/>
                  </a:cubicBezTo>
                  <a:cubicBezTo>
                    <a:pt x="1093" y="21600"/>
                    <a:pt x="546" y="21579"/>
                    <a:pt x="0" y="21537"/>
                  </a:cubicBezTo>
                </a:path>
                <a:path w="3841" h="21600" stroke="0" extrusionOk="0">
                  <a:moveTo>
                    <a:pt x="3840" y="21487"/>
                  </a:moveTo>
                  <a:cubicBezTo>
                    <a:pt x="3110" y="21562"/>
                    <a:pt x="2375" y="21599"/>
                    <a:pt x="1641" y="21600"/>
                  </a:cubicBezTo>
                  <a:cubicBezTo>
                    <a:pt x="1093" y="21600"/>
                    <a:pt x="546" y="21579"/>
                    <a:pt x="0" y="21537"/>
                  </a:cubicBezTo>
                  <a:lnTo>
                    <a:pt x="1641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5" name="Arc 63"/>
            <p:cNvSpPr>
              <a:spLocks/>
            </p:cNvSpPr>
            <p:nvPr/>
          </p:nvSpPr>
          <p:spPr bwMode="auto">
            <a:xfrm>
              <a:off x="1901825" y="3340100"/>
              <a:ext cx="106362" cy="600075"/>
            </a:xfrm>
            <a:custGeom>
              <a:avLst/>
              <a:gdLst>
                <a:gd name="G0" fmla="+- 1581 0 0"/>
                <a:gd name="G1" fmla="+- 0 0 0"/>
                <a:gd name="G2" fmla="+- 21600 0 0"/>
                <a:gd name="T0" fmla="*/ 3845 w 3845"/>
                <a:gd name="T1" fmla="*/ 21481 h 21600"/>
                <a:gd name="T2" fmla="*/ 0 w 3845"/>
                <a:gd name="T3" fmla="*/ 21542 h 21600"/>
                <a:gd name="T4" fmla="*/ 1581 w 3845"/>
                <a:gd name="T5" fmla="*/ 0 h 21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45" h="21600" fill="none" extrusionOk="0">
                  <a:moveTo>
                    <a:pt x="3845" y="21481"/>
                  </a:moveTo>
                  <a:cubicBezTo>
                    <a:pt x="3092" y="21560"/>
                    <a:pt x="2337" y="21599"/>
                    <a:pt x="1581" y="21600"/>
                  </a:cubicBezTo>
                  <a:cubicBezTo>
                    <a:pt x="1053" y="21600"/>
                    <a:pt x="526" y="21580"/>
                    <a:pt x="-1" y="21542"/>
                  </a:cubicBezTo>
                </a:path>
                <a:path w="3845" h="21600" stroke="0" extrusionOk="0">
                  <a:moveTo>
                    <a:pt x="3845" y="21481"/>
                  </a:moveTo>
                  <a:cubicBezTo>
                    <a:pt x="3092" y="21560"/>
                    <a:pt x="2337" y="21599"/>
                    <a:pt x="1581" y="21600"/>
                  </a:cubicBezTo>
                  <a:cubicBezTo>
                    <a:pt x="1053" y="21600"/>
                    <a:pt x="526" y="21580"/>
                    <a:pt x="-1" y="21542"/>
                  </a:cubicBezTo>
                  <a:lnTo>
                    <a:pt x="1581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6" name="Line 64"/>
            <p:cNvSpPr>
              <a:spLocks noChangeShapeType="1"/>
            </p:cNvSpPr>
            <p:nvPr/>
          </p:nvSpPr>
          <p:spPr bwMode="auto">
            <a:xfrm>
              <a:off x="2009775" y="3943350"/>
              <a:ext cx="4762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7" name="Freeform 65"/>
            <p:cNvSpPr>
              <a:spLocks/>
            </p:cNvSpPr>
            <p:nvPr/>
          </p:nvSpPr>
          <p:spPr bwMode="auto">
            <a:xfrm>
              <a:off x="1849438" y="3921125"/>
              <a:ext cx="53975" cy="111125"/>
            </a:xfrm>
            <a:custGeom>
              <a:avLst/>
              <a:gdLst>
                <a:gd name="T0" fmla="*/ 29 w 30"/>
                <a:gd name="T1" fmla="*/ 14 h 62"/>
                <a:gd name="T2" fmla="*/ 30 w 30"/>
                <a:gd name="T3" fmla="*/ 0 h 62"/>
                <a:gd name="T4" fmla="*/ 0 w 30"/>
                <a:gd name="T5" fmla="*/ 28 h 62"/>
                <a:gd name="T6" fmla="*/ 25 w 30"/>
                <a:gd name="T7" fmla="*/ 62 h 62"/>
                <a:gd name="T8" fmla="*/ 26 w 30"/>
                <a:gd name="T9" fmla="*/ 48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62">
                  <a:moveTo>
                    <a:pt x="29" y="14"/>
                  </a:moveTo>
                  <a:lnTo>
                    <a:pt x="30" y="0"/>
                  </a:lnTo>
                  <a:lnTo>
                    <a:pt x="0" y="28"/>
                  </a:lnTo>
                  <a:lnTo>
                    <a:pt x="25" y="62"/>
                  </a:lnTo>
                  <a:lnTo>
                    <a:pt x="26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8" name="Line 66"/>
            <p:cNvSpPr>
              <a:spLocks noChangeShapeType="1"/>
            </p:cNvSpPr>
            <p:nvPr/>
          </p:nvSpPr>
          <p:spPr bwMode="auto">
            <a:xfrm flipV="1">
              <a:off x="1863725" y="4010025"/>
              <a:ext cx="65087" cy="469900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9" name="Rectangle 67"/>
            <p:cNvSpPr>
              <a:spLocks noChangeArrowheads="1"/>
            </p:cNvSpPr>
            <p:nvPr/>
          </p:nvSpPr>
          <p:spPr bwMode="auto">
            <a:xfrm>
              <a:off x="1649413" y="4475163"/>
              <a:ext cx="23724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b="1" dirty="0" smtClean="0">
                  <a:solidFill>
                    <a:srgbClr val="008000"/>
                  </a:solidFill>
                </a:rPr>
                <a:t>RSV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60" name="Freeform 68"/>
            <p:cNvSpPr>
              <a:spLocks/>
            </p:cNvSpPr>
            <p:nvPr/>
          </p:nvSpPr>
          <p:spPr bwMode="auto">
            <a:xfrm>
              <a:off x="2332038" y="2827338"/>
              <a:ext cx="233362" cy="271463"/>
            </a:xfrm>
            <a:custGeom>
              <a:avLst/>
              <a:gdLst>
                <a:gd name="T0" fmla="*/ 83 w 147"/>
                <a:gd name="T1" fmla="*/ 158 h 171"/>
                <a:gd name="T2" fmla="*/ 129 w 147"/>
                <a:gd name="T3" fmla="*/ 171 h 171"/>
                <a:gd name="T4" fmla="*/ 147 w 147"/>
                <a:gd name="T5" fmla="*/ 126 h 171"/>
                <a:gd name="T6" fmla="*/ 133 w 147"/>
                <a:gd name="T7" fmla="*/ 133 h 171"/>
                <a:gd name="T8" fmla="*/ 113 w 147"/>
                <a:gd name="T9" fmla="*/ 97 h 171"/>
                <a:gd name="T10" fmla="*/ 88 w 147"/>
                <a:gd name="T11" fmla="*/ 64 h 171"/>
                <a:gd name="T12" fmla="*/ 61 w 147"/>
                <a:gd name="T13" fmla="*/ 34 h 171"/>
                <a:gd name="T14" fmla="*/ 31 w 147"/>
                <a:gd name="T15" fmla="*/ 5 h 171"/>
                <a:gd name="T16" fmla="*/ 24 w 147"/>
                <a:gd name="T17" fmla="*/ 0 h 171"/>
                <a:gd name="T18" fmla="*/ 0 w 147"/>
                <a:gd name="T19" fmla="*/ 30 h 171"/>
                <a:gd name="T20" fmla="*/ 28 w 147"/>
                <a:gd name="T21" fmla="*/ 55 h 171"/>
                <a:gd name="T22" fmla="*/ 53 w 147"/>
                <a:gd name="T23" fmla="*/ 82 h 171"/>
                <a:gd name="T24" fmla="*/ 74 w 147"/>
                <a:gd name="T25" fmla="*/ 112 h 171"/>
                <a:gd name="T26" fmla="*/ 94 w 147"/>
                <a:gd name="T27" fmla="*/ 144 h 171"/>
                <a:gd name="T28" fmla="*/ 98 w 147"/>
                <a:gd name="T29" fmla="*/ 152 h 171"/>
                <a:gd name="T30" fmla="*/ 83 w 147"/>
                <a:gd name="T31" fmla="*/ 158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47" h="171">
                  <a:moveTo>
                    <a:pt x="83" y="158"/>
                  </a:moveTo>
                  <a:lnTo>
                    <a:pt x="129" y="171"/>
                  </a:lnTo>
                  <a:lnTo>
                    <a:pt x="147" y="126"/>
                  </a:lnTo>
                  <a:lnTo>
                    <a:pt x="133" y="133"/>
                  </a:lnTo>
                  <a:lnTo>
                    <a:pt x="113" y="97"/>
                  </a:lnTo>
                  <a:lnTo>
                    <a:pt x="88" y="64"/>
                  </a:lnTo>
                  <a:lnTo>
                    <a:pt x="61" y="34"/>
                  </a:lnTo>
                  <a:lnTo>
                    <a:pt x="31" y="5"/>
                  </a:lnTo>
                  <a:lnTo>
                    <a:pt x="24" y="0"/>
                  </a:lnTo>
                  <a:lnTo>
                    <a:pt x="0" y="30"/>
                  </a:lnTo>
                  <a:lnTo>
                    <a:pt x="28" y="55"/>
                  </a:lnTo>
                  <a:lnTo>
                    <a:pt x="53" y="82"/>
                  </a:lnTo>
                  <a:lnTo>
                    <a:pt x="74" y="112"/>
                  </a:lnTo>
                  <a:lnTo>
                    <a:pt x="94" y="144"/>
                  </a:lnTo>
                  <a:lnTo>
                    <a:pt x="98" y="152"/>
                  </a:lnTo>
                  <a:lnTo>
                    <a:pt x="83" y="158"/>
                  </a:lnTo>
                  <a:close/>
                </a:path>
              </a:pathLst>
            </a:custGeom>
            <a:pattFill prst="openDmnd">
              <a:fgClr>
                <a:srgbClr val="000080"/>
              </a:fgClr>
              <a:bgClr>
                <a:srgbClr val="FFFFFF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1" name="Arc 69"/>
            <p:cNvSpPr>
              <a:spLocks/>
            </p:cNvSpPr>
            <p:nvPr/>
          </p:nvSpPr>
          <p:spPr bwMode="auto">
            <a:xfrm>
              <a:off x="1946275" y="2830513"/>
              <a:ext cx="590550" cy="509588"/>
            </a:xfrm>
            <a:custGeom>
              <a:avLst/>
              <a:gdLst>
                <a:gd name="G0" fmla="+- 0 0 0"/>
                <a:gd name="G1" fmla="+- 16648 0 0"/>
                <a:gd name="G2" fmla="+- 21600 0 0"/>
                <a:gd name="T0" fmla="*/ 13762 w 19278"/>
                <a:gd name="T1" fmla="*/ 0 h 16648"/>
                <a:gd name="T2" fmla="*/ 19278 w 19278"/>
                <a:gd name="T3" fmla="*/ 6906 h 16648"/>
                <a:gd name="T4" fmla="*/ 0 w 19278"/>
                <a:gd name="T5" fmla="*/ 16648 h 166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278" h="16648" fill="none" extrusionOk="0">
                  <a:moveTo>
                    <a:pt x="13762" y="-1"/>
                  </a:moveTo>
                  <a:cubicBezTo>
                    <a:pt x="16057" y="1896"/>
                    <a:pt x="17935" y="4248"/>
                    <a:pt x="19278" y="6905"/>
                  </a:cubicBezTo>
                </a:path>
                <a:path w="19278" h="16648" stroke="0" extrusionOk="0">
                  <a:moveTo>
                    <a:pt x="13762" y="-1"/>
                  </a:moveTo>
                  <a:cubicBezTo>
                    <a:pt x="16057" y="1896"/>
                    <a:pt x="17935" y="4248"/>
                    <a:pt x="19278" y="6905"/>
                  </a:cubicBezTo>
                  <a:lnTo>
                    <a:pt x="0" y="16648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2" name="Arc 70"/>
            <p:cNvSpPr>
              <a:spLocks/>
            </p:cNvSpPr>
            <p:nvPr/>
          </p:nvSpPr>
          <p:spPr bwMode="auto">
            <a:xfrm>
              <a:off x="1946275" y="2879725"/>
              <a:ext cx="534987" cy="460375"/>
            </a:xfrm>
            <a:custGeom>
              <a:avLst/>
              <a:gdLst>
                <a:gd name="G0" fmla="+- 0 0 0"/>
                <a:gd name="G1" fmla="+- 16617 0 0"/>
                <a:gd name="G2" fmla="+- 21600 0 0"/>
                <a:gd name="T0" fmla="*/ 13800 w 19313"/>
                <a:gd name="T1" fmla="*/ 0 h 16617"/>
                <a:gd name="T2" fmla="*/ 19313 w 19313"/>
                <a:gd name="T3" fmla="*/ 6945 h 16617"/>
                <a:gd name="T4" fmla="*/ 0 w 19313"/>
                <a:gd name="T5" fmla="*/ 16617 h 166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313" h="16617" fill="none" extrusionOk="0">
                  <a:moveTo>
                    <a:pt x="13799" y="0"/>
                  </a:moveTo>
                  <a:cubicBezTo>
                    <a:pt x="16098" y="1908"/>
                    <a:pt x="17975" y="4273"/>
                    <a:pt x="19313" y="6944"/>
                  </a:cubicBezTo>
                </a:path>
                <a:path w="19313" h="16617" stroke="0" extrusionOk="0">
                  <a:moveTo>
                    <a:pt x="13799" y="0"/>
                  </a:moveTo>
                  <a:cubicBezTo>
                    <a:pt x="16098" y="1908"/>
                    <a:pt x="17975" y="4273"/>
                    <a:pt x="19313" y="6944"/>
                  </a:cubicBezTo>
                  <a:lnTo>
                    <a:pt x="0" y="1661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3" name="Line 71"/>
            <p:cNvSpPr>
              <a:spLocks noChangeShapeType="1"/>
            </p:cNvSpPr>
            <p:nvPr/>
          </p:nvSpPr>
          <p:spPr bwMode="auto">
            <a:xfrm flipV="1">
              <a:off x="2332038" y="2827338"/>
              <a:ext cx="38100" cy="476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4" name="Freeform 72"/>
            <p:cNvSpPr>
              <a:spLocks/>
            </p:cNvSpPr>
            <p:nvPr/>
          </p:nvSpPr>
          <p:spPr bwMode="auto">
            <a:xfrm>
              <a:off x="2463800" y="3027363"/>
              <a:ext cx="101600" cy="71438"/>
            </a:xfrm>
            <a:custGeom>
              <a:avLst/>
              <a:gdLst>
                <a:gd name="T0" fmla="*/ 13 w 56"/>
                <a:gd name="T1" fmla="*/ 23 h 40"/>
                <a:gd name="T2" fmla="*/ 0 w 56"/>
                <a:gd name="T3" fmla="*/ 29 h 40"/>
                <a:gd name="T4" fmla="*/ 40 w 56"/>
                <a:gd name="T5" fmla="*/ 40 h 40"/>
                <a:gd name="T6" fmla="*/ 56 w 56"/>
                <a:gd name="T7" fmla="*/ 0 h 40"/>
                <a:gd name="T8" fmla="*/ 44 w 56"/>
                <a:gd name="T9" fmla="*/ 7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6" h="40">
                  <a:moveTo>
                    <a:pt x="13" y="23"/>
                  </a:moveTo>
                  <a:lnTo>
                    <a:pt x="0" y="29"/>
                  </a:lnTo>
                  <a:lnTo>
                    <a:pt x="40" y="40"/>
                  </a:lnTo>
                  <a:lnTo>
                    <a:pt x="56" y="0"/>
                  </a:lnTo>
                  <a:lnTo>
                    <a:pt x="44" y="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5" name="Line 73"/>
            <p:cNvSpPr>
              <a:spLocks noChangeShapeType="1"/>
            </p:cNvSpPr>
            <p:nvPr/>
          </p:nvSpPr>
          <p:spPr bwMode="auto">
            <a:xfrm flipH="1">
              <a:off x="2484438" y="2870200"/>
              <a:ext cx="334962" cy="73025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6" name="Rectangle 74"/>
            <p:cNvSpPr>
              <a:spLocks noChangeArrowheads="1"/>
            </p:cNvSpPr>
            <p:nvPr/>
          </p:nvSpPr>
          <p:spPr bwMode="auto">
            <a:xfrm>
              <a:off x="2824163" y="2754313"/>
              <a:ext cx="25006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Arial" pitchFamily="34" charset="0"/>
                  <a:cs typeface="Arial" pitchFamily="34" charset="0"/>
                </a:rPr>
                <a:t>PG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89" name="Freeform 97"/>
            <p:cNvSpPr>
              <a:spLocks/>
            </p:cNvSpPr>
            <p:nvPr/>
          </p:nvSpPr>
          <p:spPr bwMode="auto">
            <a:xfrm>
              <a:off x="1958975" y="2530475"/>
              <a:ext cx="334962" cy="155575"/>
            </a:xfrm>
            <a:custGeom>
              <a:avLst/>
              <a:gdLst>
                <a:gd name="T0" fmla="*/ 211 w 211"/>
                <a:gd name="T1" fmla="*/ 63 h 98"/>
                <a:gd name="T2" fmla="*/ 169 w 211"/>
                <a:gd name="T3" fmla="*/ 45 h 98"/>
                <a:gd name="T4" fmla="*/ 127 w 211"/>
                <a:gd name="T5" fmla="*/ 31 h 98"/>
                <a:gd name="T6" fmla="*/ 84 w 211"/>
                <a:gd name="T7" fmla="*/ 21 h 98"/>
                <a:gd name="T8" fmla="*/ 40 w 211"/>
                <a:gd name="T9" fmla="*/ 16 h 98"/>
                <a:gd name="T10" fmla="*/ 34 w 211"/>
                <a:gd name="T11" fmla="*/ 16 h 98"/>
                <a:gd name="T12" fmla="*/ 35 w 211"/>
                <a:gd name="T13" fmla="*/ 0 h 98"/>
                <a:gd name="T14" fmla="*/ 0 w 211"/>
                <a:gd name="T15" fmla="*/ 34 h 98"/>
                <a:gd name="T16" fmla="*/ 29 w 211"/>
                <a:gd name="T17" fmla="*/ 70 h 98"/>
                <a:gd name="T18" fmla="*/ 31 w 211"/>
                <a:gd name="T19" fmla="*/ 54 h 98"/>
                <a:gd name="T20" fmla="*/ 71 w 211"/>
                <a:gd name="T21" fmla="*/ 60 h 98"/>
                <a:gd name="T22" fmla="*/ 111 w 211"/>
                <a:gd name="T23" fmla="*/ 68 h 98"/>
                <a:gd name="T24" fmla="*/ 151 w 211"/>
                <a:gd name="T25" fmla="*/ 80 h 98"/>
                <a:gd name="T26" fmla="*/ 188 w 211"/>
                <a:gd name="T27" fmla="*/ 96 h 98"/>
                <a:gd name="T28" fmla="*/ 194 w 211"/>
                <a:gd name="T29" fmla="*/ 98 h 98"/>
                <a:gd name="T30" fmla="*/ 211 w 211"/>
                <a:gd name="T31" fmla="*/ 63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11" h="98">
                  <a:moveTo>
                    <a:pt x="211" y="63"/>
                  </a:moveTo>
                  <a:lnTo>
                    <a:pt x="169" y="45"/>
                  </a:lnTo>
                  <a:lnTo>
                    <a:pt x="127" y="31"/>
                  </a:lnTo>
                  <a:lnTo>
                    <a:pt x="84" y="21"/>
                  </a:lnTo>
                  <a:lnTo>
                    <a:pt x="40" y="16"/>
                  </a:lnTo>
                  <a:lnTo>
                    <a:pt x="34" y="16"/>
                  </a:lnTo>
                  <a:lnTo>
                    <a:pt x="35" y="0"/>
                  </a:lnTo>
                  <a:lnTo>
                    <a:pt x="0" y="34"/>
                  </a:lnTo>
                  <a:lnTo>
                    <a:pt x="29" y="70"/>
                  </a:lnTo>
                  <a:lnTo>
                    <a:pt x="31" y="54"/>
                  </a:lnTo>
                  <a:lnTo>
                    <a:pt x="71" y="60"/>
                  </a:lnTo>
                  <a:lnTo>
                    <a:pt x="111" y="68"/>
                  </a:lnTo>
                  <a:lnTo>
                    <a:pt x="151" y="80"/>
                  </a:lnTo>
                  <a:lnTo>
                    <a:pt x="188" y="96"/>
                  </a:lnTo>
                  <a:lnTo>
                    <a:pt x="194" y="98"/>
                  </a:lnTo>
                  <a:lnTo>
                    <a:pt x="211" y="63"/>
                  </a:lnTo>
                  <a:close/>
                </a:path>
              </a:pathLst>
            </a:custGeom>
            <a:solidFill>
              <a:srgbClr val="3399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0" name="Arc 98"/>
            <p:cNvSpPr>
              <a:spLocks/>
            </p:cNvSpPr>
            <p:nvPr/>
          </p:nvSpPr>
          <p:spPr bwMode="auto">
            <a:xfrm>
              <a:off x="1946275" y="2554288"/>
              <a:ext cx="347662" cy="784225"/>
            </a:xfrm>
            <a:custGeom>
              <a:avLst/>
              <a:gdLst>
                <a:gd name="G0" fmla="+- 0 0 0"/>
                <a:gd name="G1" fmla="+- 21522 0 0"/>
                <a:gd name="G2" fmla="+- 21600 0 0"/>
                <a:gd name="T0" fmla="*/ 1835 w 9528"/>
                <a:gd name="T1" fmla="*/ 0 h 21522"/>
                <a:gd name="T2" fmla="*/ 9528 w 9528"/>
                <a:gd name="T3" fmla="*/ 2137 h 21522"/>
                <a:gd name="T4" fmla="*/ 0 w 9528"/>
                <a:gd name="T5" fmla="*/ 21522 h 215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28" h="21522" fill="none" extrusionOk="0">
                  <a:moveTo>
                    <a:pt x="1834" y="0"/>
                  </a:moveTo>
                  <a:cubicBezTo>
                    <a:pt x="4509" y="228"/>
                    <a:pt x="7118" y="952"/>
                    <a:pt x="9527" y="2137"/>
                  </a:cubicBezTo>
                </a:path>
                <a:path w="9528" h="21522" stroke="0" extrusionOk="0">
                  <a:moveTo>
                    <a:pt x="1834" y="0"/>
                  </a:moveTo>
                  <a:cubicBezTo>
                    <a:pt x="4509" y="228"/>
                    <a:pt x="7118" y="952"/>
                    <a:pt x="9527" y="2137"/>
                  </a:cubicBezTo>
                  <a:lnTo>
                    <a:pt x="0" y="21522"/>
                  </a:lnTo>
                  <a:close/>
                </a:path>
              </a:pathLst>
            </a:custGeom>
            <a:noFill/>
            <a:ln w="1111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1" name="Arc 99"/>
            <p:cNvSpPr>
              <a:spLocks/>
            </p:cNvSpPr>
            <p:nvPr/>
          </p:nvSpPr>
          <p:spPr bwMode="auto">
            <a:xfrm>
              <a:off x="1946275" y="2617788"/>
              <a:ext cx="319087" cy="720725"/>
            </a:xfrm>
            <a:custGeom>
              <a:avLst/>
              <a:gdLst>
                <a:gd name="G0" fmla="+- 0 0 0"/>
                <a:gd name="G1" fmla="+- 21521 0 0"/>
                <a:gd name="G2" fmla="+- 21600 0 0"/>
                <a:gd name="T0" fmla="*/ 1843 w 9519"/>
                <a:gd name="T1" fmla="*/ 0 h 21521"/>
                <a:gd name="T2" fmla="*/ 9519 w 9519"/>
                <a:gd name="T3" fmla="*/ 2132 h 21521"/>
                <a:gd name="T4" fmla="*/ 0 w 9519"/>
                <a:gd name="T5" fmla="*/ 21521 h 21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19" h="21521" fill="none" extrusionOk="0">
                  <a:moveTo>
                    <a:pt x="1843" y="-1"/>
                  </a:moveTo>
                  <a:cubicBezTo>
                    <a:pt x="4511" y="228"/>
                    <a:pt x="7114" y="951"/>
                    <a:pt x="9519" y="2131"/>
                  </a:cubicBezTo>
                </a:path>
                <a:path w="9519" h="21521" stroke="0" extrusionOk="0">
                  <a:moveTo>
                    <a:pt x="1843" y="-1"/>
                  </a:moveTo>
                  <a:cubicBezTo>
                    <a:pt x="4511" y="228"/>
                    <a:pt x="7114" y="951"/>
                    <a:pt x="9519" y="2131"/>
                  </a:cubicBezTo>
                  <a:lnTo>
                    <a:pt x="0" y="21521"/>
                  </a:lnTo>
                  <a:close/>
                </a:path>
              </a:pathLst>
            </a:custGeom>
            <a:noFill/>
            <a:ln w="1111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2" name="Line 100"/>
            <p:cNvSpPr>
              <a:spLocks noChangeShapeType="1"/>
            </p:cNvSpPr>
            <p:nvPr/>
          </p:nvSpPr>
          <p:spPr bwMode="auto">
            <a:xfrm flipV="1">
              <a:off x="2266950" y="2630488"/>
              <a:ext cx="26987" cy="55563"/>
            </a:xfrm>
            <a:prstGeom prst="line">
              <a:avLst/>
            </a:prstGeom>
            <a:noFill/>
            <a:ln w="1111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3" name="Freeform 101"/>
            <p:cNvSpPr>
              <a:spLocks/>
            </p:cNvSpPr>
            <p:nvPr/>
          </p:nvSpPr>
          <p:spPr bwMode="auto">
            <a:xfrm>
              <a:off x="1958975" y="2530475"/>
              <a:ext cx="55562" cy="111125"/>
            </a:xfrm>
            <a:custGeom>
              <a:avLst/>
              <a:gdLst>
                <a:gd name="T0" fmla="*/ 27 w 31"/>
                <a:gd name="T1" fmla="*/ 48 h 62"/>
                <a:gd name="T2" fmla="*/ 26 w 31"/>
                <a:gd name="T3" fmla="*/ 62 h 62"/>
                <a:gd name="T4" fmla="*/ 0 w 31"/>
                <a:gd name="T5" fmla="*/ 30 h 62"/>
                <a:gd name="T6" fmla="*/ 31 w 31"/>
                <a:gd name="T7" fmla="*/ 0 h 62"/>
                <a:gd name="T8" fmla="*/ 30 w 31"/>
                <a:gd name="T9" fmla="*/ 14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1" h="62">
                  <a:moveTo>
                    <a:pt x="27" y="48"/>
                  </a:moveTo>
                  <a:lnTo>
                    <a:pt x="26" y="62"/>
                  </a:lnTo>
                  <a:lnTo>
                    <a:pt x="0" y="30"/>
                  </a:lnTo>
                  <a:lnTo>
                    <a:pt x="31" y="0"/>
                  </a:lnTo>
                  <a:lnTo>
                    <a:pt x="30" y="14"/>
                  </a:lnTo>
                </a:path>
              </a:pathLst>
            </a:custGeom>
            <a:noFill/>
            <a:ln w="1111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4" name="Line 102"/>
            <p:cNvSpPr>
              <a:spLocks noChangeShapeType="1"/>
            </p:cNvSpPr>
            <p:nvPr/>
          </p:nvSpPr>
          <p:spPr bwMode="auto">
            <a:xfrm flipH="1">
              <a:off x="2130425" y="2339975"/>
              <a:ext cx="101600" cy="233363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5" name="Rectangle 103"/>
            <p:cNvSpPr>
              <a:spLocks noChangeArrowheads="1"/>
            </p:cNvSpPr>
            <p:nvPr/>
          </p:nvSpPr>
          <p:spPr bwMode="auto">
            <a:xfrm>
              <a:off x="2238375" y="2224088"/>
              <a:ext cx="266700" cy="165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Arial" pitchFamily="34" charset="0"/>
                  <a:cs typeface="Arial" pitchFamily="34" charset="0"/>
                </a:rPr>
                <a:t>f1 ori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96" name="Freeform 104"/>
            <p:cNvSpPr>
              <a:spLocks/>
            </p:cNvSpPr>
            <p:nvPr/>
          </p:nvSpPr>
          <p:spPr bwMode="auto">
            <a:xfrm>
              <a:off x="1150938" y="2943225"/>
              <a:ext cx="171450" cy="601663"/>
            </a:xfrm>
            <a:custGeom>
              <a:avLst/>
              <a:gdLst>
                <a:gd name="T0" fmla="*/ 74 w 108"/>
                <a:gd name="T1" fmla="*/ 0 h 379"/>
                <a:gd name="T2" fmla="*/ 52 w 108"/>
                <a:gd name="T3" fmla="*/ 40 h 379"/>
                <a:gd name="T4" fmla="*/ 35 w 108"/>
                <a:gd name="T5" fmla="*/ 81 h 379"/>
                <a:gd name="T6" fmla="*/ 22 w 108"/>
                <a:gd name="T7" fmla="*/ 124 h 379"/>
                <a:gd name="T8" fmla="*/ 13 w 108"/>
                <a:gd name="T9" fmla="*/ 167 h 379"/>
                <a:gd name="T10" fmla="*/ 7 w 108"/>
                <a:gd name="T11" fmla="*/ 211 h 379"/>
                <a:gd name="T12" fmla="*/ 5 w 108"/>
                <a:gd name="T13" fmla="*/ 255 h 379"/>
                <a:gd name="T14" fmla="*/ 7 w 108"/>
                <a:gd name="T15" fmla="*/ 301 h 379"/>
                <a:gd name="T16" fmla="*/ 14 w 108"/>
                <a:gd name="T17" fmla="*/ 345 h 379"/>
                <a:gd name="T18" fmla="*/ 15 w 108"/>
                <a:gd name="T19" fmla="*/ 352 h 379"/>
                <a:gd name="T20" fmla="*/ 0 w 108"/>
                <a:gd name="T21" fmla="*/ 355 h 379"/>
                <a:gd name="T22" fmla="*/ 42 w 108"/>
                <a:gd name="T23" fmla="*/ 379 h 379"/>
                <a:gd name="T24" fmla="*/ 69 w 108"/>
                <a:gd name="T25" fmla="*/ 341 h 379"/>
                <a:gd name="T26" fmla="*/ 53 w 108"/>
                <a:gd name="T27" fmla="*/ 344 h 379"/>
                <a:gd name="T28" fmla="*/ 48 w 108"/>
                <a:gd name="T29" fmla="*/ 304 h 379"/>
                <a:gd name="T30" fmla="*/ 44 w 108"/>
                <a:gd name="T31" fmla="*/ 262 h 379"/>
                <a:gd name="T32" fmla="*/ 45 w 108"/>
                <a:gd name="T33" fmla="*/ 221 h 379"/>
                <a:gd name="T34" fmla="*/ 50 w 108"/>
                <a:gd name="T35" fmla="*/ 181 h 379"/>
                <a:gd name="T36" fmla="*/ 58 w 108"/>
                <a:gd name="T37" fmla="*/ 141 h 379"/>
                <a:gd name="T38" fmla="*/ 70 w 108"/>
                <a:gd name="T39" fmla="*/ 101 h 379"/>
                <a:gd name="T40" fmla="*/ 85 w 108"/>
                <a:gd name="T41" fmla="*/ 63 h 379"/>
                <a:gd name="T42" fmla="*/ 104 w 108"/>
                <a:gd name="T43" fmla="*/ 26 h 379"/>
                <a:gd name="T44" fmla="*/ 108 w 108"/>
                <a:gd name="T45" fmla="*/ 21 h 379"/>
                <a:gd name="T46" fmla="*/ 74 w 108"/>
                <a:gd name="T47" fmla="*/ 0 h 3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108" h="379">
                  <a:moveTo>
                    <a:pt x="74" y="0"/>
                  </a:moveTo>
                  <a:lnTo>
                    <a:pt x="52" y="40"/>
                  </a:lnTo>
                  <a:lnTo>
                    <a:pt x="35" y="81"/>
                  </a:lnTo>
                  <a:lnTo>
                    <a:pt x="22" y="124"/>
                  </a:lnTo>
                  <a:lnTo>
                    <a:pt x="13" y="167"/>
                  </a:lnTo>
                  <a:lnTo>
                    <a:pt x="7" y="211"/>
                  </a:lnTo>
                  <a:lnTo>
                    <a:pt x="5" y="255"/>
                  </a:lnTo>
                  <a:lnTo>
                    <a:pt x="7" y="301"/>
                  </a:lnTo>
                  <a:lnTo>
                    <a:pt x="14" y="345"/>
                  </a:lnTo>
                  <a:lnTo>
                    <a:pt x="15" y="352"/>
                  </a:lnTo>
                  <a:lnTo>
                    <a:pt x="0" y="355"/>
                  </a:lnTo>
                  <a:lnTo>
                    <a:pt x="42" y="379"/>
                  </a:lnTo>
                  <a:lnTo>
                    <a:pt x="69" y="341"/>
                  </a:lnTo>
                  <a:lnTo>
                    <a:pt x="53" y="344"/>
                  </a:lnTo>
                  <a:lnTo>
                    <a:pt x="48" y="304"/>
                  </a:lnTo>
                  <a:lnTo>
                    <a:pt x="44" y="262"/>
                  </a:lnTo>
                  <a:lnTo>
                    <a:pt x="45" y="221"/>
                  </a:lnTo>
                  <a:lnTo>
                    <a:pt x="50" y="181"/>
                  </a:lnTo>
                  <a:lnTo>
                    <a:pt x="58" y="141"/>
                  </a:lnTo>
                  <a:lnTo>
                    <a:pt x="70" y="101"/>
                  </a:lnTo>
                  <a:lnTo>
                    <a:pt x="85" y="63"/>
                  </a:lnTo>
                  <a:lnTo>
                    <a:pt x="104" y="26"/>
                  </a:lnTo>
                  <a:lnTo>
                    <a:pt x="108" y="21"/>
                  </a:lnTo>
                  <a:lnTo>
                    <a:pt x="74" y="0"/>
                  </a:lnTo>
                  <a:close/>
                </a:path>
              </a:pathLst>
            </a:custGeom>
            <a:solidFill>
              <a:srgbClr val="3399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7" name="Arc 105"/>
            <p:cNvSpPr>
              <a:spLocks/>
            </p:cNvSpPr>
            <p:nvPr/>
          </p:nvSpPr>
          <p:spPr bwMode="auto">
            <a:xfrm>
              <a:off x="1158875" y="2941638"/>
              <a:ext cx="787400" cy="558800"/>
            </a:xfrm>
            <a:custGeom>
              <a:avLst/>
              <a:gdLst>
                <a:gd name="G0" fmla="+- 21600 0 0"/>
                <a:gd name="G1" fmla="+- 10873 0 0"/>
                <a:gd name="G2" fmla="+- 21600 0 0"/>
                <a:gd name="T0" fmla="*/ 468 w 21600"/>
                <a:gd name="T1" fmla="*/ 15347 h 15347"/>
                <a:gd name="T2" fmla="*/ 2936 w 21600"/>
                <a:gd name="T3" fmla="*/ 0 h 15347"/>
                <a:gd name="T4" fmla="*/ 21600 w 21600"/>
                <a:gd name="T5" fmla="*/ 10873 h 15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15347" fill="none" extrusionOk="0">
                  <a:moveTo>
                    <a:pt x="468" y="15346"/>
                  </a:moveTo>
                  <a:cubicBezTo>
                    <a:pt x="156" y="13875"/>
                    <a:pt x="0" y="12376"/>
                    <a:pt x="0" y="10873"/>
                  </a:cubicBezTo>
                  <a:cubicBezTo>
                    <a:pt x="-1" y="7052"/>
                    <a:pt x="1013" y="3300"/>
                    <a:pt x="2936" y="0"/>
                  </a:cubicBezTo>
                </a:path>
                <a:path w="21600" h="15347" stroke="0" extrusionOk="0">
                  <a:moveTo>
                    <a:pt x="468" y="15346"/>
                  </a:moveTo>
                  <a:cubicBezTo>
                    <a:pt x="156" y="13875"/>
                    <a:pt x="0" y="12376"/>
                    <a:pt x="0" y="10873"/>
                  </a:cubicBezTo>
                  <a:cubicBezTo>
                    <a:pt x="-1" y="7052"/>
                    <a:pt x="1013" y="3300"/>
                    <a:pt x="2936" y="0"/>
                  </a:cubicBezTo>
                  <a:lnTo>
                    <a:pt x="21600" y="10873"/>
                  </a:lnTo>
                  <a:close/>
                </a:path>
              </a:pathLst>
            </a:custGeom>
            <a:noFill/>
            <a:ln w="1111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8" name="Arc 106"/>
            <p:cNvSpPr>
              <a:spLocks/>
            </p:cNvSpPr>
            <p:nvPr/>
          </p:nvSpPr>
          <p:spPr bwMode="auto">
            <a:xfrm>
              <a:off x="1220788" y="2974975"/>
              <a:ext cx="725487" cy="514350"/>
            </a:xfrm>
            <a:custGeom>
              <a:avLst/>
              <a:gdLst>
                <a:gd name="G0" fmla="+- 21600 0 0"/>
                <a:gd name="G1" fmla="+- 10848 0 0"/>
                <a:gd name="G2" fmla="+- 21600 0 0"/>
                <a:gd name="T0" fmla="*/ 471 w 21600"/>
                <a:gd name="T1" fmla="*/ 15333 h 15333"/>
                <a:gd name="T2" fmla="*/ 2922 w 21600"/>
                <a:gd name="T3" fmla="*/ 0 h 15333"/>
                <a:gd name="T4" fmla="*/ 21600 w 21600"/>
                <a:gd name="T5" fmla="*/ 10848 h 153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15333" fill="none" extrusionOk="0">
                  <a:moveTo>
                    <a:pt x="470" y="15333"/>
                  </a:moveTo>
                  <a:cubicBezTo>
                    <a:pt x="157" y="13858"/>
                    <a:pt x="0" y="12355"/>
                    <a:pt x="0" y="10848"/>
                  </a:cubicBezTo>
                  <a:cubicBezTo>
                    <a:pt x="-1" y="7037"/>
                    <a:pt x="1008" y="3294"/>
                    <a:pt x="2921" y="-1"/>
                  </a:cubicBezTo>
                </a:path>
                <a:path w="21600" h="15333" stroke="0" extrusionOk="0">
                  <a:moveTo>
                    <a:pt x="470" y="15333"/>
                  </a:moveTo>
                  <a:cubicBezTo>
                    <a:pt x="157" y="13858"/>
                    <a:pt x="0" y="12355"/>
                    <a:pt x="0" y="10848"/>
                  </a:cubicBezTo>
                  <a:cubicBezTo>
                    <a:pt x="-1" y="7037"/>
                    <a:pt x="1008" y="3294"/>
                    <a:pt x="2921" y="-1"/>
                  </a:cubicBezTo>
                  <a:lnTo>
                    <a:pt x="21600" y="10848"/>
                  </a:lnTo>
                  <a:close/>
                </a:path>
              </a:pathLst>
            </a:custGeom>
            <a:noFill/>
            <a:ln w="1111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9" name="Line 107"/>
            <p:cNvSpPr>
              <a:spLocks noChangeShapeType="1"/>
            </p:cNvSpPr>
            <p:nvPr/>
          </p:nvSpPr>
          <p:spPr bwMode="auto">
            <a:xfrm flipH="1" flipV="1">
              <a:off x="1268413" y="2943225"/>
              <a:ext cx="53975" cy="33338"/>
            </a:xfrm>
            <a:prstGeom prst="line">
              <a:avLst/>
            </a:prstGeom>
            <a:noFill/>
            <a:ln w="1111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00" name="Freeform 108"/>
            <p:cNvSpPr>
              <a:spLocks/>
            </p:cNvSpPr>
            <p:nvPr/>
          </p:nvSpPr>
          <p:spPr bwMode="auto">
            <a:xfrm>
              <a:off x="1150938" y="3484563"/>
              <a:ext cx="109537" cy="60325"/>
            </a:xfrm>
            <a:custGeom>
              <a:avLst/>
              <a:gdLst>
                <a:gd name="T0" fmla="*/ 47 w 61"/>
                <a:gd name="T1" fmla="*/ 2 h 33"/>
                <a:gd name="T2" fmla="*/ 61 w 61"/>
                <a:gd name="T3" fmla="*/ 0 h 33"/>
                <a:gd name="T4" fmla="*/ 37 w 61"/>
                <a:gd name="T5" fmla="*/ 33 h 33"/>
                <a:gd name="T6" fmla="*/ 0 w 61"/>
                <a:gd name="T7" fmla="*/ 12 h 33"/>
                <a:gd name="T8" fmla="*/ 13 w 61"/>
                <a:gd name="T9" fmla="*/ 9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1" h="33">
                  <a:moveTo>
                    <a:pt x="47" y="2"/>
                  </a:moveTo>
                  <a:lnTo>
                    <a:pt x="61" y="0"/>
                  </a:lnTo>
                  <a:lnTo>
                    <a:pt x="37" y="33"/>
                  </a:lnTo>
                  <a:lnTo>
                    <a:pt x="0" y="12"/>
                  </a:lnTo>
                  <a:lnTo>
                    <a:pt x="13" y="9"/>
                  </a:lnTo>
                </a:path>
              </a:pathLst>
            </a:custGeom>
            <a:noFill/>
            <a:ln w="1111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01" name="Line 109"/>
            <p:cNvSpPr>
              <a:spLocks noChangeShapeType="1"/>
            </p:cNvSpPr>
            <p:nvPr/>
          </p:nvSpPr>
          <p:spPr bwMode="auto">
            <a:xfrm flipV="1">
              <a:off x="955675" y="3240088"/>
              <a:ext cx="209550" cy="26988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02" name="Rectangle 110"/>
            <p:cNvSpPr>
              <a:spLocks noChangeArrowheads="1"/>
            </p:cNvSpPr>
            <p:nvPr/>
          </p:nvSpPr>
          <p:spPr bwMode="auto">
            <a:xfrm>
              <a:off x="785127" y="3197826"/>
              <a:ext cx="14747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Arial" pitchFamily="34" charset="0"/>
                  <a:cs typeface="Arial" pitchFamily="34" charset="0"/>
                </a:rPr>
                <a:t>ori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03" name="Arc 111"/>
            <p:cNvSpPr>
              <a:spLocks/>
            </p:cNvSpPr>
            <p:nvPr/>
          </p:nvSpPr>
          <p:spPr bwMode="auto">
            <a:xfrm>
              <a:off x="1428750" y="3338513"/>
              <a:ext cx="517525" cy="423863"/>
            </a:xfrm>
            <a:custGeom>
              <a:avLst/>
              <a:gdLst>
                <a:gd name="G0" fmla="+- 17711 0 0"/>
                <a:gd name="G1" fmla="+- 0 0 0"/>
                <a:gd name="G2" fmla="+- 21600 0 0"/>
                <a:gd name="T0" fmla="*/ 1735 w 17711"/>
                <a:gd name="T1" fmla="*/ 14537 h 14537"/>
                <a:gd name="T2" fmla="*/ 0 w 17711"/>
                <a:gd name="T3" fmla="*/ 12365 h 14537"/>
                <a:gd name="T4" fmla="*/ 17711 w 17711"/>
                <a:gd name="T5" fmla="*/ 0 h 145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711" h="14537" fill="none" extrusionOk="0">
                  <a:moveTo>
                    <a:pt x="1734" y="14537"/>
                  </a:moveTo>
                  <a:cubicBezTo>
                    <a:pt x="1110" y="13850"/>
                    <a:pt x="531" y="13125"/>
                    <a:pt x="0" y="12364"/>
                  </a:cubicBezTo>
                </a:path>
                <a:path w="17711" h="14537" stroke="0" extrusionOk="0">
                  <a:moveTo>
                    <a:pt x="1734" y="14537"/>
                  </a:moveTo>
                  <a:cubicBezTo>
                    <a:pt x="1110" y="13850"/>
                    <a:pt x="531" y="13125"/>
                    <a:pt x="0" y="12364"/>
                  </a:cubicBezTo>
                  <a:lnTo>
                    <a:pt x="17711" y="0"/>
                  </a:lnTo>
                  <a:close/>
                </a:path>
              </a:pathLst>
            </a:custGeom>
            <a:noFill/>
            <a:ln w="14288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04" name="Line 112"/>
            <p:cNvSpPr>
              <a:spLocks noChangeShapeType="1"/>
            </p:cNvSpPr>
            <p:nvPr/>
          </p:nvSpPr>
          <p:spPr bwMode="auto">
            <a:xfrm flipV="1">
              <a:off x="1057275" y="3733800"/>
              <a:ext cx="392112" cy="233363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05" name="Rectangle 113"/>
            <p:cNvSpPr>
              <a:spLocks noChangeArrowheads="1"/>
            </p:cNvSpPr>
            <p:nvPr/>
          </p:nvSpPr>
          <p:spPr bwMode="auto">
            <a:xfrm>
              <a:off x="733577" y="4010154"/>
              <a:ext cx="41838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Arial" pitchFamily="34" charset="0"/>
                  <a:cs typeface="Arial" pitchFamily="34" charset="0"/>
                </a:rPr>
                <a:t>SV40 </a:t>
              </a:r>
              <a:r>
                <a:rPr kumimoji="0" lang="en-US" altLang="en-US" sz="800" b="1" i="0" u="none" strike="noStrike" cap="none" normalizeH="0" baseline="0" dirty="0" err="1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Arial" pitchFamily="34" charset="0"/>
                  <a:cs typeface="Arial" pitchFamily="34" charset="0"/>
                </a:rPr>
                <a:t>pA</a:t>
              </a:r>
              <a:endParaRPr kumimoji="0" lang="en-US" altLang="en-US" sz="2400" b="1" i="0" u="none" strike="noStrike" cap="none" normalizeH="0" baseline="0" dirty="0" smtClean="0">
                <a:ln>
                  <a:noFill/>
                </a:ln>
                <a:solidFill>
                  <a:srgbClr val="7030A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06" name="Arc 114"/>
            <p:cNvSpPr>
              <a:spLocks/>
            </p:cNvSpPr>
            <p:nvPr/>
          </p:nvSpPr>
          <p:spPr bwMode="auto">
            <a:xfrm>
              <a:off x="1946275" y="3338513"/>
              <a:ext cx="404812" cy="558800"/>
            </a:xfrm>
            <a:custGeom>
              <a:avLst/>
              <a:gdLst>
                <a:gd name="G0" fmla="+- 0 0 0"/>
                <a:gd name="G1" fmla="+- 0 0 0"/>
                <a:gd name="G2" fmla="+- 21600 0 0"/>
                <a:gd name="T0" fmla="*/ 13870 w 13870"/>
                <a:gd name="T1" fmla="*/ 16558 h 19162"/>
                <a:gd name="T2" fmla="*/ 9969 w 13870"/>
                <a:gd name="T3" fmla="*/ 19162 h 19162"/>
                <a:gd name="T4" fmla="*/ 0 w 13870"/>
                <a:gd name="T5" fmla="*/ 0 h 19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70" h="19162" fill="none" extrusionOk="0">
                  <a:moveTo>
                    <a:pt x="13870" y="16558"/>
                  </a:moveTo>
                  <a:cubicBezTo>
                    <a:pt x="12668" y="17565"/>
                    <a:pt x="11360" y="18438"/>
                    <a:pt x="9968" y="19161"/>
                  </a:cubicBezTo>
                </a:path>
                <a:path w="13870" h="19162" stroke="0" extrusionOk="0">
                  <a:moveTo>
                    <a:pt x="13870" y="16558"/>
                  </a:moveTo>
                  <a:cubicBezTo>
                    <a:pt x="12668" y="17565"/>
                    <a:pt x="11360" y="18438"/>
                    <a:pt x="9968" y="19161"/>
                  </a:cubicBezTo>
                  <a:lnTo>
                    <a:pt x="0" y="0"/>
                  </a:lnTo>
                  <a:close/>
                </a:path>
              </a:pathLst>
            </a:custGeom>
            <a:noFill/>
            <a:ln w="14288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07" name="Line 115"/>
            <p:cNvSpPr>
              <a:spLocks noChangeShapeType="1"/>
            </p:cNvSpPr>
            <p:nvPr/>
          </p:nvSpPr>
          <p:spPr bwMode="auto">
            <a:xfrm flipH="1" flipV="1">
              <a:off x="2301875" y="3871913"/>
              <a:ext cx="390525" cy="228600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08" name="Rectangle 116"/>
            <p:cNvSpPr>
              <a:spLocks noChangeArrowheads="1"/>
            </p:cNvSpPr>
            <p:nvPr/>
          </p:nvSpPr>
          <p:spPr bwMode="auto">
            <a:xfrm>
              <a:off x="2697163" y="4097338"/>
              <a:ext cx="40556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</a:rPr>
                <a:t>BGH</a:t>
              </a:r>
              <a:r>
                <a:rPr kumimoji="0" lang="en-US" altLang="en-US" sz="600" b="1" i="0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</a:rPr>
                <a:t> </a:t>
              </a:r>
              <a:r>
                <a:rPr lang="en-US" altLang="en-US" sz="800" b="1" dirty="0" err="1">
                  <a:solidFill>
                    <a:srgbClr val="7030A0"/>
                  </a:solidFill>
                </a:rPr>
                <a:t>p</a:t>
              </a:r>
              <a:r>
                <a:rPr kumimoji="0" lang="en-US" altLang="en-US" sz="800" b="1" i="0" u="none" strike="noStrike" cap="none" normalizeH="0" baseline="0" dirty="0" err="1" smtClean="0">
                  <a:ln>
                    <a:noFill/>
                  </a:ln>
                  <a:solidFill>
                    <a:srgbClr val="7030A0"/>
                  </a:solidFill>
                  <a:effectLst/>
                </a:rPr>
                <a:t>A</a:t>
              </a:r>
              <a:r>
                <a:rPr kumimoji="0" lang="en-US" altLang="en-US" sz="600" b="1" i="0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</a:rPr>
                <a:t> </a:t>
              </a:r>
              <a:endParaRPr kumimoji="0" lang="en-US" altLang="en-US" sz="1800" b="1" i="0" u="none" strike="noStrike" cap="none" normalizeH="0" baseline="0" dirty="0" smtClean="0">
                <a:ln>
                  <a:noFill/>
                </a:ln>
                <a:solidFill>
                  <a:srgbClr val="7030A0"/>
                </a:solidFill>
                <a:effectLst/>
              </a:endParaRPr>
            </a:p>
          </p:txBody>
        </p:sp>
      </p:grpSp>
      <p:sp>
        <p:nvSpPr>
          <p:cNvPr id="5246" name="TextBox 5245"/>
          <p:cNvSpPr txBox="1"/>
          <p:nvPr/>
        </p:nvSpPr>
        <p:spPr>
          <a:xfrm>
            <a:off x="381000" y="2409825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5247" name="TextBox 5246"/>
          <p:cNvSpPr txBox="1"/>
          <p:nvPr/>
        </p:nvSpPr>
        <p:spPr>
          <a:xfrm>
            <a:off x="381000" y="3790047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</a:t>
            </a:r>
          </a:p>
        </p:txBody>
      </p:sp>
      <p:grpSp>
        <p:nvGrpSpPr>
          <p:cNvPr id="5152" name="Group 5151"/>
          <p:cNvGrpSpPr/>
          <p:nvPr/>
        </p:nvGrpSpPr>
        <p:grpSpPr>
          <a:xfrm>
            <a:off x="4632771" y="4267200"/>
            <a:ext cx="2336106" cy="1712327"/>
            <a:chOff x="4632771" y="2707690"/>
            <a:chExt cx="2336106" cy="1712327"/>
          </a:xfrm>
        </p:grpSpPr>
        <p:sp>
          <p:nvSpPr>
            <p:cNvPr id="5215" name="Rectangle 125"/>
            <p:cNvSpPr>
              <a:spLocks noChangeArrowheads="1"/>
            </p:cNvSpPr>
            <p:nvPr/>
          </p:nvSpPr>
          <p:spPr bwMode="auto">
            <a:xfrm>
              <a:off x="5126913" y="3274448"/>
              <a:ext cx="11798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MA3932 /3933 </a:t>
              </a:r>
              <a:r>
                <a:rPr kumimoji="0" lang="en-US" alt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RNA</a:t>
              </a:r>
              <a:endParaRPr kumimoji="0" lang="en-US" altLang="en-US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  mLig3 ex #1/ #8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6" name="Freeform 159"/>
            <p:cNvSpPr>
              <a:spLocks/>
            </p:cNvSpPr>
            <p:nvPr/>
          </p:nvSpPr>
          <p:spPr bwMode="auto">
            <a:xfrm>
              <a:off x="4901406" y="2752140"/>
              <a:ext cx="1538288" cy="1539875"/>
            </a:xfrm>
            <a:custGeom>
              <a:avLst/>
              <a:gdLst>
                <a:gd name="T0" fmla="*/ 401 w 969"/>
                <a:gd name="T1" fmla="*/ 7 h 970"/>
                <a:gd name="T2" fmla="*/ 278 w 969"/>
                <a:gd name="T3" fmla="*/ 47 h 970"/>
                <a:gd name="T4" fmla="*/ 169 w 969"/>
                <a:gd name="T5" fmla="*/ 117 h 970"/>
                <a:gd name="T6" fmla="*/ 83 w 969"/>
                <a:gd name="T7" fmla="*/ 214 h 970"/>
                <a:gd name="T8" fmla="*/ 26 w 969"/>
                <a:gd name="T9" fmla="*/ 331 h 970"/>
                <a:gd name="T10" fmla="*/ 1 w 969"/>
                <a:gd name="T11" fmla="*/ 458 h 970"/>
                <a:gd name="T12" fmla="*/ 12 w 969"/>
                <a:gd name="T13" fmla="*/ 587 h 970"/>
                <a:gd name="T14" fmla="*/ 55 w 969"/>
                <a:gd name="T15" fmla="*/ 708 h 970"/>
                <a:gd name="T16" fmla="*/ 129 w 969"/>
                <a:gd name="T17" fmla="*/ 815 h 970"/>
                <a:gd name="T18" fmla="*/ 229 w 969"/>
                <a:gd name="T19" fmla="*/ 898 h 970"/>
                <a:gd name="T20" fmla="*/ 348 w 969"/>
                <a:gd name="T21" fmla="*/ 950 h 970"/>
                <a:gd name="T22" fmla="*/ 476 w 969"/>
                <a:gd name="T23" fmla="*/ 970 h 970"/>
                <a:gd name="T24" fmla="*/ 604 w 969"/>
                <a:gd name="T25" fmla="*/ 954 h 970"/>
                <a:gd name="T26" fmla="*/ 724 w 969"/>
                <a:gd name="T27" fmla="*/ 906 h 970"/>
                <a:gd name="T28" fmla="*/ 827 w 969"/>
                <a:gd name="T29" fmla="*/ 827 h 970"/>
                <a:gd name="T30" fmla="*/ 906 w 969"/>
                <a:gd name="T31" fmla="*/ 724 h 970"/>
                <a:gd name="T32" fmla="*/ 954 w 969"/>
                <a:gd name="T33" fmla="*/ 604 h 970"/>
                <a:gd name="T34" fmla="*/ 969 w 969"/>
                <a:gd name="T35" fmla="*/ 475 h 970"/>
                <a:gd name="T36" fmla="*/ 949 w 969"/>
                <a:gd name="T37" fmla="*/ 346 h 970"/>
                <a:gd name="T38" fmla="*/ 895 w 969"/>
                <a:gd name="T39" fmla="*/ 228 h 970"/>
                <a:gd name="T40" fmla="*/ 813 w 969"/>
                <a:gd name="T41" fmla="*/ 129 h 970"/>
                <a:gd name="T42" fmla="*/ 706 w 969"/>
                <a:gd name="T43" fmla="*/ 55 h 970"/>
                <a:gd name="T44" fmla="*/ 585 w 969"/>
                <a:gd name="T45" fmla="*/ 11 h 970"/>
                <a:gd name="T46" fmla="*/ 489 w 969"/>
                <a:gd name="T47" fmla="*/ 0 h 970"/>
                <a:gd name="T48" fmla="*/ 572 w 969"/>
                <a:gd name="T49" fmla="*/ 20 h 970"/>
                <a:gd name="T50" fmla="*/ 694 w 969"/>
                <a:gd name="T51" fmla="*/ 59 h 970"/>
                <a:gd name="T52" fmla="*/ 799 w 969"/>
                <a:gd name="T53" fmla="*/ 130 h 970"/>
                <a:gd name="T54" fmla="*/ 882 w 969"/>
                <a:gd name="T55" fmla="*/ 226 h 970"/>
                <a:gd name="T56" fmla="*/ 936 w 969"/>
                <a:gd name="T57" fmla="*/ 341 h 970"/>
                <a:gd name="T58" fmla="*/ 958 w 969"/>
                <a:gd name="T59" fmla="*/ 466 h 970"/>
                <a:gd name="T60" fmla="*/ 946 w 969"/>
                <a:gd name="T61" fmla="*/ 591 h 970"/>
                <a:gd name="T62" fmla="*/ 901 w 969"/>
                <a:gd name="T63" fmla="*/ 711 h 970"/>
                <a:gd name="T64" fmla="*/ 826 w 969"/>
                <a:gd name="T65" fmla="*/ 814 h 970"/>
                <a:gd name="T66" fmla="*/ 728 w 969"/>
                <a:gd name="T67" fmla="*/ 892 h 970"/>
                <a:gd name="T68" fmla="*/ 611 w 969"/>
                <a:gd name="T69" fmla="*/ 942 h 970"/>
                <a:gd name="T70" fmla="*/ 485 w 969"/>
                <a:gd name="T71" fmla="*/ 960 h 970"/>
                <a:gd name="T72" fmla="*/ 359 w 969"/>
                <a:gd name="T73" fmla="*/ 943 h 970"/>
                <a:gd name="T74" fmla="*/ 243 w 969"/>
                <a:gd name="T75" fmla="*/ 893 h 970"/>
                <a:gd name="T76" fmla="*/ 144 w 969"/>
                <a:gd name="T77" fmla="*/ 815 h 970"/>
                <a:gd name="T78" fmla="*/ 68 w 969"/>
                <a:gd name="T79" fmla="*/ 713 h 970"/>
                <a:gd name="T80" fmla="*/ 23 w 969"/>
                <a:gd name="T81" fmla="*/ 594 h 970"/>
                <a:gd name="T82" fmla="*/ 10 w 969"/>
                <a:gd name="T83" fmla="*/ 468 h 970"/>
                <a:gd name="T84" fmla="*/ 33 w 969"/>
                <a:gd name="T85" fmla="*/ 343 h 970"/>
                <a:gd name="T86" fmla="*/ 86 w 969"/>
                <a:gd name="T87" fmla="*/ 227 h 970"/>
                <a:gd name="T88" fmla="*/ 169 w 969"/>
                <a:gd name="T89" fmla="*/ 131 h 970"/>
                <a:gd name="T90" fmla="*/ 274 w 969"/>
                <a:gd name="T91" fmla="*/ 60 h 970"/>
                <a:gd name="T92" fmla="*/ 395 w 969"/>
                <a:gd name="T93" fmla="*/ 20 h 970"/>
                <a:gd name="T94" fmla="*/ 487 w 969"/>
                <a:gd name="T95" fmla="*/ 11 h 9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969" h="970">
                  <a:moveTo>
                    <a:pt x="487" y="0"/>
                  </a:moveTo>
                  <a:lnTo>
                    <a:pt x="444" y="3"/>
                  </a:lnTo>
                  <a:lnTo>
                    <a:pt x="401" y="7"/>
                  </a:lnTo>
                  <a:lnTo>
                    <a:pt x="359" y="17"/>
                  </a:lnTo>
                  <a:lnTo>
                    <a:pt x="319" y="30"/>
                  </a:lnTo>
                  <a:lnTo>
                    <a:pt x="278" y="47"/>
                  </a:lnTo>
                  <a:lnTo>
                    <a:pt x="239" y="67"/>
                  </a:lnTo>
                  <a:lnTo>
                    <a:pt x="203" y="90"/>
                  </a:lnTo>
                  <a:lnTo>
                    <a:pt x="169" y="117"/>
                  </a:lnTo>
                  <a:lnTo>
                    <a:pt x="137" y="147"/>
                  </a:lnTo>
                  <a:lnTo>
                    <a:pt x="109" y="180"/>
                  </a:lnTo>
                  <a:lnTo>
                    <a:pt x="83" y="214"/>
                  </a:lnTo>
                  <a:lnTo>
                    <a:pt x="60" y="251"/>
                  </a:lnTo>
                  <a:lnTo>
                    <a:pt x="41" y="290"/>
                  </a:lnTo>
                  <a:lnTo>
                    <a:pt x="26" y="331"/>
                  </a:lnTo>
                  <a:lnTo>
                    <a:pt x="14" y="371"/>
                  </a:lnTo>
                  <a:lnTo>
                    <a:pt x="6" y="414"/>
                  </a:lnTo>
                  <a:lnTo>
                    <a:pt x="1" y="458"/>
                  </a:lnTo>
                  <a:lnTo>
                    <a:pt x="0" y="501"/>
                  </a:lnTo>
                  <a:lnTo>
                    <a:pt x="4" y="544"/>
                  </a:lnTo>
                  <a:lnTo>
                    <a:pt x="12" y="587"/>
                  </a:lnTo>
                  <a:lnTo>
                    <a:pt x="22" y="629"/>
                  </a:lnTo>
                  <a:lnTo>
                    <a:pt x="36" y="670"/>
                  </a:lnTo>
                  <a:lnTo>
                    <a:pt x="55" y="708"/>
                  </a:lnTo>
                  <a:lnTo>
                    <a:pt x="76" y="747"/>
                  </a:lnTo>
                  <a:lnTo>
                    <a:pt x="101" y="782"/>
                  </a:lnTo>
                  <a:lnTo>
                    <a:pt x="129" y="815"/>
                  </a:lnTo>
                  <a:lnTo>
                    <a:pt x="160" y="846"/>
                  </a:lnTo>
                  <a:lnTo>
                    <a:pt x="194" y="873"/>
                  </a:lnTo>
                  <a:lnTo>
                    <a:pt x="229" y="898"/>
                  </a:lnTo>
                  <a:lnTo>
                    <a:pt x="268" y="918"/>
                  </a:lnTo>
                  <a:lnTo>
                    <a:pt x="307" y="936"/>
                  </a:lnTo>
                  <a:lnTo>
                    <a:pt x="348" y="950"/>
                  </a:lnTo>
                  <a:lnTo>
                    <a:pt x="390" y="960"/>
                  </a:lnTo>
                  <a:lnTo>
                    <a:pt x="433" y="967"/>
                  </a:lnTo>
                  <a:lnTo>
                    <a:pt x="476" y="970"/>
                  </a:lnTo>
                  <a:lnTo>
                    <a:pt x="519" y="969"/>
                  </a:lnTo>
                  <a:lnTo>
                    <a:pt x="562" y="964"/>
                  </a:lnTo>
                  <a:lnTo>
                    <a:pt x="604" y="954"/>
                  </a:lnTo>
                  <a:lnTo>
                    <a:pt x="646" y="942"/>
                  </a:lnTo>
                  <a:lnTo>
                    <a:pt x="686" y="926"/>
                  </a:lnTo>
                  <a:lnTo>
                    <a:pt x="724" y="906"/>
                  </a:lnTo>
                  <a:lnTo>
                    <a:pt x="761" y="883"/>
                  </a:lnTo>
                  <a:lnTo>
                    <a:pt x="796" y="857"/>
                  </a:lnTo>
                  <a:lnTo>
                    <a:pt x="827" y="827"/>
                  </a:lnTo>
                  <a:lnTo>
                    <a:pt x="857" y="796"/>
                  </a:lnTo>
                  <a:lnTo>
                    <a:pt x="883" y="760"/>
                  </a:lnTo>
                  <a:lnTo>
                    <a:pt x="906" y="724"/>
                  </a:lnTo>
                  <a:lnTo>
                    <a:pt x="925" y="686"/>
                  </a:lnTo>
                  <a:lnTo>
                    <a:pt x="942" y="645"/>
                  </a:lnTo>
                  <a:lnTo>
                    <a:pt x="954" y="604"/>
                  </a:lnTo>
                  <a:lnTo>
                    <a:pt x="962" y="561"/>
                  </a:lnTo>
                  <a:lnTo>
                    <a:pt x="968" y="519"/>
                  </a:lnTo>
                  <a:lnTo>
                    <a:pt x="969" y="475"/>
                  </a:lnTo>
                  <a:lnTo>
                    <a:pt x="966" y="431"/>
                  </a:lnTo>
                  <a:lnTo>
                    <a:pt x="959" y="388"/>
                  </a:lnTo>
                  <a:lnTo>
                    <a:pt x="949" y="346"/>
                  </a:lnTo>
                  <a:lnTo>
                    <a:pt x="934" y="306"/>
                  </a:lnTo>
                  <a:lnTo>
                    <a:pt x="917" y="267"/>
                  </a:lnTo>
                  <a:lnTo>
                    <a:pt x="895" y="228"/>
                  </a:lnTo>
                  <a:lnTo>
                    <a:pt x="871" y="193"/>
                  </a:lnTo>
                  <a:lnTo>
                    <a:pt x="843" y="159"/>
                  </a:lnTo>
                  <a:lnTo>
                    <a:pt x="813" y="129"/>
                  </a:lnTo>
                  <a:lnTo>
                    <a:pt x="780" y="101"/>
                  </a:lnTo>
                  <a:lnTo>
                    <a:pt x="744" y="76"/>
                  </a:lnTo>
                  <a:lnTo>
                    <a:pt x="706" y="55"/>
                  </a:lnTo>
                  <a:lnTo>
                    <a:pt x="668" y="37"/>
                  </a:lnTo>
                  <a:lnTo>
                    <a:pt x="627" y="22"/>
                  </a:lnTo>
                  <a:lnTo>
                    <a:pt x="585" y="11"/>
                  </a:lnTo>
                  <a:lnTo>
                    <a:pt x="542" y="4"/>
                  </a:lnTo>
                  <a:lnTo>
                    <a:pt x="499" y="0"/>
                  </a:lnTo>
                  <a:lnTo>
                    <a:pt x="489" y="0"/>
                  </a:lnTo>
                  <a:lnTo>
                    <a:pt x="489" y="11"/>
                  </a:lnTo>
                  <a:lnTo>
                    <a:pt x="531" y="13"/>
                  </a:lnTo>
                  <a:lnTo>
                    <a:pt x="572" y="20"/>
                  </a:lnTo>
                  <a:lnTo>
                    <a:pt x="614" y="29"/>
                  </a:lnTo>
                  <a:lnTo>
                    <a:pt x="654" y="42"/>
                  </a:lnTo>
                  <a:lnTo>
                    <a:pt x="694" y="59"/>
                  </a:lnTo>
                  <a:lnTo>
                    <a:pt x="730" y="80"/>
                  </a:lnTo>
                  <a:lnTo>
                    <a:pt x="765" y="104"/>
                  </a:lnTo>
                  <a:lnTo>
                    <a:pt x="799" y="130"/>
                  </a:lnTo>
                  <a:lnTo>
                    <a:pt x="829" y="159"/>
                  </a:lnTo>
                  <a:lnTo>
                    <a:pt x="857" y="192"/>
                  </a:lnTo>
                  <a:lnTo>
                    <a:pt x="882" y="226"/>
                  </a:lnTo>
                  <a:lnTo>
                    <a:pt x="903" y="262"/>
                  </a:lnTo>
                  <a:lnTo>
                    <a:pt x="922" y="301"/>
                  </a:lnTo>
                  <a:lnTo>
                    <a:pt x="936" y="341"/>
                  </a:lnTo>
                  <a:lnTo>
                    <a:pt x="946" y="382"/>
                  </a:lnTo>
                  <a:lnTo>
                    <a:pt x="954" y="424"/>
                  </a:lnTo>
                  <a:lnTo>
                    <a:pt x="958" y="466"/>
                  </a:lnTo>
                  <a:lnTo>
                    <a:pt x="958" y="507"/>
                  </a:lnTo>
                  <a:lnTo>
                    <a:pt x="954" y="551"/>
                  </a:lnTo>
                  <a:lnTo>
                    <a:pt x="946" y="591"/>
                  </a:lnTo>
                  <a:lnTo>
                    <a:pt x="935" y="633"/>
                  </a:lnTo>
                  <a:lnTo>
                    <a:pt x="920" y="672"/>
                  </a:lnTo>
                  <a:lnTo>
                    <a:pt x="901" y="711"/>
                  </a:lnTo>
                  <a:lnTo>
                    <a:pt x="880" y="747"/>
                  </a:lnTo>
                  <a:lnTo>
                    <a:pt x="855" y="781"/>
                  </a:lnTo>
                  <a:lnTo>
                    <a:pt x="826" y="814"/>
                  </a:lnTo>
                  <a:lnTo>
                    <a:pt x="796" y="842"/>
                  </a:lnTo>
                  <a:lnTo>
                    <a:pt x="763" y="869"/>
                  </a:lnTo>
                  <a:lnTo>
                    <a:pt x="728" y="892"/>
                  </a:lnTo>
                  <a:lnTo>
                    <a:pt x="690" y="913"/>
                  </a:lnTo>
                  <a:lnTo>
                    <a:pt x="652" y="930"/>
                  </a:lnTo>
                  <a:lnTo>
                    <a:pt x="611" y="942"/>
                  </a:lnTo>
                  <a:lnTo>
                    <a:pt x="570" y="952"/>
                  </a:lnTo>
                  <a:lnTo>
                    <a:pt x="528" y="958"/>
                  </a:lnTo>
                  <a:lnTo>
                    <a:pt x="485" y="960"/>
                  </a:lnTo>
                  <a:lnTo>
                    <a:pt x="443" y="958"/>
                  </a:lnTo>
                  <a:lnTo>
                    <a:pt x="401" y="952"/>
                  </a:lnTo>
                  <a:lnTo>
                    <a:pt x="359" y="943"/>
                  </a:lnTo>
                  <a:lnTo>
                    <a:pt x="320" y="930"/>
                  </a:lnTo>
                  <a:lnTo>
                    <a:pt x="280" y="914"/>
                  </a:lnTo>
                  <a:lnTo>
                    <a:pt x="243" y="893"/>
                  </a:lnTo>
                  <a:lnTo>
                    <a:pt x="208" y="871"/>
                  </a:lnTo>
                  <a:lnTo>
                    <a:pt x="175" y="844"/>
                  </a:lnTo>
                  <a:lnTo>
                    <a:pt x="144" y="815"/>
                  </a:lnTo>
                  <a:lnTo>
                    <a:pt x="116" y="783"/>
                  </a:lnTo>
                  <a:lnTo>
                    <a:pt x="91" y="749"/>
                  </a:lnTo>
                  <a:lnTo>
                    <a:pt x="68" y="713"/>
                  </a:lnTo>
                  <a:lnTo>
                    <a:pt x="50" y="674"/>
                  </a:lnTo>
                  <a:lnTo>
                    <a:pt x="35" y="635"/>
                  </a:lnTo>
                  <a:lnTo>
                    <a:pt x="23" y="594"/>
                  </a:lnTo>
                  <a:lnTo>
                    <a:pt x="15" y="553"/>
                  </a:lnTo>
                  <a:lnTo>
                    <a:pt x="12" y="510"/>
                  </a:lnTo>
                  <a:lnTo>
                    <a:pt x="10" y="468"/>
                  </a:lnTo>
                  <a:lnTo>
                    <a:pt x="15" y="426"/>
                  </a:lnTo>
                  <a:lnTo>
                    <a:pt x="22" y="384"/>
                  </a:lnTo>
                  <a:lnTo>
                    <a:pt x="33" y="343"/>
                  </a:lnTo>
                  <a:lnTo>
                    <a:pt x="47" y="303"/>
                  </a:lnTo>
                  <a:lnTo>
                    <a:pt x="65" y="265"/>
                  </a:lnTo>
                  <a:lnTo>
                    <a:pt x="86" y="227"/>
                  </a:lnTo>
                  <a:lnTo>
                    <a:pt x="111" y="193"/>
                  </a:lnTo>
                  <a:lnTo>
                    <a:pt x="138" y="161"/>
                  </a:lnTo>
                  <a:lnTo>
                    <a:pt x="169" y="131"/>
                  </a:lnTo>
                  <a:lnTo>
                    <a:pt x="202" y="105"/>
                  </a:lnTo>
                  <a:lnTo>
                    <a:pt x="237" y="81"/>
                  </a:lnTo>
                  <a:lnTo>
                    <a:pt x="274" y="60"/>
                  </a:lnTo>
                  <a:lnTo>
                    <a:pt x="313" y="43"/>
                  </a:lnTo>
                  <a:lnTo>
                    <a:pt x="353" y="30"/>
                  </a:lnTo>
                  <a:lnTo>
                    <a:pt x="395" y="20"/>
                  </a:lnTo>
                  <a:lnTo>
                    <a:pt x="435" y="13"/>
                  </a:lnTo>
                  <a:lnTo>
                    <a:pt x="478" y="11"/>
                  </a:lnTo>
                  <a:lnTo>
                    <a:pt x="487" y="11"/>
                  </a:lnTo>
                  <a:lnTo>
                    <a:pt x="487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7" name="Oval 160"/>
            <p:cNvSpPr>
              <a:spLocks noChangeArrowheads="1"/>
            </p:cNvSpPr>
            <p:nvPr/>
          </p:nvSpPr>
          <p:spPr bwMode="auto">
            <a:xfrm>
              <a:off x="4901406" y="2752140"/>
              <a:ext cx="1527175" cy="1530350"/>
            </a:xfrm>
            <a:prstGeom prst="ellips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8" name="Oval 161"/>
            <p:cNvSpPr>
              <a:spLocks noChangeArrowheads="1"/>
            </p:cNvSpPr>
            <p:nvPr/>
          </p:nvSpPr>
          <p:spPr bwMode="auto">
            <a:xfrm>
              <a:off x="4917281" y="2769603"/>
              <a:ext cx="1495425" cy="1495425"/>
            </a:xfrm>
            <a:prstGeom prst="ellips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1" name="Rectangle 164"/>
            <p:cNvSpPr>
              <a:spLocks noChangeArrowheads="1"/>
            </p:cNvSpPr>
            <p:nvPr/>
          </p:nvSpPr>
          <p:spPr bwMode="auto">
            <a:xfrm>
              <a:off x="5458469" y="3589338"/>
              <a:ext cx="342900" cy="173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itchFamily="49" charset="0"/>
                  <a:cs typeface="Arial" pitchFamily="34" charset="0"/>
                </a:rPr>
                <a:t>3031 bp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" name="Freeform 165"/>
            <p:cNvSpPr>
              <a:spLocks/>
            </p:cNvSpPr>
            <p:nvPr/>
          </p:nvSpPr>
          <p:spPr bwMode="auto">
            <a:xfrm>
              <a:off x="4898231" y="3720515"/>
              <a:ext cx="1035050" cy="593725"/>
            </a:xfrm>
            <a:custGeom>
              <a:avLst/>
              <a:gdLst>
                <a:gd name="T0" fmla="*/ 67 w 652"/>
                <a:gd name="T1" fmla="*/ 19 h 374"/>
                <a:gd name="T2" fmla="*/ 24 w 652"/>
                <a:gd name="T3" fmla="*/ 0 h 374"/>
                <a:gd name="T4" fmla="*/ 0 w 652"/>
                <a:gd name="T5" fmla="*/ 42 h 374"/>
                <a:gd name="T6" fmla="*/ 15 w 652"/>
                <a:gd name="T7" fmla="*/ 36 h 374"/>
                <a:gd name="T8" fmla="*/ 31 w 652"/>
                <a:gd name="T9" fmla="*/ 78 h 374"/>
                <a:gd name="T10" fmla="*/ 51 w 652"/>
                <a:gd name="T11" fmla="*/ 118 h 374"/>
                <a:gd name="T12" fmla="*/ 74 w 652"/>
                <a:gd name="T13" fmla="*/ 156 h 374"/>
                <a:gd name="T14" fmla="*/ 101 w 652"/>
                <a:gd name="T15" fmla="*/ 191 h 374"/>
                <a:gd name="T16" fmla="*/ 130 w 652"/>
                <a:gd name="T17" fmla="*/ 225 h 374"/>
                <a:gd name="T18" fmla="*/ 163 w 652"/>
                <a:gd name="T19" fmla="*/ 255 h 374"/>
                <a:gd name="T20" fmla="*/ 198 w 652"/>
                <a:gd name="T21" fmla="*/ 283 h 374"/>
                <a:gd name="T22" fmla="*/ 236 w 652"/>
                <a:gd name="T23" fmla="*/ 307 h 374"/>
                <a:gd name="T24" fmla="*/ 275 w 652"/>
                <a:gd name="T25" fmla="*/ 327 h 374"/>
                <a:gd name="T26" fmla="*/ 316 w 652"/>
                <a:gd name="T27" fmla="*/ 344 h 374"/>
                <a:gd name="T28" fmla="*/ 359 w 652"/>
                <a:gd name="T29" fmla="*/ 358 h 374"/>
                <a:gd name="T30" fmla="*/ 402 w 652"/>
                <a:gd name="T31" fmla="*/ 367 h 374"/>
                <a:gd name="T32" fmla="*/ 448 w 652"/>
                <a:gd name="T33" fmla="*/ 373 h 374"/>
                <a:gd name="T34" fmla="*/ 492 w 652"/>
                <a:gd name="T35" fmla="*/ 374 h 374"/>
                <a:gd name="T36" fmla="*/ 536 w 652"/>
                <a:gd name="T37" fmla="*/ 372 h 374"/>
                <a:gd name="T38" fmla="*/ 580 w 652"/>
                <a:gd name="T39" fmla="*/ 366 h 374"/>
                <a:gd name="T40" fmla="*/ 623 w 652"/>
                <a:gd name="T41" fmla="*/ 356 h 374"/>
                <a:gd name="T42" fmla="*/ 652 w 652"/>
                <a:gd name="T43" fmla="*/ 346 h 374"/>
                <a:gd name="T44" fmla="*/ 639 w 652"/>
                <a:gd name="T45" fmla="*/ 309 h 374"/>
                <a:gd name="T46" fmla="*/ 599 w 652"/>
                <a:gd name="T47" fmla="*/ 321 h 374"/>
                <a:gd name="T48" fmla="*/ 559 w 652"/>
                <a:gd name="T49" fmla="*/ 330 h 374"/>
                <a:gd name="T50" fmla="*/ 518 w 652"/>
                <a:gd name="T51" fmla="*/ 334 h 374"/>
                <a:gd name="T52" fmla="*/ 477 w 652"/>
                <a:gd name="T53" fmla="*/ 335 h 374"/>
                <a:gd name="T54" fmla="*/ 436 w 652"/>
                <a:gd name="T55" fmla="*/ 332 h 374"/>
                <a:gd name="T56" fmla="*/ 395 w 652"/>
                <a:gd name="T57" fmla="*/ 326 h 374"/>
                <a:gd name="T58" fmla="*/ 356 w 652"/>
                <a:gd name="T59" fmla="*/ 316 h 374"/>
                <a:gd name="T60" fmla="*/ 317 w 652"/>
                <a:gd name="T61" fmla="*/ 303 h 374"/>
                <a:gd name="T62" fmla="*/ 280 w 652"/>
                <a:gd name="T63" fmla="*/ 285 h 374"/>
                <a:gd name="T64" fmla="*/ 244 w 652"/>
                <a:gd name="T65" fmla="*/ 265 h 374"/>
                <a:gd name="T66" fmla="*/ 210 w 652"/>
                <a:gd name="T67" fmla="*/ 242 h 374"/>
                <a:gd name="T68" fmla="*/ 178 w 652"/>
                <a:gd name="T69" fmla="*/ 216 h 374"/>
                <a:gd name="T70" fmla="*/ 150 w 652"/>
                <a:gd name="T71" fmla="*/ 187 h 374"/>
                <a:gd name="T72" fmla="*/ 122 w 652"/>
                <a:gd name="T73" fmla="*/ 156 h 374"/>
                <a:gd name="T74" fmla="*/ 99 w 652"/>
                <a:gd name="T75" fmla="*/ 122 h 374"/>
                <a:gd name="T76" fmla="*/ 78 w 652"/>
                <a:gd name="T77" fmla="*/ 87 h 374"/>
                <a:gd name="T78" fmla="*/ 61 w 652"/>
                <a:gd name="T79" fmla="*/ 50 h 374"/>
                <a:gd name="T80" fmla="*/ 52 w 652"/>
                <a:gd name="T81" fmla="*/ 23 h 374"/>
                <a:gd name="T82" fmla="*/ 67 w 652"/>
                <a:gd name="T83" fmla="*/ 19 h 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652" h="374">
                  <a:moveTo>
                    <a:pt x="67" y="19"/>
                  </a:moveTo>
                  <a:lnTo>
                    <a:pt x="24" y="0"/>
                  </a:lnTo>
                  <a:lnTo>
                    <a:pt x="0" y="42"/>
                  </a:lnTo>
                  <a:lnTo>
                    <a:pt x="15" y="36"/>
                  </a:lnTo>
                  <a:lnTo>
                    <a:pt x="31" y="78"/>
                  </a:lnTo>
                  <a:lnTo>
                    <a:pt x="51" y="118"/>
                  </a:lnTo>
                  <a:lnTo>
                    <a:pt x="74" y="156"/>
                  </a:lnTo>
                  <a:lnTo>
                    <a:pt x="101" y="191"/>
                  </a:lnTo>
                  <a:lnTo>
                    <a:pt x="130" y="225"/>
                  </a:lnTo>
                  <a:lnTo>
                    <a:pt x="163" y="255"/>
                  </a:lnTo>
                  <a:lnTo>
                    <a:pt x="198" y="283"/>
                  </a:lnTo>
                  <a:lnTo>
                    <a:pt x="236" y="307"/>
                  </a:lnTo>
                  <a:lnTo>
                    <a:pt x="275" y="327"/>
                  </a:lnTo>
                  <a:lnTo>
                    <a:pt x="316" y="344"/>
                  </a:lnTo>
                  <a:lnTo>
                    <a:pt x="359" y="358"/>
                  </a:lnTo>
                  <a:lnTo>
                    <a:pt x="402" y="367"/>
                  </a:lnTo>
                  <a:lnTo>
                    <a:pt x="448" y="373"/>
                  </a:lnTo>
                  <a:lnTo>
                    <a:pt x="492" y="374"/>
                  </a:lnTo>
                  <a:lnTo>
                    <a:pt x="536" y="372"/>
                  </a:lnTo>
                  <a:lnTo>
                    <a:pt x="580" y="366"/>
                  </a:lnTo>
                  <a:lnTo>
                    <a:pt x="623" y="356"/>
                  </a:lnTo>
                  <a:lnTo>
                    <a:pt x="652" y="346"/>
                  </a:lnTo>
                  <a:lnTo>
                    <a:pt x="639" y="309"/>
                  </a:lnTo>
                  <a:lnTo>
                    <a:pt x="599" y="321"/>
                  </a:lnTo>
                  <a:lnTo>
                    <a:pt x="559" y="330"/>
                  </a:lnTo>
                  <a:lnTo>
                    <a:pt x="518" y="334"/>
                  </a:lnTo>
                  <a:lnTo>
                    <a:pt x="477" y="335"/>
                  </a:lnTo>
                  <a:lnTo>
                    <a:pt x="436" y="332"/>
                  </a:lnTo>
                  <a:lnTo>
                    <a:pt x="395" y="326"/>
                  </a:lnTo>
                  <a:lnTo>
                    <a:pt x="356" y="316"/>
                  </a:lnTo>
                  <a:lnTo>
                    <a:pt x="317" y="303"/>
                  </a:lnTo>
                  <a:lnTo>
                    <a:pt x="280" y="285"/>
                  </a:lnTo>
                  <a:lnTo>
                    <a:pt x="244" y="265"/>
                  </a:lnTo>
                  <a:lnTo>
                    <a:pt x="210" y="242"/>
                  </a:lnTo>
                  <a:lnTo>
                    <a:pt x="178" y="216"/>
                  </a:lnTo>
                  <a:lnTo>
                    <a:pt x="150" y="187"/>
                  </a:lnTo>
                  <a:lnTo>
                    <a:pt x="122" y="156"/>
                  </a:lnTo>
                  <a:lnTo>
                    <a:pt x="99" y="122"/>
                  </a:lnTo>
                  <a:lnTo>
                    <a:pt x="78" y="87"/>
                  </a:lnTo>
                  <a:lnTo>
                    <a:pt x="61" y="50"/>
                  </a:lnTo>
                  <a:lnTo>
                    <a:pt x="52" y="23"/>
                  </a:lnTo>
                  <a:lnTo>
                    <a:pt x="67" y="19"/>
                  </a:lnTo>
                  <a:close/>
                </a:path>
              </a:pathLst>
            </a:custGeom>
            <a:solidFill>
              <a:srgbClr val="FF66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3" name="Arc 166"/>
            <p:cNvSpPr>
              <a:spLocks/>
            </p:cNvSpPr>
            <p:nvPr/>
          </p:nvSpPr>
          <p:spPr bwMode="auto">
            <a:xfrm>
              <a:off x="4922043" y="3517315"/>
              <a:ext cx="1008063" cy="787400"/>
            </a:xfrm>
            <a:custGeom>
              <a:avLst/>
              <a:gdLst>
                <a:gd name="G0" fmla="+- 20385 0 0"/>
                <a:gd name="G1" fmla="+- 0 0 0"/>
                <a:gd name="G2" fmla="+- 21600 0 0"/>
                <a:gd name="T0" fmla="*/ 27639 w 27639"/>
                <a:gd name="T1" fmla="*/ 20346 h 21600"/>
                <a:gd name="T2" fmla="*/ 0 w 27639"/>
                <a:gd name="T3" fmla="*/ 7143 h 21600"/>
                <a:gd name="T4" fmla="*/ 20385 w 27639"/>
                <a:gd name="T5" fmla="*/ 0 h 21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639" h="21600" fill="none" extrusionOk="0">
                  <a:moveTo>
                    <a:pt x="27638" y="20345"/>
                  </a:moveTo>
                  <a:cubicBezTo>
                    <a:pt x="25310" y="21175"/>
                    <a:pt x="22856" y="21599"/>
                    <a:pt x="20385" y="21600"/>
                  </a:cubicBezTo>
                  <a:cubicBezTo>
                    <a:pt x="11209" y="21600"/>
                    <a:pt x="3034" y="15802"/>
                    <a:pt x="0" y="7142"/>
                  </a:cubicBezTo>
                </a:path>
                <a:path w="27639" h="21600" stroke="0" extrusionOk="0">
                  <a:moveTo>
                    <a:pt x="27638" y="20345"/>
                  </a:moveTo>
                  <a:cubicBezTo>
                    <a:pt x="25310" y="21175"/>
                    <a:pt x="22856" y="21599"/>
                    <a:pt x="20385" y="21600"/>
                  </a:cubicBezTo>
                  <a:cubicBezTo>
                    <a:pt x="11209" y="21600"/>
                    <a:pt x="3034" y="15802"/>
                    <a:pt x="0" y="7142"/>
                  </a:cubicBezTo>
                  <a:lnTo>
                    <a:pt x="20385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4" name="Arc 167"/>
            <p:cNvSpPr>
              <a:spLocks/>
            </p:cNvSpPr>
            <p:nvPr/>
          </p:nvSpPr>
          <p:spPr bwMode="auto">
            <a:xfrm>
              <a:off x="4982368" y="3517315"/>
              <a:ext cx="927100" cy="725488"/>
            </a:xfrm>
            <a:custGeom>
              <a:avLst/>
              <a:gdLst>
                <a:gd name="G0" fmla="+- 20390 0 0"/>
                <a:gd name="G1" fmla="+- 0 0 0"/>
                <a:gd name="G2" fmla="+- 21600 0 0"/>
                <a:gd name="T0" fmla="*/ 27666 w 27666"/>
                <a:gd name="T1" fmla="*/ 20338 h 21600"/>
                <a:gd name="T2" fmla="*/ 0 w 27666"/>
                <a:gd name="T3" fmla="*/ 7128 h 21600"/>
                <a:gd name="T4" fmla="*/ 20390 w 27666"/>
                <a:gd name="T5" fmla="*/ 0 h 21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666" h="21600" fill="none" extrusionOk="0">
                  <a:moveTo>
                    <a:pt x="27665" y="20337"/>
                  </a:moveTo>
                  <a:cubicBezTo>
                    <a:pt x="25331" y="21172"/>
                    <a:pt x="22869" y="21599"/>
                    <a:pt x="20390" y="21600"/>
                  </a:cubicBezTo>
                  <a:cubicBezTo>
                    <a:pt x="11208" y="21600"/>
                    <a:pt x="3029" y="15795"/>
                    <a:pt x="0" y="7127"/>
                  </a:cubicBezTo>
                </a:path>
                <a:path w="27666" h="21600" stroke="0" extrusionOk="0">
                  <a:moveTo>
                    <a:pt x="27665" y="20337"/>
                  </a:moveTo>
                  <a:cubicBezTo>
                    <a:pt x="25331" y="21172"/>
                    <a:pt x="22869" y="21599"/>
                    <a:pt x="20390" y="21600"/>
                  </a:cubicBezTo>
                  <a:cubicBezTo>
                    <a:pt x="11208" y="21600"/>
                    <a:pt x="3029" y="15795"/>
                    <a:pt x="0" y="7127"/>
                  </a:cubicBezTo>
                  <a:lnTo>
                    <a:pt x="20390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5" name="Line 168"/>
            <p:cNvSpPr>
              <a:spLocks noChangeShapeType="1"/>
            </p:cNvSpPr>
            <p:nvPr/>
          </p:nvSpPr>
          <p:spPr bwMode="auto">
            <a:xfrm>
              <a:off x="5912643" y="4211053"/>
              <a:ext cx="20638" cy="587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" name="Freeform 169"/>
            <p:cNvSpPr>
              <a:spLocks/>
            </p:cNvSpPr>
            <p:nvPr/>
          </p:nvSpPr>
          <p:spPr bwMode="auto">
            <a:xfrm>
              <a:off x="4898231" y="3720515"/>
              <a:ext cx="106363" cy="66675"/>
            </a:xfrm>
            <a:custGeom>
              <a:avLst/>
              <a:gdLst>
                <a:gd name="T0" fmla="*/ 46 w 59"/>
                <a:gd name="T1" fmla="*/ 21 h 37"/>
                <a:gd name="T2" fmla="*/ 59 w 59"/>
                <a:gd name="T3" fmla="*/ 17 h 37"/>
                <a:gd name="T4" fmla="*/ 21 w 59"/>
                <a:gd name="T5" fmla="*/ 0 h 37"/>
                <a:gd name="T6" fmla="*/ 0 w 59"/>
                <a:gd name="T7" fmla="*/ 37 h 37"/>
                <a:gd name="T8" fmla="*/ 13 w 59"/>
                <a:gd name="T9" fmla="*/ 32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" h="37">
                  <a:moveTo>
                    <a:pt x="46" y="21"/>
                  </a:moveTo>
                  <a:lnTo>
                    <a:pt x="59" y="17"/>
                  </a:lnTo>
                  <a:lnTo>
                    <a:pt x="21" y="0"/>
                  </a:lnTo>
                  <a:lnTo>
                    <a:pt x="0" y="37"/>
                  </a:lnTo>
                  <a:lnTo>
                    <a:pt x="13" y="3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" name="Line 170"/>
            <p:cNvSpPr>
              <a:spLocks noChangeShapeType="1"/>
            </p:cNvSpPr>
            <p:nvPr/>
          </p:nvSpPr>
          <p:spPr bwMode="auto">
            <a:xfrm flipV="1">
              <a:off x="5182393" y="4223753"/>
              <a:ext cx="119063" cy="23813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" name="Rectangle 171"/>
            <p:cNvSpPr>
              <a:spLocks noChangeArrowheads="1"/>
            </p:cNvSpPr>
            <p:nvPr/>
          </p:nvSpPr>
          <p:spPr bwMode="auto">
            <a:xfrm>
              <a:off x="4809331" y="4250740"/>
              <a:ext cx="26770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800000"/>
                  </a:solidFill>
                  <a:effectLst/>
                  <a:latin typeface="Arial" pitchFamily="34" charset="0"/>
                  <a:cs typeface="Arial" pitchFamily="34" charset="0"/>
                </a:rPr>
                <a:t>Neo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9" name="Freeform 172"/>
            <p:cNvSpPr>
              <a:spLocks/>
            </p:cNvSpPr>
            <p:nvPr/>
          </p:nvSpPr>
          <p:spPr bwMode="auto">
            <a:xfrm>
              <a:off x="4877593" y="2707690"/>
              <a:ext cx="787400" cy="949325"/>
            </a:xfrm>
            <a:custGeom>
              <a:avLst/>
              <a:gdLst>
                <a:gd name="T0" fmla="*/ 466 w 496"/>
                <a:gd name="T1" fmla="*/ 70 h 598"/>
                <a:gd name="T2" fmla="*/ 496 w 496"/>
                <a:gd name="T3" fmla="*/ 34 h 598"/>
                <a:gd name="T4" fmla="*/ 462 w 496"/>
                <a:gd name="T5" fmla="*/ 0 h 598"/>
                <a:gd name="T6" fmla="*/ 463 w 496"/>
                <a:gd name="T7" fmla="*/ 16 h 598"/>
                <a:gd name="T8" fmla="*/ 419 w 496"/>
                <a:gd name="T9" fmla="*/ 20 h 598"/>
                <a:gd name="T10" fmla="*/ 374 w 496"/>
                <a:gd name="T11" fmla="*/ 29 h 598"/>
                <a:gd name="T12" fmla="*/ 333 w 496"/>
                <a:gd name="T13" fmla="*/ 43 h 598"/>
                <a:gd name="T14" fmla="*/ 291 w 496"/>
                <a:gd name="T15" fmla="*/ 60 h 598"/>
                <a:gd name="T16" fmla="*/ 251 w 496"/>
                <a:gd name="T17" fmla="*/ 81 h 598"/>
                <a:gd name="T18" fmla="*/ 214 w 496"/>
                <a:gd name="T19" fmla="*/ 104 h 598"/>
                <a:gd name="T20" fmla="*/ 178 w 496"/>
                <a:gd name="T21" fmla="*/ 132 h 598"/>
                <a:gd name="T22" fmla="*/ 146 w 496"/>
                <a:gd name="T23" fmla="*/ 162 h 598"/>
                <a:gd name="T24" fmla="*/ 115 w 496"/>
                <a:gd name="T25" fmla="*/ 195 h 598"/>
                <a:gd name="T26" fmla="*/ 89 w 496"/>
                <a:gd name="T27" fmla="*/ 230 h 598"/>
                <a:gd name="T28" fmla="*/ 65 w 496"/>
                <a:gd name="T29" fmla="*/ 268 h 598"/>
                <a:gd name="T30" fmla="*/ 45 w 496"/>
                <a:gd name="T31" fmla="*/ 309 h 598"/>
                <a:gd name="T32" fmla="*/ 29 w 496"/>
                <a:gd name="T33" fmla="*/ 349 h 598"/>
                <a:gd name="T34" fmla="*/ 15 w 496"/>
                <a:gd name="T35" fmla="*/ 393 h 598"/>
                <a:gd name="T36" fmla="*/ 7 w 496"/>
                <a:gd name="T37" fmla="*/ 436 h 598"/>
                <a:gd name="T38" fmla="*/ 2 w 496"/>
                <a:gd name="T39" fmla="*/ 481 h 598"/>
                <a:gd name="T40" fmla="*/ 0 w 496"/>
                <a:gd name="T41" fmla="*/ 525 h 598"/>
                <a:gd name="T42" fmla="*/ 4 w 496"/>
                <a:gd name="T43" fmla="*/ 570 h 598"/>
                <a:gd name="T44" fmla="*/ 8 w 496"/>
                <a:gd name="T45" fmla="*/ 598 h 598"/>
                <a:gd name="T46" fmla="*/ 47 w 496"/>
                <a:gd name="T47" fmla="*/ 591 h 598"/>
                <a:gd name="T48" fmla="*/ 41 w 496"/>
                <a:gd name="T49" fmla="*/ 550 h 598"/>
                <a:gd name="T50" fmla="*/ 40 w 496"/>
                <a:gd name="T51" fmla="*/ 509 h 598"/>
                <a:gd name="T52" fmla="*/ 42 w 496"/>
                <a:gd name="T53" fmla="*/ 467 h 598"/>
                <a:gd name="T54" fmla="*/ 48 w 496"/>
                <a:gd name="T55" fmla="*/ 428 h 598"/>
                <a:gd name="T56" fmla="*/ 58 w 496"/>
                <a:gd name="T57" fmla="*/ 387 h 598"/>
                <a:gd name="T58" fmla="*/ 71 w 496"/>
                <a:gd name="T59" fmla="*/ 348 h 598"/>
                <a:gd name="T60" fmla="*/ 88 w 496"/>
                <a:gd name="T61" fmla="*/ 311 h 598"/>
                <a:gd name="T62" fmla="*/ 107 w 496"/>
                <a:gd name="T63" fmla="*/ 275 h 598"/>
                <a:gd name="T64" fmla="*/ 130 w 496"/>
                <a:gd name="T65" fmla="*/ 241 h 598"/>
                <a:gd name="T66" fmla="*/ 156 w 496"/>
                <a:gd name="T67" fmla="*/ 209 h 598"/>
                <a:gd name="T68" fmla="*/ 184 w 496"/>
                <a:gd name="T69" fmla="*/ 179 h 598"/>
                <a:gd name="T70" fmla="*/ 216 w 496"/>
                <a:gd name="T71" fmla="*/ 152 h 598"/>
                <a:gd name="T72" fmla="*/ 249 w 496"/>
                <a:gd name="T73" fmla="*/ 128 h 598"/>
                <a:gd name="T74" fmla="*/ 284 w 496"/>
                <a:gd name="T75" fmla="*/ 107 h 598"/>
                <a:gd name="T76" fmla="*/ 321 w 496"/>
                <a:gd name="T77" fmla="*/ 90 h 598"/>
                <a:gd name="T78" fmla="*/ 360 w 496"/>
                <a:gd name="T79" fmla="*/ 75 h 598"/>
                <a:gd name="T80" fmla="*/ 399 w 496"/>
                <a:gd name="T81" fmla="*/ 65 h 598"/>
                <a:gd name="T82" fmla="*/ 440 w 496"/>
                <a:gd name="T83" fmla="*/ 57 h 598"/>
                <a:gd name="T84" fmla="*/ 465 w 496"/>
                <a:gd name="T85" fmla="*/ 54 h 598"/>
                <a:gd name="T86" fmla="*/ 466 w 496"/>
                <a:gd name="T87" fmla="*/ 70 h 5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496" h="598">
                  <a:moveTo>
                    <a:pt x="466" y="70"/>
                  </a:moveTo>
                  <a:lnTo>
                    <a:pt x="496" y="34"/>
                  </a:lnTo>
                  <a:lnTo>
                    <a:pt x="462" y="0"/>
                  </a:lnTo>
                  <a:lnTo>
                    <a:pt x="463" y="16"/>
                  </a:lnTo>
                  <a:lnTo>
                    <a:pt x="419" y="20"/>
                  </a:lnTo>
                  <a:lnTo>
                    <a:pt x="374" y="29"/>
                  </a:lnTo>
                  <a:lnTo>
                    <a:pt x="333" y="43"/>
                  </a:lnTo>
                  <a:lnTo>
                    <a:pt x="291" y="60"/>
                  </a:lnTo>
                  <a:lnTo>
                    <a:pt x="251" y="81"/>
                  </a:lnTo>
                  <a:lnTo>
                    <a:pt x="214" y="104"/>
                  </a:lnTo>
                  <a:lnTo>
                    <a:pt x="178" y="132"/>
                  </a:lnTo>
                  <a:lnTo>
                    <a:pt x="146" y="162"/>
                  </a:lnTo>
                  <a:lnTo>
                    <a:pt x="115" y="195"/>
                  </a:lnTo>
                  <a:lnTo>
                    <a:pt x="89" y="230"/>
                  </a:lnTo>
                  <a:lnTo>
                    <a:pt x="65" y="268"/>
                  </a:lnTo>
                  <a:lnTo>
                    <a:pt x="45" y="309"/>
                  </a:lnTo>
                  <a:lnTo>
                    <a:pt x="29" y="349"/>
                  </a:lnTo>
                  <a:lnTo>
                    <a:pt x="15" y="393"/>
                  </a:lnTo>
                  <a:lnTo>
                    <a:pt x="7" y="436"/>
                  </a:lnTo>
                  <a:lnTo>
                    <a:pt x="2" y="481"/>
                  </a:lnTo>
                  <a:lnTo>
                    <a:pt x="0" y="525"/>
                  </a:lnTo>
                  <a:lnTo>
                    <a:pt x="4" y="570"/>
                  </a:lnTo>
                  <a:lnTo>
                    <a:pt x="8" y="598"/>
                  </a:lnTo>
                  <a:lnTo>
                    <a:pt x="47" y="591"/>
                  </a:lnTo>
                  <a:lnTo>
                    <a:pt x="41" y="550"/>
                  </a:lnTo>
                  <a:lnTo>
                    <a:pt x="40" y="509"/>
                  </a:lnTo>
                  <a:lnTo>
                    <a:pt x="42" y="467"/>
                  </a:lnTo>
                  <a:lnTo>
                    <a:pt x="48" y="428"/>
                  </a:lnTo>
                  <a:lnTo>
                    <a:pt x="58" y="387"/>
                  </a:lnTo>
                  <a:lnTo>
                    <a:pt x="71" y="348"/>
                  </a:lnTo>
                  <a:lnTo>
                    <a:pt x="88" y="311"/>
                  </a:lnTo>
                  <a:lnTo>
                    <a:pt x="107" y="275"/>
                  </a:lnTo>
                  <a:lnTo>
                    <a:pt x="130" y="241"/>
                  </a:lnTo>
                  <a:lnTo>
                    <a:pt x="156" y="209"/>
                  </a:lnTo>
                  <a:lnTo>
                    <a:pt x="184" y="179"/>
                  </a:lnTo>
                  <a:lnTo>
                    <a:pt x="216" y="152"/>
                  </a:lnTo>
                  <a:lnTo>
                    <a:pt x="249" y="128"/>
                  </a:lnTo>
                  <a:lnTo>
                    <a:pt x="284" y="107"/>
                  </a:lnTo>
                  <a:lnTo>
                    <a:pt x="321" y="90"/>
                  </a:lnTo>
                  <a:lnTo>
                    <a:pt x="360" y="75"/>
                  </a:lnTo>
                  <a:lnTo>
                    <a:pt x="399" y="65"/>
                  </a:lnTo>
                  <a:lnTo>
                    <a:pt x="440" y="57"/>
                  </a:lnTo>
                  <a:lnTo>
                    <a:pt x="465" y="54"/>
                  </a:lnTo>
                  <a:lnTo>
                    <a:pt x="466" y="70"/>
                  </a:ln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" name="Arc 173"/>
            <p:cNvSpPr>
              <a:spLocks/>
            </p:cNvSpPr>
            <p:nvPr/>
          </p:nvSpPr>
          <p:spPr bwMode="auto">
            <a:xfrm>
              <a:off x="4877593" y="2731503"/>
              <a:ext cx="787400" cy="925513"/>
            </a:xfrm>
            <a:custGeom>
              <a:avLst/>
              <a:gdLst>
                <a:gd name="G0" fmla="+- 21600 0 0"/>
                <a:gd name="G1" fmla="+- 21552 0 0"/>
                <a:gd name="G2" fmla="+- 21600 0 0"/>
                <a:gd name="T0" fmla="*/ 343 w 21600"/>
                <a:gd name="T1" fmla="*/ 25385 h 25385"/>
                <a:gd name="T2" fmla="*/ 20160 w 21600"/>
                <a:gd name="T3" fmla="*/ 0 h 25385"/>
                <a:gd name="T4" fmla="*/ 21600 w 21600"/>
                <a:gd name="T5" fmla="*/ 21552 h 253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25385" fill="none" extrusionOk="0">
                  <a:moveTo>
                    <a:pt x="342" y="25385"/>
                  </a:moveTo>
                  <a:cubicBezTo>
                    <a:pt x="114" y="24120"/>
                    <a:pt x="0" y="22837"/>
                    <a:pt x="0" y="21552"/>
                  </a:cubicBezTo>
                  <a:cubicBezTo>
                    <a:pt x="-1" y="10181"/>
                    <a:pt x="8814" y="758"/>
                    <a:pt x="20160" y="0"/>
                  </a:cubicBezTo>
                </a:path>
                <a:path w="21600" h="25385" stroke="0" extrusionOk="0">
                  <a:moveTo>
                    <a:pt x="342" y="25385"/>
                  </a:moveTo>
                  <a:cubicBezTo>
                    <a:pt x="114" y="24120"/>
                    <a:pt x="0" y="22837"/>
                    <a:pt x="0" y="21552"/>
                  </a:cubicBezTo>
                  <a:cubicBezTo>
                    <a:pt x="-1" y="10181"/>
                    <a:pt x="8814" y="758"/>
                    <a:pt x="20160" y="0"/>
                  </a:cubicBezTo>
                  <a:lnTo>
                    <a:pt x="21600" y="21552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1" name="Arc 174"/>
            <p:cNvSpPr>
              <a:spLocks/>
            </p:cNvSpPr>
            <p:nvPr/>
          </p:nvSpPr>
          <p:spPr bwMode="auto">
            <a:xfrm>
              <a:off x="4941093" y="2793415"/>
              <a:ext cx="723900" cy="852488"/>
            </a:xfrm>
            <a:custGeom>
              <a:avLst/>
              <a:gdLst>
                <a:gd name="G0" fmla="+- 21600 0 0"/>
                <a:gd name="G1" fmla="+- 21550 0 0"/>
                <a:gd name="G2" fmla="+- 21600 0 0"/>
                <a:gd name="T0" fmla="*/ 342 w 21600"/>
                <a:gd name="T1" fmla="*/ 25377 h 25377"/>
                <a:gd name="T2" fmla="*/ 20132 w 21600"/>
                <a:gd name="T3" fmla="*/ 0 h 25377"/>
                <a:gd name="T4" fmla="*/ 21600 w 21600"/>
                <a:gd name="T5" fmla="*/ 21550 h 253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00" h="25377" fill="none" extrusionOk="0">
                  <a:moveTo>
                    <a:pt x="341" y="25377"/>
                  </a:moveTo>
                  <a:cubicBezTo>
                    <a:pt x="114" y="24114"/>
                    <a:pt x="0" y="22833"/>
                    <a:pt x="0" y="21550"/>
                  </a:cubicBezTo>
                  <a:cubicBezTo>
                    <a:pt x="-1" y="10190"/>
                    <a:pt x="8798" y="771"/>
                    <a:pt x="20131" y="-1"/>
                  </a:cubicBezTo>
                </a:path>
                <a:path w="21600" h="25377" stroke="0" extrusionOk="0">
                  <a:moveTo>
                    <a:pt x="341" y="25377"/>
                  </a:moveTo>
                  <a:cubicBezTo>
                    <a:pt x="114" y="24114"/>
                    <a:pt x="0" y="22833"/>
                    <a:pt x="0" y="21550"/>
                  </a:cubicBezTo>
                  <a:cubicBezTo>
                    <a:pt x="-1" y="10190"/>
                    <a:pt x="8798" y="771"/>
                    <a:pt x="20131" y="-1"/>
                  </a:cubicBezTo>
                  <a:lnTo>
                    <a:pt x="21600" y="2155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2" name="Line 175"/>
            <p:cNvSpPr>
              <a:spLocks noChangeShapeType="1"/>
            </p:cNvSpPr>
            <p:nvPr/>
          </p:nvSpPr>
          <p:spPr bwMode="auto">
            <a:xfrm flipH="1">
              <a:off x="4890293" y="3645903"/>
              <a:ext cx="61913" cy="111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" name="Line 177"/>
            <p:cNvSpPr>
              <a:spLocks noChangeShapeType="1"/>
            </p:cNvSpPr>
            <p:nvPr/>
          </p:nvSpPr>
          <p:spPr bwMode="auto">
            <a:xfrm flipV="1">
              <a:off x="4901406" y="3014078"/>
              <a:ext cx="161925" cy="33338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" name="Rectangle 178"/>
            <p:cNvSpPr>
              <a:spLocks noChangeArrowheads="1"/>
            </p:cNvSpPr>
            <p:nvPr/>
          </p:nvSpPr>
          <p:spPr bwMode="auto">
            <a:xfrm flipH="1">
              <a:off x="4632771" y="2978944"/>
              <a:ext cx="2446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err="1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Arial" pitchFamily="34" charset="0"/>
                  <a:cs typeface="Arial" pitchFamily="34" charset="0"/>
                </a:rPr>
                <a:t>ori</a:t>
              </a:r>
              <a:endParaRPr kumimoji="0" lang="en-US" altLang="en-US" sz="20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" name="Freeform 179"/>
            <p:cNvSpPr>
              <a:spLocks/>
            </p:cNvSpPr>
            <p:nvPr/>
          </p:nvSpPr>
          <p:spPr bwMode="auto">
            <a:xfrm>
              <a:off x="6358731" y="3331578"/>
              <a:ext cx="109538" cy="60325"/>
            </a:xfrm>
            <a:custGeom>
              <a:avLst/>
              <a:gdLst>
                <a:gd name="T0" fmla="*/ 0 w 69"/>
                <a:gd name="T1" fmla="*/ 28 h 38"/>
                <a:gd name="T2" fmla="*/ 39 w 69"/>
                <a:gd name="T3" fmla="*/ 38 h 38"/>
                <a:gd name="T4" fmla="*/ 69 w 69"/>
                <a:gd name="T5" fmla="*/ 14 h 38"/>
                <a:gd name="T6" fmla="*/ 55 w 69"/>
                <a:gd name="T7" fmla="*/ 17 h 38"/>
                <a:gd name="T8" fmla="*/ 50 w 69"/>
                <a:gd name="T9" fmla="*/ 0 h 38"/>
                <a:gd name="T10" fmla="*/ 11 w 69"/>
                <a:gd name="T11" fmla="*/ 9 h 38"/>
                <a:gd name="T12" fmla="*/ 16 w 69"/>
                <a:gd name="T13" fmla="*/ 26 h 38"/>
                <a:gd name="T14" fmla="*/ 0 w 69"/>
                <a:gd name="T15" fmla="*/ 28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9" h="38">
                  <a:moveTo>
                    <a:pt x="0" y="28"/>
                  </a:moveTo>
                  <a:lnTo>
                    <a:pt x="39" y="38"/>
                  </a:lnTo>
                  <a:lnTo>
                    <a:pt x="69" y="14"/>
                  </a:lnTo>
                  <a:lnTo>
                    <a:pt x="55" y="17"/>
                  </a:lnTo>
                  <a:lnTo>
                    <a:pt x="50" y="0"/>
                  </a:lnTo>
                  <a:lnTo>
                    <a:pt x="11" y="9"/>
                  </a:lnTo>
                  <a:lnTo>
                    <a:pt x="16" y="26"/>
                  </a:lnTo>
                  <a:lnTo>
                    <a:pt x="0" y="28"/>
                  </a:lnTo>
                  <a:close/>
                </a:path>
              </a:pathLst>
            </a:custGeom>
            <a:solidFill>
              <a:srgbClr val="C04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" name="Arc 180"/>
            <p:cNvSpPr>
              <a:spLocks/>
            </p:cNvSpPr>
            <p:nvPr/>
          </p:nvSpPr>
          <p:spPr bwMode="auto">
            <a:xfrm>
              <a:off x="5664993" y="3333165"/>
              <a:ext cx="771525" cy="184150"/>
            </a:xfrm>
            <a:custGeom>
              <a:avLst/>
              <a:gdLst>
                <a:gd name="G0" fmla="+- 0 0 0"/>
                <a:gd name="G1" fmla="+- 5046 0 0"/>
                <a:gd name="G2" fmla="+- 21600 0 0"/>
                <a:gd name="T0" fmla="*/ 21002 w 21167"/>
                <a:gd name="T1" fmla="*/ 0 h 5046"/>
                <a:gd name="T2" fmla="*/ 21167 w 21167"/>
                <a:gd name="T3" fmla="*/ 744 h 5046"/>
                <a:gd name="T4" fmla="*/ 0 w 21167"/>
                <a:gd name="T5" fmla="*/ 5046 h 50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167" h="5046" fill="none" extrusionOk="0">
                  <a:moveTo>
                    <a:pt x="21002" y="-1"/>
                  </a:moveTo>
                  <a:cubicBezTo>
                    <a:pt x="21061" y="246"/>
                    <a:pt x="21116" y="494"/>
                    <a:pt x="21167" y="743"/>
                  </a:cubicBezTo>
                </a:path>
                <a:path w="21167" h="5046" stroke="0" extrusionOk="0">
                  <a:moveTo>
                    <a:pt x="21002" y="-1"/>
                  </a:moveTo>
                  <a:cubicBezTo>
                    <a:pt x="21061" y="246"/>
                    <a:pt x="21116" y="494"/>
                    <a:pt x="21167" y="743"/>
                  </a:cubicBezTo>
                  <a:lnTo>
                    <a:pt x="0" y="504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" name="Arc 181"/>
            <p:cNvSpPr>
              <a:spLocks/>
            </p:cNvSpPr>
            <p:nvPr/>
          </p:nvSpPr>
          <p:spPr bwMode="auto">
            <a:xfrm>
              <a:off x="5664993" y="3347453"/>
              <a:ext cx="709613" cy="169863"/>
            </a:xfrm>
            <a:custGeom>
              <a:avLst/>
              <a:gdLst>
                <a:gd name="G0" fmla="+- 0 0 0"/>
                <a:gd name="G1" fmla="+- 5052 0 0"/>
                <a:gd name="G2" fmla="+- 21600 0 0"/>
                <a:gd name="T0" fmla="*/ 21001 w 21179"/>
                <a:gd name="T1" fmla="*/ 0 h 5052"/>
                <a:gd name="T2" fmla="*/ 21179 w 21179"/>
                <a:gd name="T3" fmla="*/ 807 h 5052"/>
                <a:gd name="T4" fmla="*/ 0 w 21179"/>
                <a:gd name="T5" fmla="*/ 5052 h 50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179" h="5052" fill="none" extrusionOk="0">
                  <a:moveTo>
                    <a:pt x="21000" y="0"/>
                  </a:moveTo>
                  <a:cubicBezTo>
                    <a:pt x="21065" y="267"/>
                    <a:pt x="21124" y="536"/>
                    <a:pt x="21178" y="807"/>
                  </a:cubicBezTo>
                </a:path>
                <a:path w="21179" h="5052" stroke="0" extrusionOk="0">
                  <a:moveTo>
                    <a:pt x="21000" y="0"/>
                  </a:moveTo>
                  <a:cubicBezTo>
                    <a:pt x="21065" y="267"/>
                    <a:pt x="21124" y="536"/>
                    <a:pt x="21178" y="807"/>
                  </a:cubicBezTo>
                  <a:lnTo>
                    <a:pt x="0" y="5052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" name="Line 182"/>
            <p:cNvSpPr>
              <a:spLocks noChangeShapeType="1"/>
            </p:cNvSpPr>
            <p:nvPr/>
          </p:nvSpPr>
          <p:spPr bwMode="auto">
            <a:xfrm flipV="1">
              <a:off x="6376193" y="3331578"/>
              <a:ext cx="61913" cy="14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" name="Freeform 183"/>
            <p:cNvSpPr>
              <a:spLocks/>
            </p:cNvSpPr>
            <p:nvPr/>
          </p:nvSpPr>
          <p:spPr bwMode="auto">
            <a:xfrm>
              <a:off x="6358731" y="3353803"/>
              <a:ext cx="109538" cy="38100"/>
            </a:xfrm>
            <a:custGeom>
              <a:avLst/>
              <a:gdLst>
                <a:gd name="T0" fmla="*/ 14 w 61"/>
                <a:gd name="T1" fmla="*/ 10 h 21"/>
                <a:gd name="T2" fmla="*/ 0 w 61"/>
                <a:gd name="T3" fmla="*/ 12 h 21"/>
                <a:gd name="T4" fmla="*/ 34 w 61"/>
                <a:gd name="T5" fmla="*/ 21 h 21"/>
                <a:gd name="T6" fmla="*/ 61 w 61"/>
                <a:gd name="T7" fmla="*/ 0 h 21"/>
                <a:gd name="T8" fmla="*/ 48 w 61"/>
                <a:gd name="T9" fmla="*/ 2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1" h="21">
                  <a:moveTo>
                    <a:pt x="14" y="10"/>
                  </a:moveTo>
                  <a:lnTo>
                    <a:pt x="0" y="12"/>
                  </a:lnTo>
                  <a:lnTo>
                    <a:pt x="34" y="21"/>
                  </a:lnTo>
                  <a:lnTo>
                    <a:pt x="61" y="0"/>
                  </a:lnTo>
                  <a:lnTo>
                    <a:pt x="48" y="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1" name="Line 184"/>
            <p:cNvSpPr>
              <a:spLocks noChangeShapeType="1"/>
            </p:cNvSpPr>
            <p:nvPr/>
          </p:nvSpPr>
          <p:spPr bwMode="auto">
            <a:xfrm flipH="1">
              <a:off x="6446043" y="3334753"/>
              <a:ext cx="131763" cy="23813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2" name="Rectangle 185"/>
            <p:cNvSpPr>
              <a:spLocks noChangeArrowheads="1"/>
            </p:cNvSpPr>
            <p:nvPr/>
          </p:nvSpPr>
          <p:spPr bwMode="auto">
            <a:xfrm>
              <a:off x="6584156" y="3328403"/>
              <a:ext cx="38472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err="1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Arial" pitchFamily="34" charset="0"/>
                  <a:cs typeface="Arial" pitchFamily="34" charset="0"/>
                </a:rPr>
                <a:t>sgRNA</a:t>
              </a:r>
              <a:endParaRPr kumimoji="0" lang="en-US" alt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" name="Freeform 186"/>
            <p:cNvSpPr>
              <a:spLocks/>
            </p:cNvSpPr>
            <p:nvPr/>
          </p:nvSpPr>
          <p:spPr bwMode="auto">
            <a:xfrm>
              <a:off x="6187281" y="2964865"/>
              <a:ext cx="260350" cy="369888"/>
            </a:xfrm>
            <a:custGeom>
              <a:avLst/>
              <a:gdLst>
                <a:gd name="T0" fmla="*/ 96 w 164"/>
                <a:gd name="T1" fmla="*/ 214 h 233"/>
                <a:gd name="T2" fmla="*/ 139 w 164"/>
                <a:gd name="T3" fmla="*/ 233 h 233"/>
                <a:gd name="T4" fmla="*/ 164 w 164"/>
                <a:gd name="T5" fmla="*/ 192 h 233"/>
                <a:gd name="T6" fmla="*/ 149 w 164"/>
                <a:gd name="T7" fmla="*/ 197 h 233"/>
                <a:gd name="T8" fmla="*/ 133 w 164"/>
                <a:gd name="T9" fmla="*/ 155 h 233"/>
                <a:gd name="T10" fmla="*/ 114 w 164"/>
                <a:gd name="T11" fmla="*/ 115 h 233"/>
                <a:gd name="T12" fmla="*/ 91 w 164"/>
                <a:gd name="T13" fmla="*/ 76 h 233"/>
                <a:gd name="T14" fmla="*/ 65 w 164"/>
                <a:gd name="T15" fmla="*/ 40 h 233"/>
                <a:gd name="T16" fmla="*/ 36 w 164"/>
                <a:gd name="T17" fmla="*/ 7 h 233"/>
                <a:gd name="T18" fmla="*/ 29 w 164"/>
                <a:gd name="T19" fmla="*/ 0 h 233"/>
                <a:gd name="T20" fmla="*/ 0 w 164"/>
                <a:gd name="T21" fmla="*/ 27 h 233"/>
                <a:gd name="T22" fmla="*/ 29 w 164"/>
                <a:gd name="T23" fmla="*/ 58 h 233"/>
                <a:gd name="T24" fmla="*/ 54 w 164"/>
                <a:gd name="T25" fmla="*/ 91 h 233"/>
                <a:gd name="T26" fmla="*/ 75 w 164"/>
                <a:gd name="T27" fmla="*/ 126 h 233"/>
                <a:gd name="T28" fmla="*/ 93 w 164"/>
                <a:gd name="T29" fmla="*/ 162 h 233"/>
                <a:gd name="T30" fmla="*/ 108 w 164"/>
                <a:gd name="T31" fmla="*/ 201 h 233"/>
                <a:gd name="T32" fmla="*/ 112 w 164"/>
                <a:gd name="T33" fmla="*/ 209 h 233"/>
                <a:gd name="T34" fmla="*/ 96 w 164"/>
                <a:gd name="T35" fmla="*/ 214 h 2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4" h="233">
                  <a:moveTo>
                    <a:pt x="96" y="214"/>
                  </a:moveTo>
                  <a:lnTo>
                    <a:pt x="139" y="233"/>
                  </a:lnTo>
                  <a:lnTo>
                    <a:pt x="164" y="192"/>
                  </a:lnTo>
                  <a:lnTo>
                    <a:pt x="149" y="197"/>
                  </a:lnTo>
                  <a:lnTo>
                    <a:pt x="133" y="155"/>
                  </a:lnTo>
                  <a:lnTo>
                    <a:pt x="114" y="115"/>
                  </a:lnTo>
                  <a:lnTo>
                    <a:pt x="91" y="76"/>
                  </a:lnTo>
                  <a:lnTo>
                    <a:pt x="65" y="40"/>
                  </a:lnTo>
                  <a:lnTo>
                    <a:pt x="36" y="7"/>
                  </a:lnTo>
                  <a:lnTo>
                    <a:pt x="29" y="0"/>
                  </a:lnTo>
                  <a:lnTo>
                    <a:pt x="0" y="27"/>
                  </a:lnTo>
                  <a:lnTo>
                    <a:pt x="29" y="58"/>
                  </a:lnTo>
                  <a:lnTo>
                    <a:pt x="54" y="91"/>
                  </a:lnTo>
                  <a:lnTo>
                    <a:pt x="75" y="126"/>
                  </a:lnTo>
                  <a:lnTo>
                    <a:pt x="93" y="162"/>
                  </a:lnTo>
                  <a:lnTo>
                    <a:pt x="108" y="201"/>
                  </a:lnTo>
                  <a:lnTo>
                    <a:pt x="112" y="209"/>
                  </a:lnTo>
                  <a:lnTo>
                    <a:pt x="96" y="214"/>
                  </a:lnTo>
                  <a:close/>
                </a:path>
              </a:pathLst>
            </a:custGeom>
            <a:pattFill prst="openDmnd">
              <a:fgClr>
                <a:srgbClr val="000080"/>
              </a:fgClr>
              <a:bgClr>
                <a:srgbClr val="FFFFFF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48" name="Arc 187"/>
            <p:cNvSpPr>
              <a:spLocks/>
            </p:cNvSpPr>
            <p:nvPr/>
          </p:nvSpPr>
          <p:spPr bwMode="auto">
            <a:xfrm>
              <a:off x="5664993" y="2968040"/>
              <a:ext cx="750888" cy="549275"/>
            </a:xfrm>
            <a:custGeom>
              <a:avLst/>
              <a:gdLst>
                <a:gd name="G0" fmla="+- 0 0 0"/>
                <a:gd name="G1" fmla="+- 15056 0 0"/>
                <a:gd name="G2" fmla="+- 21600 0 0"/>
                <a:gd name="T0" fmla="*/ 15488 w 20597"/>
                <a:gd name="T1" fmla="*/ 0 h 15056"/>
                <a:gd name="T2" fmla="*/ 20597 w 20597"/>
                <a:gd name="T3" fmla="*/ 8549 h 15056"/>
                <a:gd name="T4" fmla="*/ 0 w 20597"/>
                <a:gd name="T5" fmla="*/ 15056 h 150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97" h="15056" fill="none" extrusionOk="0">
                  <a:moveTo>
                    <a:pt x="15487" y="0"/>
                  </a:moveTo>
                  <a:cubicBezTo>
                    <a:pt x="17833" y="2412"/>
                    <a:pt x="19582" y="5340"/>
                    <a:pt x="20596" y="8549"/>
                  </a:cubicBezTo>
                </a:path>
                <a:path w="20597" h="15056" stroke="0" extrusionOk="0">
                  <a:moveTo>
                    <a:pt x="15487" y="0"/>
                  </a:moveTo>
                  <a:cubicBezTo>
                    <a:pt x="17833" y="2412"/>
                    <a:pt x="19582" y="5340"/>
                    <a:pt x="20596" y="8549"/>
                  </a:cubicBezTo>
                  <a:lnTo>
                    <a:pt x="0" y="1505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49" name="Arc 188"/>
            <p:cNvSpPr>
              <a:spLocks/>
            </p:cNvSpPr>
            <p:nvPr/>
          </p:nvSpPr>
          <p:spPr bwMode="auto">
            <a:xfrm>
              <a:off x="5664993" y="3010903"/>
              <a:ext cx="690563" cy="506413"/>
            </a:xfrm>
            <a:custGeom>
              <a:avLst/>
              <a:gdLst>
                <a:gd name="G0" fmla="+- 0 0 0"/>
                <a:gd name="G1" fmla="+- 15067 0 0"/>
                <a:gd name="G2" fmla="+- 21600 0 0"/>
                <a:gd name="T0" fmla="*/ 15477 w 20605"/>
                <a:gd name="T1" fmla="*/ 0 h 15067"/>
                <a:gd name="T2" fmla="*/ 20605 w 20605"/>
                <a:gd name="T3" fmla="*/ 8587 h 15067"/>
                <a:gd name="T4" fmla="*/ 0 w 20605"/>
                <a:gd name="T5" fmla="*/ 15067 h 150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605" h="15067" fill="none" extrusionOk="0">
                  <a:moveTo>
                    <a:pt x="15477" y="-1"/>
                  </a:moveTo>
                  <a:cubicBezTo>
                    <a:pt x="17834" y="2421"/>
                    <a:pt x="19591" y="5362"/>
                    <a:pt x="20605" y="8586"/>
                  </a:cubicBezTo>
                </a:path>
                <a:path w="20605" h="15067" stroke="0" extrusionOk="0">
                  <a:moveTo>
                    <a:pt x="15477" y="-1"/>
                  </a:moveTo>
                  <a:cubicBezTo>
                    <a:pt x="17834" y="2421"/>
                    <a:pt x="19591" y="5362"/>
                    <a:pt x="20605" y="8586"/>
                  </a:cubicBezTo>
                  <a:lnTo>
                    <a:pt x="0" y="1506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50" name="Line 189"/>
            <p:cNvSpPr>
              <a:spLocks noChangeShapeType="1"/>
            </p:cNvSpPr>
            <p:nvPr/>
          </p:nvSpPr>
          <p:spPr bwMode="auto">
            <a:xfrm flipV="1">
              <a:off x="6187281" y="2964865"/>
              <a:ext cx="46038" cy="428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51" name="Freeform 190"/>
            <p:cNvSpPr>
              <a:spLocks/>
            </p:cNvSpPr>
            <p:nvPr/>
          </p:nvSpPr>
          <p:spPr bwMode="auto">
            <a:xfrm>
              <a:off x="6339681" y="3269665"/>
              <a:ext cx="107950" cy="65088"/>
            </a:xfrm>
            <a:custGeom>
              <a:avLst/>
              <a:gdLst>
                <a:gd name="T0" fmla="*/ 14 w 60"/>
                <a:gd name="T1" fmla="*/ 15 h 36"/>
                <a:gd name="T2" fmla="*/ 0 w 60"/>
                <a:gd name="T3" fmla="*/ 19 h 36"/>
                <a:gd name="T4" fmla="*/ 38 w 60"/>
                <a:gd name="T5" fmla="*/ 36 h 36"/>
                <a:gd name="T6" fmla="*/ 60 w 60"/>
                <a:gd name="T7" fmla="*/ 0 h 36"/>
                <a:gd name="T8" fmla="*/ 47 w 60"/>
                <a:gd name="T9" fmla="*/ 4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0" h="36">
                  <a:moveTo>
                    <a:pt x="14" y="15"/>
                  </a:moveTo>
                  <a:lnTo>
                    <a:pt x="0" y="19"/>
                  </a:lnTo>
                  <a:lnTo>
                    <a:pt x="38" y="36"/>
                  </a:lnTo>
                  <a:lnTo>
                    <a:pt x="60" y="0"/>
                  </a:lnTo>
                  <a:lnTo>
                    <a:pt x="47" y="4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52" name="Line 191"/>
            <p:cNvSpPr>
              <a:spLocks noChangeShapeType="1"/>
            </p:cNvSpPr>
            <p:nvPr/>
          </p:nvSpPr>
          <p:spPr bwMode="auto">
            <a:xfrm flipH="1">
              <a:off x="6358730" y="3058318"/>
              <a:ext cx="117475" cy="74821"/>
            </a:xfrm>
            <a:prstGeom prst="line">
              <a:avLst/>
            </a:prstGeom>
            <a:noFill/>
            <a:ln w="0">
              <a:solidFill>
                <a:srgbClr val="C0804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53" name="Rectangle 192"/>
            <p:cNvSpPr>
              <a:spLocks noChangeArrowheads="1"/>
            </p:cNvSpPr>
            <p:nvPr/>
          </p:nvSpPr>
          <p:spPr bwMode="auto">
            <a:xfrm>
              <a:off x="6480968" y="2960132"/>
              <a:ext cx="1635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Arial" pitchFamily="34" charset="0"/>
                  <a:cs typeface="Arial" pitchFamily="34" charset="0"/>
                </a:rPr>
                <a:t>U6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169" name="TextBox 5168"/>
          <p:cNvSpPr txBox="1"/>
          <p:nvPr/>
        </p:nvSpPr>
        <p:spPr>
          <a:xfrm>
            <a:off x="4114366" y="3790047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</a:t>
            </a:r>
            <a:endParaRPr lang="en-US" dirty="0"/>
          </a:p>
        </p:txBody>
      </p:sp>
      <p:grpSp>
        <p:nvGrpSpPr>
          <p:cNvPr id="40" name="Group 39"/>
          <p:cNvGrpSpPr/>
          <p:nvPr/>
        </p:nvGrpSpPr>
        <p:grpSpPr>
          <a:xfrm>
            <a:off x="941415" y="2051906"/>
            <a:ext cx="5662396" cy="1119919"/>
            <a:chOff x="941415" y="2051906"/>
            <a:chExt cx="5662396" cy="1119919"/>
          </a:xfrm>
        </p:grpSpPr>
        <p:sp>
          <p:nvSpPr>
            <p:cNvPr id="143" name="Rectangle 106"/>
            <p:cNvSpPr>
              <a:spLocks noChangeArrowheads="1"/>
            </p:cNvSpPr>
            <p:nvPr/>
          </p:nvSpPr>
          <p:spPr bwMode="auto">
            <a:xfrm>
              <a:off x="979530" y="2989347"/>
              <a:ext cx="10164" cy="43446"/>
            </a:xfrm>
            <a:prstGeom prst="rect">
              <a:avLst/>
            </a:prstGeom>
            <a:solidFill>
              <a:srgbClr val="FFFFCC"/>
            </a:solidFill>
            <a:ln w="0">
              <a:solidFill>
                <a:srgbClr val="CCCC99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144" name="Rectangle 107"/>
            <p:cNvSpPr>
              <a:spLocks noChangeArrowheads="1"/>
            </p:cNvSpPr>
            <p:nvPr/>
          </p:nvSpPr>
          <p:spPr bwMode="auto">
            <a:xfrm>
              <a:off x="989694" y="2989347"/>
              <a:ext cx="5066693" cy="43446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145" name="Line 111"/>
            <p:cNvSpPr>
              <a:spLocks noChangeShapeType="1"/>
            </p:cNvSpPr>
            <p:nvPr/>
          </p:nvSpPr>
          <p:spPr bwMode="auto">
            <a:xfrm flipH="1">
              <a:off x="4877377" y="2593080"/>
              <a:ext cx="40656" cy="3325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46" name="Rectangle 112"/>
            <p:cNvSpPr>
              <a:spLocks noChangeArrowheads="1"/>
            </p:cNvSpPr>
            <p:nvPr/>
          </p:nvSpPr>
          <p:spPr bwMode="auto">
            <a:xfrm>
              <a:off x="4781433" y="2283019"/>
              <a:ext cx="436018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/>
                <a:t>Neo</a:t>
              </a:r>
              <a:endParaRPr lang="en-US" altLang="en-US" sz="2000" b="1" dirty="0"/>
            </a:p>
          </p:txBody>
        </p:sp>
        <p:sp>
          <p:nvSpPr>
            <p:cNvPr id="147" name="Line 114"/>
            <p:cNvSpPr>
              <a:spLocks noChangeShapeType="1"/>
            </p:cNvSpPr>
            <p:nvPr/>
          </p:nvSpPr>
          <p:spPr bwMode="auto">
            <a:xfrm flipH="1">
              <a:off x="3320222" y="2763421"/>
              <a:ext cx="2542" cy="1853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48" name="Rectangle 115"/>
            <p:cNvSpPr>
              <a:spLocks noChangeArrowheads="1"/>
            </p:cNvSpPr>
            <p:nvPr/>
          </p:nvSpPr>
          <p:spPr bwMode="auto">
            <a:xfrm>
              <a:off x="3016491" y="2393025"/>
              <a:ext cx="67326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err="1" smtClean="0"/>
                <a:t>ChVlig</a:t>
              </a:r>
              <a:endParaRPr lang="en-US" altLang="en-US" sz="2000" b="1" dirty="0"/>
            </a:p>
          </p:txBody>
        </p:sp>
        <p:sp>
          <p:nvSpPr>
            <p:cNvPr id="149" name="Line 117"/>
            <p:cNvSpPr>
              <a:spLocks noChangeShapeType="1"/>
            </p:cNvSpPr>
            <p:nvPr/>
          </p:nvSpPr>
          <p:spPr bwMode="auto">
            <a:xfrm>
              <a:off x="1248873" y="2714180"/>
              <a:ext cx="94015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50" name="Rectangle 118"/>
            <p:cNvSpPr>
              <a:spLocks noChangeArrowheads="1"/>
            </p:cNvSpPr>
            <p:nvPr/>
          </p:nvSpPr>
          <p:spPr bwMode="auto">
            <a:xfrm>
              <a:off x="941415" y="2485358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</a:rPr>
                <a:t>LTR</a:t>
              </a:r>
              <a:endParaRPr lang="en-US" altLang="en-US" sz="3200"/>
            </a:p>
          </p:txBody>
        </p:sp>
        <p:sp>
          <p:nvSpPr>
            <p:cNvPr id="151" name="Line 120"/>
            <p:cNvSpPr>
              <a:spLocks noChangeShapeType="1"/>
            </p:cNvSpPr>
            <p:nvPr/>
          </p:nvSpPr>
          <p:spPr bwMode="auto">
            <a:xfrm flipH="1">
              <a:off x="6271150" y="2714180"/>
              <a:ext cx="71147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52" name="Rectangle 121"/>
            <p:cNvSpPr>
              <a:spLocks noChangeArrowheads="1"/>
            </p:cNvSpPr>
            <p:nvPr/>
          </p:nvSpPr>
          <p:spPr bwMode="auto">
            <a:xfrm>
              <a:off x="6352461" y="2485358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>
                  <a:solidFill>
                    <a:srgbClr val="000000"/>
                  </a:solidFill>
                </a:rPr>
                <a:t>LTR</a:t>
              </a:r>
              <a:endParaRPr lang="en-US" altLang="en-US" sz="3200" dirty="0"/>
            </a:p>
          </p:txBody>
        </p:sp>
        <p:sp>
          <p:nvSpPr>
            <p:cNvPr id="153" name="Line 144"/>
            <p:cNvSpPr>
              <a:spLocks noChangeShapeType="1"/>
            </p:cNvSpPr>
            <p:nvPr/>
          </p:nvSpPr>
          <p:spPr bwMode="auto">
            <a:xfrm>
              <a:off x="2069605" y="2653355"/>
              <a:ext cx="43197" cy="27227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54" name="Rectangle 145"/>
            <p:cNvSpPr>
              <a:spLocks noChangeArrowheads="1"/>
            </p:cNvSpPr>
            <p:nvPr/>
          </p:nvSpPr>
          <p:spPr bwMode="auto">
            <a:xfrm>
              <a:off x="1790168" y="2227196"/>
              <a:ext cx="584423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>
                  <a:solidFill>
                    <a:srgbClr val="000000"/>
                  </a:solidFill>
                </a:rPr>
                <a:t>Gag</a:t>
              </a:r>
              <a:endParaRPr lang="en-US" altLang="en-US" sz="4400" dirty="0"/>
            </a:p>
          </p:txBody>
        </p:sp>
        <p:sp>
          <p:nvSpPr>
            <p:cNvPr id="155" name="Line 150"/>
            <p:cNvSpPr>
              <a:spLocks noChangeShapeType="1"/>
            </p:cNvSpPr>
            <p:nvPr/>
          </p:nvSpPr>
          <p:spPr bwMode="auto">
            <a:xfrm flipH="1">
              <a:off x="4285331" y="2432556"/>
              <a:ext cx="14855" cy="4930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56" name="Rectangle 151"/>
            <p:cNvSpPr>
              <a:spLocks noChangeArrowheads="1"/>
            </p:cNvSpPr>
            <p:nvPr/>
          </p:nvSpPr>
          <p:spPr bwMode="auto">
            <a:xfrm>
              <a:off x="4114366" y="2192010"/>
              <a:ext cx="3204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 smtClean="0">
                  <a:solidFill>
                    <a:srgbClr val="000000"/>
                  </a:solidFill>
                </a:rPr>
                <a:t>IRES</a:t>
              </a:r>
              <a:endParaRPr lang="en-US" altLang="en-US" sz="3200" baseline="-25000" dirty="0"/>
            </a:p>
          </p:txBody>
        </p:sp>
        <p:sp>
          <p:nvSpPr>
            <p:cNvPr id="157" name="Freeform 110" descr="Wide downward diagonal"/>
            <p:cNvSpPr>
              <a:spLocks/>
            </p:cNvSpPr>
            <p:nvPr/>
          </p:nvSpPr>
          <p:spPr bwMode="auto">
            <a:xfrm>
              <a:off x="4564837" y="2856109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wdDnDiag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58" name="Freeform 113" descr="5%"/>
            <p:cNvSpPr>
              <a:spLocks/>
            </p:cNvSpPr>
            <p:nvPr/>
          </p:nvSpPr>
          <p:spPr bwMode="auto">
            <a:xfrm>
              <a:off x="2621165" y="2856109"/>
              <a:ext cx="1374496" cy="307336"/>
            </a:xfrm>
            <a:custGeom>
              <a:avLst/>
              <a:gdLst>
                <a:gd name="T0" fmla="*/ 617436824 w 293"/>
                <a:gd name="T1" fmla="*/ 269655131 h 107"/>
                <a:gd name="T2" fmla="*/ 738404194 w 293"/>
                <a:gd name="T3" fmla="*/ 133567094 h 107"/>
                <a:gd name="T4" fmla="*/ 617436824 w 293"/>
                <a:gd name="T5" fmla="*/ 0 h 107"/>
                <a:gd name="T6" fmla="*/ 617436824 w 293"/>
                <a:gd name="T7" fmla="*/ 60483572 h 107"/>
                <a:gd name="T8" fmla="*/ 0 w 293"/>
                <a:gd name="T9" fmla="*/ 60483572 h 107"/>
                <a:gd name="T10" fmla="*/ 0 w 293"/>
                <a:gd name="T11" fmla="*/ 209171559 h 107"/>
                <a:gd name="T12" fmla="*/ 617436824 w 293"/>
                <a:gd name="T13" fmla="*/ 209171559 h 107"/>
                <a:gd name="T14" fmla="*/ 617436824 w 293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93"/>
                <a:gd name="T25" fmla="*/ 0 h 107"/>
                <a:gd name="T26" fmla="*/ 293 w 293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93" h="107">
                  <a:moveTo>
                    <a:pt x="245" y="107"/>
                  </a:moveTo>
                  <a:lnTo>
                    <a:pt x="293" y="53"/>
                  </a:lnTo>
                  <a:lnTo>
                    <a:pt x="245" y="0"/>
                  </a:lnTo>
                  <a:lnTo>
                    <a:pt x="245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45" y="83"/>
                  </a:lnTo>
                  <a:lnTo>
                    <a:pt x="245" y="107"/>
                  </a:lnTo>
                  <a:close/>
                </a:path>
              </a:pathLst>
            </a:custGeom>
            <a:pattFill prst="lgGrid">
              <a:fgClr>
                <a:schemeClr val="tx1"/>
              </a:fgClr>
              <a:bgClr>
                <a:schemeClr val="bg1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59" name="Freeform 116" descr="Small grid"/>
            <p:cNvSpPr>
              <a:spLocks/>
            </p:cNvSpPr>
            <p:nvPr/>
          </p:nvSpPr>
          <p:spPr bwMode="auto">
            <a:xfrm>
              <a:off x="961743" y="2861902"/>
              <a:ext cx="701308" cy="309923"/>
            </a:xfrm>
            <a:custGeom>
              <a:avLst/>
              <a:gdLst>
                <a:gd name="T0" fmla="*/ 574595625 w 276"/>
                <a:gd name="T1" fmla="*/ 269655131 h 107"/>
                <a:gd name="T2" fmla="*/ 695563125 w 276"/>
                <a:gd name="T3" fmla="*/ 133567094 h 107"/>
                <a:gd name="T4" fmla="*/ 574595625 w 276"/>
                <a:gd name="T5" fmla="*/ 0 h 107"/>
                <a:gd name="T6" fmla="*/ 574595625 w 276"/>
                <a:gd name="T7" fmla="*/ 60483572 h 107"/>
                <a:gd name="T8" fmla="*/ 0 w 276"/>
                <a:gd name="T9" fmla="*/ 60483572 h 107"/>
                <a:gd name="T10" fmla="*/ 0 w 276"/>
                <a:gd name="T11" fmla="*/ 209171559 h 107"/>
                <a:gd name="T12" fmla="*/ 574595625 w 276"/>
                <a:gd name="T13" fmla="*/ 209171559 h 107"/>
                <a:gd name="T14" fmla="*/ 574595625 w 27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76"/>
                <a:gd name="T25" fmla="*/ 0 h 107"/>
                <a:gd name="T26" fmla="*/ 276 w 27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76" h="107">
                  <a:moveTo>
                    <a:pt x="228" y="107"/>
                  </a:moveTo>
                  <a:lnTo>
                    <a:pt x="276" y="53"/>
                  </a:lnTo>
                  <a:lnTo>
                    <a:pt x="228" y="0"/>
                  </a:lnTo>
                  <a:lnTo>
                    <a:pt x="228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28" y="83"/>
                  </a:lnTo>
                  <a:lnTo>
                    <a:pt x="228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60" name="Freeform 119" descr="Small grid"/>
            <p:cNvSpPr>
              <a:spLocks/>
            </p:cNvSpPr>
            <p:nvPr/>
          </p:nvSpPr>
          <p:spPr bwMode="auto">
            <a:xfrm>
              <a:off x="5881230" y="2856109"/>
              <a:ext cx="714013" cy="309923"/>
            </a:xfrm>
            <a:custGeom>
              <a:avLst/>
              <a:gdLst>
                <a:gd name="T0" fmla="*/ 589717223 w 281"/>
                <a:gd name="T1" fmla="*/ 269655131 h 107"/>
                <a:gd name="T2" fmla="*/ 708165494 w 281"/>
                <a:gd name="T3" fmla="*/ 133567094 h 107"/>
                <a:gd name="T4" fmla="*/ 589717223 w 281"/>
                <a:gd name="T5" fmla="*/ 0 h 107"/>
                <a:gd name="T6" fmla="*/ 589717223 w 281"/>
                <a:gd name="T7" fmla="*/ 60483572 h 107"/>
                <a:gd name="T8" fmla="*/ 0 w 281"/>
                <a:gd name="T9" fmla="*/ 60483572 h 107"/>
                <a:gd name="T10" fmla="*/ 0 w 281"/>
                <a:gd name="T11" fmla="*/ 209171559 h 107"/>
                <a:gd name="T12" fmla="*/ 589717223 w 281"/>
                <a:gd name="T13" fmla="*/ 209171559 h 107"/>
                <a:gd name="T14" fmla="*/ 589717223 w 28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81"/>
                <a:gd name="T25" fmla="*/ 0 h 107"/>
                <a:gd name="T26" fmla="*/ 281 w 28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81" h="107">
                  <a:moveTo>
                    <a:pt x="234" y="107"/>
                  </a:moveTo>
                  <a:lnTo>
                    <a:pt x="281" y="53"/>
                  </a:lnTo>
                  <a:lnTo>
                    <a:pt x="234" y="0"/>
                  </a:lnTo>
                  <a:lnTo>
                    <a:pt x="234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34" y="83"/>
                  </a:lnTo>
                  <a:lnTo>
                    <a:pt x="234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61" name="Freeform 143" descr="Light vertical"/>
            <p:cNvSpPr>
              <a:spLocks/>
            </p:cNvSpPr>
            <p:nvPr/>
          </p:nvSpPr>
          <p:spPr bwMode="auto">
            <a:xfrm>
              <a:off x="1718952" y="2856109"/>
              <a:ext cx="790242" cy="309923"/>
            </a:xfrm>
            <a:custGeom>
              <a:avLst/>
              <a:gdLst>
                <a:gd name="T0" fmla="*/ 662802559 w 311"/>
                <a:gd name="T1" fmla="*/ 269655131 h 107"/>
                <a:gd name="T2" fmla="*/ 783770181 w 311"/>
                <a:gd name="T3" fmla="*/ 133567094 h 107"/>
                <a:gd name="T4" fmla="*/ 662802559 w 311"/>
                <a:gd name="T5" fmla="*/ 0 h 107"/>
                <a:gd name="T6" fmla="*/ 662802559 w 311"/>
                <a:gd name="T7" fmla="*/ 60483572 h 107"/>
                <a:gd name="T8" fmla="*/ 0 w 311"/>
                <a:gd name="T9" fmla="*/ 60483572 h 107"/>
                <a:gd name="T10" fmla="*/ 0 w 311"/>
                <a:gd name="T11" fmla="*/ 209171559 h 107"/>
                <a:gd name="T12" fmla="*/ 662802559 w 311"/>
                <a:gd name="T13" fmla="*/ 209171559 h 107"/>
                <a:gd name="T14" fmla="*/ 662802559 w 31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311"/>
                <a:gd name="T25" fmla="*/ 0 h 107"/>
                <a:gd name="T26" fmla="*/ 311 w 31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311" h="107">
                  <a:moveTo>
                    <a:pt x="263" y="107"/>
                  </a:moveTo>
                  <a:lnTo>
                    <a:pt x="311" y="53"/>
                  </a:lnTo>
                  <a:lnTo>
                    <a:pt x="263" y="0"/>
                  </a:lnTo>
                  <a:lnTo>
                    <a:pt x="263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63" y="83"/>
                  </a:lnTo>
                  <a:lnTo>
                    <a:pt x="263" y="107"/>
                  </a:lnTo>
                  <a:close/>
                </a:path>
              </a:pathLst>
            </a:custGeom>
            <a:pattFill prst="ltVert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62" name="Rectangle 161"/>
            <p:cNvSpPr/>
            <p:nvPr/>
          </p:nvSpPr>
          <p:spPr bwMode="auto">
            <a:xfrm>
              <a:off x="4075693" y="2941622"/>
              <a:ext cx="450471" cy="13889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3200"/>
            </a:p>
          </p:txBody>
        </p:sp>
        <p:sp>
          <p:nvSpPr>
            <p:cNvPr id="163" name="Freeform 110" descr="Wide downward diagonal"/>
            <p:cNvSpPr>
              <a:spLocks/>
            </p:cNvSpPr>
            <p:nvPr/>
          </p:nvSpPr>
          <p:spPr bwMode="auto">
            <a:xfrm>
              <a:off x="5224357" y="2853522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pct10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5105427" y="2051906"/>
              <a:ext cx="8226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WPRE</a:t>
              </a:r>
              <a:endParaRPr lang="en-US" sz="2000" b="1" dirty="0"/>
            </a:p>
          </p:txBody>
        </p:sp>
        <p:cxnSp>
          <p:nvCxnSpPr>
            <p:cNvPr id="165" name="Straight Connector 164"/>
            <p:cNvCxnSpPr/>
            <p:nvPr/>
          </p:nvCxnSpPr>
          <p:spPr>
            <a:xfrm flipH="1">
              <a:off x="5516239" y="2384320"/>
              <a:ext cx="9175" cy="5550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6" name="TextBox 165"/>
          <p:cNvSpPr txBox="1"/>
          <p:nvPr/>
        </p:nvSpPr>
        <p:spPr>
          <a:xfrm>
            <a:off x="389283" y="640080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1 Fig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30628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Line 114"/>
          <p:cNvSpPr>
            <a:spLocks noChangeShapeType="1"/>
          </p:cNvSpPr>
          <p:nvPr/>
        </p:nvSpPr>
        <p:spPr bwMode="auto">
          <a:xfrm flipH="1">
            <a:off x="1952148" y="1058767"/>
            <a:ext cx="2542" cy="1853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6" name="TextBox 5"/>
          <p:cNvSpPr txBox="1"/>
          <p:nvPr/>
        </p:nvSpPr>
        <p:spPr>
          <a:xfrm>
            <a:off x="1655345" y="706385"/>
            <a:ext cx="608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MTS</a:t>
            </a:r>
            <a:endParaRPr lang="en-US" b="1" dirty="0"/>
          </a:p>
        </p:txBody>
      </p:sp>
      <p:sp>
        <p:nvSpPr>
          <p:cNvPr id="11" name="Line 114"/>
          <p:cNvSpPr>
            <a:spLocks noChangeShapeType="1"/>
          </p:cNvSpPr>
          <p:nvPr/>
        </p:nvSpPr>
        <p:spPr bwMode="auto">
          <a:xfrm flipH="1">
            <a:off x="3672193" y="1029038"/>
            <a:ext cx="2542" cy="1853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grpSp>
        <p:nvGrpSpPr>
          <p:cNvPr id="38" name="Group 37"/>
          <p:cNvGrpSpPr/>
          <p:nvPr/>
        </p:nvGrpSpPr>
        <p:grpSpPr>
          <a:xfrm>
            <a:off x="685800" y="381000"/>
            <a:ext cx="5662396" cy="1119919"/>
            <a:chOff x="1474788" y="2029496"/>
            <a:chExt cx="5662396" cy="1119919"/>
          </a:xfrm>
        </p:grpSpPr>
        <p:sp>
          <p:nvSpPr>
            <p:cNvPr id="39" name="Rectangle 106"/>
            <p:cNvSpPr>
              <a:spLocks noChangeArrowheads="1"/>
            </p:cNvSpPr>
            <p:nvPr/>
          </p:nvSpPr>
          <p:spPr bwMode="auto">
            <a:xfrm>
              <a:off x="1512903" y="2966937"/>
              <a:ext cx="10164" cy="43446"/>
            </a:xfrm>
            <a:prstGeom prst="rect">
              <a:avLst/>
            </a:prstGeom>
            <a:solidFill>
              <a:srgbClr val="FFFFCC"/>
            </a:solidFill>
            <a:ln w="0">
              <a:solidFill>
                <a:srgbClr val="CCCC99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40" name="Rectangle 107"/>
            <p:cNvSpPr>
              <a:spLocks noChangeArrowheads="1"/>
            </p:cNvSpPr>
            <p:nvPr/>
          </p:nvSpPr>
          <p:spPr bwMode="auto">
            <a:xfrm>
              <a:off x="1523067" y="2966937"/>
              <a:ext cx="5066693" cy="43446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endParaRPr lang="en-US" altLang="en-US" sz="3200"/>
            </a:p>
          </p:txBody>
        </p:sp>
        <p:sp>
          <p:nvSpPr>
            <p:cNvPr id="41" name="Line 111"/>
            <p:cNvSpPr>
              <a:spLocks noChangeShapeType="1"/>
            </p:cNvSpPr>
            <p:nvPr/>
          </p:nvSpPr>
          <p:spPr bwMode="auto">
            <a:xfrm flipH="1">
              <a:off x="5410750" y="2570670"/>
              <a:ext cx="40656" cy="3325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2" name="Rectangle 112"/>
            <p:cNvSpPr>
              <a:spLocks noChangeArrowheads="1"/>
            </p:cNvSpPr>
            <p:nvPr/>
          </p:nvSpPr>
          <p:spPr bwMode="auto">
            <a:xfrm>
              <a:off x="5314806" y="2260609"/>
              <a:ext cx="436018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smtClean="0"/>
                <a:t>Neo</a:t>
              </a:r>
              <a:endParaRPr lang="en-US" altLang="en-US" sz="2000" b="1" dirty="0"/>
            </a:p>
          </p:txBody>
        </p:sp>
        <p:sp>
          <p:nvSpPr>
            <p:cNvPr id="43" name="Line 114"/>
            <p:cNvSpPr>
              <a:spLocks noChangeShapeType="1"/>
            </p:cNvSpPr>
            <p:nvPr/>
          </p:nvSpPr>
          <p:spPr bwMode="auto">
            <a:xfrm flipH="1">
              <a:off x="3459124" y="2763974"/>
              <a:ext cx="2542" cy="1853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4" name="Rectangle 115"/>
            <p:cNvSpPr>
              <a:spLocks noChangeArrowheads="1"/>
            </p:cNvSpPr>
            <p:nvPr/>
          </p:nvSpPr>
          <p:spPr bwMode="auto">
            <a:xfrm>
              <a:off x="3175711" y="2421334"/>
              <a:ext cx="50654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2000" b="1" dirty="0" err="1" smtClean="0"/>
                <a:t>Lig</a:t>
              </a:r>
              <a:r>
                <a:rPr lang="en-US" altLang="en-US" sz="2000" b="1" dirty="0" smtClean="0"/>
                <a:t> A</a:t>
              </a:r>
              <a:endParaRPr lang="en-US" altLang="en-US" sz="2000" b="1" dirty="0"/>
            </a:p>
          </p:txBody>
        </p:sp>
        <p:sp>
          <p:nvSpPr>
            <p:cNvPr id="45" name="Line 117"/>
            <p:cNvSpPr>
              <a:spLocks noChangeShapeType="1"/>
            </p:cNvSpPr>
            <p:nvPr/>
          </p:nvSpPr>
          <p:spPr bwMode="auto">
            <a:xfrm>
              <a:off x="1782246" y="2691770"/>
              <a:ext cx="94015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6" name="Rectangle 118"/>
            <p:cNvSpPr>
              <a:spLocks noChangeArrowheads="1"/>
            </p:cNvSpPr>
            <p:nvPr/>
          </p:nvSpPr>
          <p:spPr bwMode="auto">
            <a:xfrm>
              <a:off x="1474788" y="2462948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>
                  <a:solidFill>
                    <a:srgbClr val="000000"/>
                  </a:solidFill>
                </a:rPr>
                <a:t>LTR</a:t>
              </a:r>
              <a:endParaRPr lang="en-US" altLang="en-US" sz="3200"/>
            </a:p>
          </p:txBody>
        </p:sp>
        <p:sp>
          <p:nvSpPr>
            <p:cNvPr id="47" name="Line 120"/>
            <p:cNvSpPr>
              <a:spLocks noChangeShapeType="1"/>
            </p:cNvSpPr>
            <p:nvPr/>
          </p:nvSpPr>
          <p:spPr bwMode="auto">
            <a:xfrm flipH="1">
              <a:off x="6804523" y="2691770"/>
              <a:ext cx="71147" cy="2114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48" name="Rectangle 121"/>
            <p:cNvSpPr>
              <a:spLocks noChangeArrowheads="1"/>
            </p:cNvSpPr>
            <p:nvPr/>
          </p:nvSpPr>
          <p:spPr bwMode="auto">
            <a:xfrm>
              <a:off x="6885834" y="2462948"/>
              <a:ext cx="2513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>
                  <a:solidFill>
                    <a:srgbClr val="000000"/>
                  </a:solidFill>
                </a:rPr>
                <a:t>LTR</a:t>
              </a:r>
              <a:endParaRPr lang="en-US" altLang="en-US" sz="3200" dirty="0"/>
            </a:p>
          </p:txBody>
        </p:sp>
        <p:sp>
          <p:nvSpPr>
            <p:cNvPr id="49" name="Line 150"/>
            <p:cNvSpPr>
              <a:spLocks noChangeShapeType="1"/>
            </p:cNvSpPr>
            <p:nvPr/>
          </p:nvSpPr>
          <p:spPr bwMode="auto">
            <a:xfrm flipH="1">
              <a:off x="4818704" y="2410146"/>
              <a:ext cx="14855" cy="4930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0" name="Rectangle 151"/>
            <p:cNvSpPr>
              <a:spLocks noChangeArrowheads="1"/>
            </p:cNvSpPr>
            <p:nvPr/>
          </p:nvSpPr>
          <p:spPr bwMode="auto">
            <a:xfrm>
              <a:off x="4647739" y="2169600"/>
              <a:ext cx="3204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altLang="en-US" sz="1400" b="1" dirty="0" smtClean="0">
                  <a:solidFill>
                    <a:srgbClr val="000000"/>
                  </a:solidFill>
                </a:rPr>
                <a:t>IRES</a:t>
              </a:r>
              <a:endParaRPr lang="en-US" altLang="en-US" sz="3200" baseline="-25000" dirty="0"/>
            </a:p>
          </p:txBody>
        </p:sp>
        <p:sp>
          <p:nvSpPr>
            <p:cNvPr id="51" name="Freeform 110" descr="Wide downward diagonal"/>
            <p:cNvSpPr>
              <a:spLocks/>
            </p:cNvSpPr>
            <p:nvPr/>
          </p:nvSpPr>
          <p:spPr bwMode="auto">
            <a:xfrm>
              <a:off x="5098210" y="2833699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wdDnDiag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2" name="Freeform 113" descr="5%"/>
            <p:cNvSpPr>
              <a:spLocks/>
            </p:cNvSpPr>
            <p:nvPr/>
          </p:nvSpPr>
          <p:spPr bwMode="auto">
            <a:xfrm>
              <a:off x="2867828" y="2833699"/>
              <a:ext cx="1516329" cy="307336"/>
            </a:xfrm>
            <a:custGeom>
              <a:avLst/>
              <a:gdLst>
                <a:gd name="T0" fmla="*/ 617436824 w 293"/>
                <a:gd name="T1" fmla="*/ 269655131 h 107"/>
                <a:gd name="T2" fmla="*/ 738404194 w 293"/>
                <a:gd name="T3" fmla="*/ 133567094 h 107"/>
                <a:gd name="T4" fmla="*/ 617436824 w 293"/>
                <a:gd name="T5" fmla="*/ 0 h 107"/>
                <a:gd name="T6" fmla="*/ 617436824 w 293"/>
                <a:gd name="T7" fmla="*/ 60483572 h 107"/>
                <a:gd name="T8" fmla="*/ 0 w 293"/>
                <a:gd name="T9" fmla="*/ 60483572 h 107"/>
                <a:gd name="T10" fmla="*/ 0 w 293"/>
                <a:gd name="T11" fmla="*/ 209171559 h 107"/>
                <a:gd name="T12" fmla="*/ 617436824 w 293"/>
                <a:gd name="T13" fmla="*/ 209171559 h 107"/>
                <a:gd name="T14" fmla="*/ 617436824 w 293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93"/>
                <a:gd name="T25" fmla="*/ 0 h 107"/>
                <a:gd name="T26" fmla="*/ 293 w 293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93" h="107">
                  <a:moveTo>
                    <a:pt x="245" y="107"/>
                  </a:moveTo>
                  <a:lnTo>
                    <a:pt x="293" y="53"/>
                  </a:lnTo>
                  <a:lnTo>
                    <a:pt x="245" y="0"/>
                  </a:lnTo>
                  <a:lnTo>
                    <a:pt x="245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45" y="83"/>
                  </a:lnTo>
                  <a:lnTo>
                    <a:pt x="245" y="107"/>
                  </a:lnTo>
                  <a:close/>
                </a:path>
              </a:pathLst>
            </a:custGeom>
            <a:pattFill prst="dkVert">
              <a:fgClr>
                <a:schemeClr val="tx1"/>
              </a:fgClr>
              <a:bgClr>
                <a:schemeClr val="bg1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3" name="Freeform 116" descr="Small grid"/>
            <p:cNvSpPr>
              <a:spLocks/>
            </p:cNvSpPr>
            <p:nvPr/>
          </p:nvSpPr>
          <p:spPr bwMode="auto">
            <a:xfrm>
              <a:off x="1495116" y="2839492"/>
              <a:ext cx="701308" cy="309923"/>
            </a:xfrm>
            <a:custGeom>
              <a:avLst/>
              <a:gdLst>
                <a:gd name="T0" fmla="*/ 574595625 w 276"/>
                <a:gd name="T1" fmla="*/ 269655131 h 107"/>
                <a:gd name="T2" fmla="*/ 695563125 w 276"/>
                <a:gd name="T3" fmla="*/ 133567094 h 107"/>
                <a:gd name="T4" fmla="*/ 574595625 w 276"/>
                <a:gd name="T5" fmla="*/ 0 h 107"/>
                <a:gd name="T6" fmla="*/ 574595625 w 276"/>
                <a:gd name="T7" fmla="*/ 60483572 h 107"/>
                <a:gd name="T8" fmla="*/ 0 w 276"/>
                <a:gd name="T9" fmla="*/ 60483572 h 107"/>
                <a:gd name="T10" fmla="*/ 0 w 276"/>
                <a:gd name="T11" fmla="*/ 209171559 h 107"/>
                <a:gd name="T12" fmla="*/ 574595625 w 276"/>
                <a:gd name="T13" fmla="*/ 209171559 h 107"/>
                <a:gd name="T14" fmla="*/ 574595625 w 276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76"/>
                <a:gd name="T25" fmla="*/ 0 h 107"/>
                <a:gd name="T26" fmla="*/ 276 w 276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76" h="107">
                  <a:moveTo>
                    <a:pt x="228" y="107"/>
                  </a:moveTo>
                  <a:lnTo>
                    <a:pt x="276" y="53"/>
                  </a:lnTo>
                  <a:lnTo>
                    <a:pt x="228" y="0"/>
                  </a:lnTo>
                  <a:lnTo>
                    <a:pt x="228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28" y="83"/>
                  </a:lnTo>
                  <a:lnTo>
                    <a:pt x="228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4" name="Freeform 119" descr="Small grid"/>
            <p:cNvSpPr>
              <a:spLocks/>
            </p:cNvSpPr>
            <p:nvPr/>
          </p:nvSpPr>
          <p:spPr bwMode="auto">
            <a:xfrm>
              <a:off x="6414603" y="2833699"/>
              <a:ext cx="714013" cy="309923"/>
            </a:xfrm>
            <a:custGeom>
              <a:avLst/>
              <a:gdLst>
                <a:gd name="T0" fmla="*/ 589717223 w 281"/>
                <a:gd name="T1" fmla="*/ 269655131 h 107"/>
                <a:gd name="T2" fmla="*/ 708165494 w 281"/>
                <a:gd name="T3" fmla="*/ 133567094 h 107"/>
                <a:gd name="T4" fmla="*/ 589717223 w 281"/>
                <a:gd name="T5" fmla="*/ 0 h 107"/>
                <a:gd name="T6" fmla="*/ 589717223 w 281"/>
                <a:gd name="T7" fmla="*/ 60483572 h 107"/>
                <a:gd name="T8" fmla="*/ 0 w 281"/>
                <a:gd name="T9" fmla="*/ 60483572 h 107"/>
                <a:gd name="T10" fmla="*/ 0 w 281"/>
                <a:gd name="T11" fmla="*/ 209171559 h 107"/>
                <a:gd name="T12" fmla="*/ 589717223 w 281"/>
                <a:gd name="T13" fmla="*/ 209171559 h 107"/>
                <a:gd name="T14" fmla="*/ 589717223 w 281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81"/>
                <a:gd name="T25" fmla="*/ 0 h 107"/>
                <a:gd name="T26" fmla="*/ 281 w 281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81" h="107">
                  <a:moveTo>
                    <a:pt x="234" y="107"/>
                  </a:moveTo>
                  <a:lnTo>
                    <a:pt x="281" y="53"/>
                  </a:lnTo>
                  <a:lnTo>
                    <a:pt x="234" y="0"/>
                  </a:lnTo>
                  <a:lnTo>
                    <a:pt x="234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234" y="83"/>
                  </a:lnTo>
                  <a:lnTo>
                    <a:pt x="234" y="107"/>
                  </a:lnTo>
                  <a:close/>
                </a:path>
              </a:pathLst>
            </a:custGeom>
            <a:pattFill prst="smGrid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5" name="Rectangle 54"/>
            <p:cNvSpPr/>
            <p:nvPr/>
          </p:nvSpPr>
          <p:spPr bwMode="auto">
            <a:xfrm>
              <a:off x="4609066" y="2919212"/>
              <a:ext cx="450471" cy="13889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3200"/>
            </a:p>
          </p:txBody>
        </p:sp>
        <p:sp>
          <p:nvSpPr>
            <p:cNvPr id="56" name="Freeform 110" descr="Wide downward diagonal"/>
            <p:cNvSpPr>
              <a:spLocks/>
            </p:cNvSpPr>
            <p:nvPr/>
          </p:nvSpPr>
          <p:spPr bwMode="auto">
            <a:xfrm>
              <a:off x="5757730" y="2831112"/>
              <a:ext cx="622538" cy="309923"/>
            </a:xfrm>
            <a:custGeom>
              <a:avLst/>
              <a:gdLst>
                <a:gd name="T0" fmla="*/ 493951260 w 245"/>
                <a:gd name="T1" fmla="*/ 269655131 h 107"/>
                <a:gd name="T2" fmla="*/ 617439869 w 245"/>
                <a:gd name="T3" fmla="*/ 133567094 h 107"/>
                <a:gd name="T4" fmla="*/ 493951260 w 245"/>
                <a:gd name="T5" fmla="*/ 0 h 107"/>
                <a:gd name="T6" fmla="*/ 493951260 w 245"/>
                <a:gd name="T7" fmla="*/ 60483572 h 107"/>
                <a:gd name="T8" fmla="*/ 0 w 245"/>
                <a:gd name="T9" fmla="*/ 60483572 h 107"/>
                <a:gd name="T10" fmla="*/ 0 w 245"/>
                <a:gd name="T11" fmla="*/ 209171559 h 107"/>
                <a:gd name="T12" fmla="*/ 493951260 w 245"/>
                <a:gd name="T13" fmla="*/ 209171559 h 107"/>
                <a:gd name="T14" fmla="*/ 493951260 w 245"/>
                <a:gd name="T15" fmla="*/ 269655131 h 107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w 245"/>
                <a:gd name="T25" fmla="*/ 0 h 107"/>
                <a:gd name="T26" fmla="*/ 245 w 245"/>
                <a:gd name="T27" fmla="*/ 107 h 107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T24" t="T25" r="T26" b="T27"/>
              <a:pathLst>
                <a:path w="245" h="107">
                  <a:moveTo>
                    <a:pt x="196" y="107"/>
                  </a:moveTo>
                  <a:lnTo>
                    <a:pt x="245" y="53"/>
                  </a:lnTo>
                  <a:lnTo>
                    <a:pt x="196" y="0"/>
                  </a:lnTo>
                  <a:lnTo>
                    <a:pt x="196" y="24"/>
                  </a:lnTo>
                  <a:lnTo>
                    <a:pt x="0" y="24"/>
                  </a:lnTo>
                  <a:lnTo>
                    <a:pt x="0" y="83"/>
                  </a:lnTo>
                  <a:lnTo>
                    <a:pt x="196" y="83"/>
                  </a:lnTo>
                  <a:lnTo>
                    <a:pt x="196" y="107"/>
                  </a:lnTo>
                  <a:close/>
                </a:path>
              </a:pathLst>
            </a:custGeom>
            <a:pattFill prst="pct10">
              <a:fgClr>
                <a:schemeClr val="tx1"/>
              </a:fgClr>
              <a:bgClr>
                <a:srgbClr val="FFFFFF"/>
              </a:bgClr>
            </a:patt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sz="320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638800" y="2029496"/>
              <a:ext cx="8226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WPRE</a:t>
              </a:r>
              <a:endParaRPr lang="en-US" sz="2000" b="1" dirty="0"/>
            </a:p>
          </p:txBody>
        </p:sp>
        <p:cxnSp>
          <p:nvCxnSpPr>
            <p:cNvPr id="58" name="Straight Connector 57"/>
            <p:cNvCxnSpPr/>
            <p:nvPr/>
          </p:nvCxnSpPr>
          <p:spPr>
            <a:xfrm flipH="1">
              <a:off x="6049612" y="2361910"/>
              <a:ext cx="9175" cy="5550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9" name="Rectangle 58"/>
          <p:cNvSpPr/>
          <p:nvPr/>
        </p:nvSpPr>
        <p:spPr bwMode="auto">
          <a:xfrm>
            <a:off x="3593451" y="1239405"/>
            <a:ext cx="154880" cy="16806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3200"/>
          </a:p>
        </p:txBody>
      </p:sp>
      <p:sp>
        <p:nvSpPr>
          <p:cNvPr id="60" name="Rectangle 59"/>
          <p:cNvSpPr/>
          <p:nvPr/>
        </p:nvSpPr>
        <p:spPr bwMode="auto">
          <a:xfrm>
            <a:off x="1797356" y="1254718"/>
            <a:ext cx="267762" cy="15275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3200"/>
          </a:p>
        </p:txBody>
      </p:sp>
      <p:sp>
        <p:nvSpPr>
          <p:cNvPr id="63" name="Line 114"/>
          <p:cNvSpPr>
            <a:spLocks noChangeShapeType="1"/>
          </p:cNvSpPr>
          <p:nvPr/>
        </p:nvSpPr>
        <p:spPr bwMode="auto">
          <a:xfrm flipH="1">
            <a:off x="3632436" y="2566850"/>
            <a:ext cx="2542" cy="1853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65" name="Rectangle 106"/>
          <p:cNvSpPr>
            <a:spLocks noChangeArrowheads="1"/>
          </p:cNvSpPr>
          <p:nvPr/>
        </p:nvSpPr>
        <p:spPr bwMode="auto">
          <a:xfrm>
            <a:off x="684158" y="2856253"/>
            <a:ext cx="10164" cy="43446"/>
          </a:xfrm>
          <a:prstGeom prst="rect">
            <a:avLst/>
          </a:prstGeom>
          <a:solidFill>
            <a:srgbClr val="FFFFCC"/>
          </a:solidFill>
          <a:ln w="0">
            <a:solidFill>
              <a:srgbClr val="CCCC99"/>
            </a:solidFill>
            <a:miter lim="800000"/>
            <a:headEnd/>
            <a:tailEnd/>
          </a:ln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endParaRPr lang="en-US" altLang="en-US" sz="3200"/>
          </a:p>
        </p:txBody>
      </p:sp>
      <p:sp>
        <p:nvSpPr>
          <p:cNvPr id="66" name="Rectangle 107"/>
          <p:cNvSpPr>
            <a:spLocks noChangeArrowheads="1"/>
          </p:cNvSpPr>
          <p:nvPr/>
        </p:nvSpPr>
        <p:spPr bwMode="auto">
          <a:xfrm>
            <a:off x="694322" y="2856253"/>
            <a:ext cx="5066693" cy="43446"/>
          </a:xfrm>
          <a:prstGeom prst="rect">
            <a:avLst/>
          </a:prstGeom>
          <a:solidFill>
            <a:schemeClr val="tx1"/>
          </a:solidFill>
          <a:ln w="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endParaRPr lang="en-US" altLang="en-US" sz="3200"/>
          </a:p>
        </p:txBody>
      </p:sp>
      <p:sp>
        <p:nvSpPr>
          <p:cNvPr id="67" name="Line 111"/>
          <p:cNvSpPr>
            <a:spLocks noChangeShapeType="1"/>
          </p:cNvSpPr>
          <p:nvPr/>
        </p:nvSpPr>
        <p:spPr bwMode="auto">
          <a:xfrm flipH="1">
            <a:off x="4582005" y="2459986"/>
            <a:ext cx="40656" cy="332544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68" name="Rectangle 112"/>
          <p:cNvSpPr>
            <a:spLocks noChangeArrowheads="1"/>
          </p:cNvSpPr>
          <p:nvPr/>
        </p:nvSpPr>
        <p:spPr bwMode="auto">
          <a:xfrm>
            <a:off x="4486061" y="2149925"/>
            <a:ext cx="436018" cy="307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2000" b="1" dirty="0" smtClean="0"/>
              <a:t>Neo</a:t>
            </a:r>
            <a:endParaRPr lang="en-US" altLang="en-US" sz="2000" b="1" dirty="0"/>
          </a:p>
        </p:txBody>
      </p:sp>
      <p:sp>
        <p:nvSpPr>
          <p:cNvPr id="69" name="Line 114"/>
          <p:cNvSpPr>
            <a:spLocks noChangeShapeType="1"/>
          </p:cNvSpPr>
          <p:nvPr/>
        </p:nvSpPr>
        <p:spPr bwMode="auto">
          <a:xfrm flipH="1">
            <a:off x="2630379" y="2653290"/>
            <a:ext cx="2542" cy="1853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70" name="Rectangle 115"/>
          <p:cNvSpPr>
            <a:spLocks noChangeArrowheads="1"/>
          </p:cNvSpPr>
          <p:nvPr/>
        </p:nvSpPr>
        <p:spPr bwMode="auto">
          <a:xfrm>
            <a:off x="2346966" y="2310650"/>
            <a:ext cx="5065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2000" b="1" dirty="0" err="1" smtClean="0"/>
              <a:t>Lig</a:t>
            </a:r>
            <a:r>
              <a:rPr lang="en-US" altLang="en-US" sz="2000" b="1" dirty="0" smtClean="0"/>
              <a:t> A</a:t>
            </a:r>
            <a:endParaRPr lang="en-US" altLang="en-US" sz="2000" b="1" dirty="0"/>
          </a:p>
        </p:txBody>
      </p:sp>
      <p:sp>
        <p:nvSpPr>
          <p:cNvPr id="71" name="Line 117"/>
          <p:cNvSpPr>
            <a:spLocks noChangeShapeType="1"/>
          </p:cNvSpPr>
          <p:nvPr/>
        </p:nvSpPr>
        <p:spPr bwMode="auto">
          <a:xfrm>
            <a:off x="953501" y="2581086"/>
            <a:ext cx="94015" cy="211444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72" name="Rectangle 118"/>
          <p:cNvSpPr>
            <a:spLocks noChangeArrowheads="1"/>
          </p:cNvSpPr>
          <p:nvPr/>
        </p:nvSpPr>
        <p:spPr bwMode="auto">
          <a:xfrm>
            <a:off x="646043" y="2352264"/>
            <a:ext cx="2513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400" b="1">
                <a:solidFill>
                  <a:srgbClr val="000000"/>
                </a:solidFill>
              </a:rPr>
              <a:t>LTR</a:t>
            </a:r>
            <a:endParaRPr lang="en-US" altLang="en-US" sz="3200"/>
          </a:p>
        </p:txBody>
      </p:sp>
      <p:sp>
        <p:nvSpPr>
          <p:cNvPr id="73" name="Line 120"/>
          <p:cNvSpPr>
            <a:spLocks noChangeShapeType="1"/>
          </p:cNvSpPr>
          <p:nvPr/>
        </p:nvSpPr>
        <p:spPr bwMode="auto">
          <a:xfrm flipH="1">
            <a:off x="5975778" y="2581086"/>
            <a:ext cx="71147" cy="211444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74" name="Rectangle 121"/>
          <p:cNvSpPr>
            <a:spLocks noChangeArrowheads="1"/>
          </p:cNvSpPr>
          <p:nvPr/>
        </p:nvSpPr>
        <p:spPr bwMode="auto">
          <a:xfrm>
            <a:off x="6057089" y="2352264"/>
            <a:ext cx="2513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400" b="1" dirty="0">
                <a:solidFill>
                  <a:srgbClr val="000000"/>
                </a:solidFill>
              </a:rPr>
              <a:t>LTR</a:t>
            </a:r>
            <a:endParaRPr lang="en-US" altLang="en-US" sz="3200" dirty="0"/>
          </a:p>
        </p:txBody>
      </p:sp>
      <p:sp>
        <p:nvSpPr>
          <p:cNvPr id="75" name="Line 150"/>
          <p:cNvSpPr>
            <a:spLocks noChangeShapeType="1"/>
          </p:cNvSpPr>
          <p:nvPr/>
        </p:nvSpPr>
        <p:spPr bwMode="auto">
          <a:xfrm flipH="1">
            <a:off x="3989959" y="2299462"/>
            <a:ext cx="14855" cy="493069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3200"/>
          </a:p>
        </p:txBody>
      </p:sp>
      <p:sp>
        <p:nvSpPr>
          <p:cNvPr id="76" name="Rectangle 151"/>
          <p:cNvSpPr>
            <a:spLocks noChangeArrowheads="1"/>
          </p:cNvSpPr>
          <p:nvPr/>
        </p:nvSpPr>
        <p:spPr bwMode="auto">
          <a:xfrm>
            <a:off x="3818994" y="2058916"/>
            <a:ext cx="3204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400" b="1" dirty="0" smtClean="0">
                <a:solidFill>
                  <a:srgbClr val="000000"/>
                </a:solidFill>
              </a:rPr>
              <a:t>IRES</a:t>
            </a:r>
            <a:endParaRPr lang="en-US" altLang="en-US" sz="3200" baseline="-25000" dirty="0"/>
          </a:p>
        </p:txBody>
      </p:sp>
      <p:sp>
        <p:nvSpPr>
          <p:cNvPr id="77" name="Freeform 110" descr="Wide downward diagonal"/>
          <p:cNvSpPr>
            <a:spLocks/>
          </p:cNvSpPr>
          <p:nvPr/>
        </p:nvSpPr>
        <p:spPr bwMode="auto">
          <a:xfrm>
            <a:off x="4269465" y="2723015"/>
            <a:ext cx="622538" cy="309923"/>
          </a:xfrm>
          <a:custGeom>
            <a:avLst/>
            <a:gdLst>
              <a:gd name="T0" fmla="*/ 493951260 w 245"/>
              <a:gd name="T1" fmla="*/ 269655131 h 107"/>
              <a:gd name="T2" fmla="*/ 617439869 w 245"/>
              <a:gd name="T3" fmla="*/ 133567094 h 107"/>
              <a:gd name="T4" fmla="*/ 493951260 w 245"/>
              <a:gd name="T5" fmla="*/ 0 h 107"/>
              <a:gd name="T6" fmla="*/ 493951260 w 245"/>
              <a:gd name="T7" fmla="*/ 60483572 h 107"/>
              <a:gd name="T8" fmla="*/ 0 w 245"/>
              <a:gd name="T9" fmla="*/ 60483572 h 107"/>
              <a:gd name="T10" fmla="*/ 0 w 245"/>
              <a:gd name="T11" fmla="*/ 209171559 h 107"/>
              <a:gd name="T12" fmla="*/ 493951260 w 245"/>
              <a:gd name="T13" fmla="*/ 209171559 h 107"/>
              <a:gd name="T14" fmla="*/ 493951260 w 245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45"/>
              <a:gd name="T25" fmla="*/ 0 h 107"/>
              <a:gd name="T26" fmla="*/ 245 w 245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45" h="107">
                <a:moveTo>
                  <a:pt x="196" y="107"/>
                </a:moveTo>
                <a:lnTo>
                  <a:pt x="245" y="53"/>
                </a:lnTo>
                <a:lnTo>
                  <a:pt x="196" y="0"/>
                </a:lnTo>
                <a:lnTo>
                  <a:pt x="196" y="24"/>
                </a:lnTo>
                <a:lnTo>
                  <a:pt x="0" y="24"/>
                </a:lnTo>
                <a:lnTo>
                  <a:pt x="0" y="83"/>
                </a:lnTo>
                <a:lnTo>
                  <a:pt x="196" y="83"/>
                </a:lnTo>
                <a:lnTo>
                  <a:pt x="196" y="107"/>
                </a:lnTo>
                <a:close/>
              </a:path>
            </a:pathLst>
          </a:custGeom>
          <a:pattFill prst="wdDnDiag">
            <a:fgClr>
              <a:schemeClr val="tx1"/>
            </a:fgClr>
            <a:bgClr>
              <a:srgbClr val="FFFFFF"/>
            </a:bgClr>
          </a:pattFill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78" name="Freeform 113" descr="5%"/>
          <p:cNvSpPr>
            <a:spLocks/>
          </p:cNvSpPr>
          <p:nvPr/>
        </p:nvSpPr>
        <p:spPr bwMode="auto">
          <a:xfrm>
            <a:off x="1757599" y="2723015"/>
            <a:ext cx="1797813" cy="307336"/>
          </a:xfrm>
          <a:custGeom>
            <a:avLst/>
            <a:gdLst>
              <a:gd name="T0" fmla="*/ 617436824 w 293"/>
              <a:gd name="T1" fmla="*/ 269655131 h 107"/>
              <a:gd name="T2" fmla="*/ 738404194 w 293"/>
              <a:gd name="T3" fmla="*/ 133567094 h 107"/>
              <a:gd name="T4" fmla="*/ 617436824 w 293"/>
              <a:gd name="T5" fmla="*/ 0 h 107"/>
              <a:gd name="T6" fmla="*/ 617436824 w 293"/>
              <a:gd name="T7" fmla="*/ 60483572 h 107"/>
              <a:gd name="T8" fmla="*/ 0 w 293"/>
              <a:gd name="T9" fmla="*/ 60483572 h 107"/>
              <a:gd name="T10" fmla="*/ 0 w 293"/>
              <a:gd name="T11" fmla="*/ 209171559 h 107"/>
              <a:gd name="T12" fmla="*/ 617436824 w 293"/>
              <a:gd name="T13" fmla="*/ 209171559 h 107"/>
              <a:gd name="T14" fmla="*/ 617436824 w 293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93"/>
              <a:gd name="T25" fmla="*/ 0 h 107"/>
              <a:gd name="T26" fmla="*/ 293 w 293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93" h="107">
                <a:moveTo>
                  <a:pt x="245" y="107"/>
                </a:moveTo>
                <a:lnTo>
                  <a:pt x="293" y="53"/>
                </a:lnTo>
                <a:lnTo>
                  <a:pt x="245" y="0"/>
                </a:lnTo>
                <a:lnTo>
                  <a:pt x="245" y="24"/>
                </a:lnTo>
                <a:lnTo>
                  <a:pt x="0" y="24"/>
                </a:lnTo>
                <a:lnTo>
                  <a:pt x="0" y="83"/>
                </a:lnTo>
                <a:lnTo>
                  <a:pt x="245" y="83"/>
                </a:lnTo>
                <a:lnTo>
                  <a:pt x="245" y="107"/>
                </a:lnTo>
                <a:close/>
              </a:path>
            </a:pathLst>
          </a:custGeom>
          <a:pattFill prst="dkVert">
            <a:fgClr>
              <a:schemeClr val="tx1"/>
            </a:fgClr>
            <a:bgClr>
              <a:schemeClr val="bg1"/>
            </a:bgClr>
          </a:pattFill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79" name="Freeform 116" descr="Small grid"/>
          <p:cNvSpPr>
            <a:spLocks/>
          </p:cNvSpPr>
          <p:nvPr/>
        </p:nvSpPr>
        <p:spPr bwMode="auto">
          <a:xfrm>
            <a:off x="666371" y="2728808"/>
            <a:ext cx="701308" cy="309923"/>
          </a:xfrm>
          <a:custGeom>
            <a:avLst/>
            <a:gdLst>
              <a:gd name="T0" fmla="*/ 574595625 w 276"/>
              <a:gd name="T1" fmla="*/ 269655131 h 107"/>
              <a:gd name="T2" fmla="*/ 695563125 w 276"/>
              <a:gd name="T3" fmla="*/ 133567094 h 107"/>
              <a:gd name="T4" fmla="*/ 574595625 w 276"/>
              <a:gd name="T5" fmla="*/ 0 h 107"/>
              <a:gd name="T6" fmla="*/ 574595625 w 276"/>
              <a:gd name="T7" fmla="*/ 60483572 h 107"/>
              <a:gd name="T8" fmla="*/ 0 w 276"/>
              <a:gd name="T9" fmla="*/ 60483572 h 107"/>
              <a:gd name="T10" fmla="*/ 0 w 276"/>
              <a:gd name="T11" fmla="*/ 209171559 h 107"/>
              <a:gd name="T12" fmla="*/ 574595625 w 276"/>
              <a:gd name="T13" fmla="*/ 209171559 h 107"/>
              <a:gd name="T14" fmla="*/ 574595625 w 276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76"/>
              <a:gd name="T25" fmla="*/ 0 h 107"/>
              <a:gd name="T26" fmla="*/ 276 w 276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76" h="107">
                <a:moveTo>
                  <a:pt x="228" y="107"/>
                </a:moveTo>
                <a:lnTo>
                  <a:pt x="276" y="53"/>
                </a:lnTo>
                <a:lnTo>
                  <a:pt x="228" y="0"/>
                </a:lnTo>
                <a:lnTo>
                  <a:pt x="228" y="24"/>
                </a:lnTo>
                <a:lnTo>
                  <a:pt x="0" y="24"/>
                </a:lnTo>
                <a:lnTo>
                  <a:pt x="0" y="83"/>
                </a:lnTo>
                <a:lnTo>
                  <a:pt x="228" y="83"/>
                </a:lnTo>
                <a:lnTo>
                  <a:pt x="228" y="107"/>
                </a:lnTo>
                <a:close/>
              </a:path>
            </a:pathLst>
          </a:custGeom>
          <a:pattFill prst="smGrid">
            <a:fgClr>
              <a:schemeClr val="tx1"/>
            </a:fgClr>
            <a:bgClr>
              <a:srgbClr val="FFFFFF"/>
            </a:bgClr>
          </a:pattFill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80" name="Freeform 119" descr="Small grid"/>
          <p:cNvSpPr>
            <a:spLocks/>
          </p:cNvSpPr>
          <p:nvPr/>
        </p:nvSpPr>
        <p:spPr bwMode="auto">
          <a:xfrm>
            <a:off x="5585858" y="2723015"/>
            <a:ext cx="714013" cy="309923"/>
          </a:xfrm>
          <a:custGeom>
            <a:avLst/>
            <a:gdLst>
              <a:gd name="T0" fmla="*/ 589717223 w 281"/>
              <a:gd name="T1" fmla="*/ 269655131 h 107"/>
              <a:gd name="T2" fmla="*/ 708165494 w 281"/>
              <a:gd name="T3" fmla="*/ 133567094 h 107"/>
              <a:gd name="T4" fmla="*/ 589717223 w 281"/>
              <a:gd name="T5" fmla="*/ 0 h 107"/>
              <a:gd name="T6" fmla="*/ 589717223 w 281"/>
              <a:gd name="T7" fmla="*/ 60483572 h 107"/>
              <a:gd name="T8" fmla="*/ 0 w 281"/>
              <a:gd name="T9" fmla="*/ 60483572 h 107"/>
              <a:gd name="T10" fmla="*/ 0 w 281"/>
              <a:gd name="T11" fmla="*/ 209171559 h 107"/>
              <a:gd name="T12" fmla="*/ 589717223 w 281"/>
              <a:gd name="T13" fmla="*/ 209171559 h 107"/>
              <a:gd name="T14" fmla="*/ 589717223 w 281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81"/>
              <a:gd name="T25" fmla="*/ 0 h 107"/>
              <a:gd name="T26" fmla="*/ 281 w 281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81" h="107">
                <a:moveTo>
                  <a:pt x="234" y="107"/>
                </a:moveTo>
                <a:lnTo>
                  <a:pt x="281" y="53"/>
                </a:lnTo>
                <a:lnTo>
                  <a:pt x="234" y="0"/>
                </a:lnTo>
                <a:lnTo>
                  <a:pt x="234" y="24"/>
                </a:lnTo>
                <a:lnTo>
                  <a:pt x="0" y="24"/>
                </a:lnTo>
                <a:lnTo>
                  <a:pt x="0" y="83"/>
                </a:lnTo>
                <a:lnTo>
                  <a:pt x="234" y="83"/>
                </a:lnTo>
                <a:lnTo>
                  <a:pt x="234" y="107"/>
                </a:lnTo>
                <a:close/>
              </a:path>
            </a:pathLst>
          </a:custGeom>
          <a:pattFill prst="smGrid">
            <a:fgClr>
              <a:schemeClr val="tx1"/>
            </a:fgClr>
            <a:bgClr>
              <a:srgbClr val="FFFFFF"/>
            </a:bgClr>
          </a:pattFill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81" name="Rectangle 80"/>
          <p:cNvSpPr/>
          <p:nvPr/>
        </p:nvSpPr>
        <p:spPr bwMode="auto">
          <a:xfrm>
            <a:off x="3780321" y="2808528"/>
            <a:ext cx="450471" cy="13889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3200"/>
          </a:p>
        </p:txBody>
      </p:sp>
      <p:sp>
        <p:nvSpPr>
          <p:cNvPr id="82" name="Freeform 110" descr="Wide downward diagonal"/>
          <p:cNvSpPr>
            <a:spLocks/>
          </p:cNvSpPr>
          <p:nvPr/>
        </p:nvSpPr>
        <p:spPr bwMode="auto">
          <a:xfrm>
            <a:off x="4928985" y="2720428"/>
            <a:ext cx="622538" cy="309923"/>
          </a:xfrm>
          <a:custGeom>
            <a:avLst/>
            <a:gdLst>
              <a:gd name="T0" fmla="*/ 493951260 w 245"/>
              <a:gd name="T1" fmla="*/ 269655131 h 107"/>
              <a:gd name="T2" fmla="*/ 617439869 w 245"/>
              <a:gd name="T3" fmla="*/ 133567094 h 107"/>
              <a:gd name="T4" fmla="*/ 493951260 w 245"/>
              <a:gd name="T5" fmla="*/ 0 h 107"/>
              <a:gd name="T6" fmla="*/ 493951260 w 245"/>
              <a:gd name="T7" fmla="*/ 60483572 h 107"/>
              <a:gd name="T8" fmla="*/ 0 w 245"/>
              <a:gd name="T9" fmla="*/ 60483572 h 107"/>
              <a:gd name="T10" fmla="*/ 0 w 245"/>
              <a:gd name="T11" fmla="*/ 209171559 h 107"/>
              <a:gd name="T12" fmla="*/ 493951260 w 245"/>
              <a:gd name="T13" fmla="*/ 209171559 h 107"/>
              <a:gd name="T14" fmla="*/ 493951260 w 245"/>
              <a:gd name="T15" fmla="*/ 269655131 h 107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245"/>
              <a:gd name="T25" fmla="*/ 0 h 107"/>
              <a:gd name="T26" fmla="*/ 245 w 245"/>
              <a:gd name="T27" fmla="*/ 107 h 107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45" h="107">
                <a:moveTo>
                  <a:pt x="196" y="107"/>
                </a:moveTo>
                <a:lnTo>
                  <a:pt x="245" y="53"/>
                </a:lnTo>
                <a:lnTo>
                  <a:pt x="196" y="0"/>
                </a:lnTo>
                <a:lnTo>
                  <a:pt x="196" y="24"/>
                </a:lnTo>
                <a:lnTo>
                  <a:pt x="0" y="24"/>
                </a:lnTo>
                <a:lnTo>
                  <a:pt x="0" y="83"/>
                </a:lnTo>
                <a:lnTo>
                  <a:pt x="196" y="83"/>
                </a:lnTo>
                <a:lnTo>
                  <a:pt x="196" y="107"/>
                </a:lnTo>
                <a:close/>
              </a:path>
            </a:pathLst>
          </a:custGeom>
          <a:pattFill prst="pct10">
            <a:fgClr>
              <a:schemeClr val="tx1"/>
            </a:fgClr>
            <a:bgClr>
              <a:srgbClr val="FFFFFF"/>
            </a:bgClr>
          </a:pattFill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 sz="3200"/>
          </a:p>
        </p:txBody>
      </p:sp>
      <p:sp>
        <p:nvSpPr>
          <p:cNvPr id="83" name="TextBox 82"/>
          <p:cNvSpPr txBox="1"/>
          <p:nvPr/>
        </p:nvSpPr>
        <p:spPr>
          <a:xfrm>
            <a:off x="4810055" y="1918812"/>
            <a:ext cx="8226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WPRE</a:t>
            </a:r>
            <a:endParaRPr lang="en-US" sz="2000" b="1" dirty="0"/>
          </a:p>
        </p:txBody>
      </p:sp>
      <p:cxnSp>
        <p:nvCxnSpPr>
          <p:cNvPr id="84" name="Straight Connector 83"/>
          <p:cNvCxnSpPr/>
          <p:nvPr/>
        </p:nvCxnSpPr>
        <p:spPr>
          <a:xfrm flipH="1">
            <a:off x="5220867" y="2251226"/>
            <a:ext cx="9175" cy="55504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Rectangle 84"/>
          <p:cNvSpPr/>
          <p:nvPr/>
        </p:nvSpPr>
        <p:spPr bwMode="auto">
          <a:xfrm>
            <a:off x="3553694" y="2777217"/>
            <a:ext cx="154880" cy="16806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3200"/>
          </a:p>
        </p:txBody>
      </p:sp>
      <p:sp>
        <p:nvSpPr>
          <p:cNvPr id="87" name="TextBox 86"/>
          <p:cNvSpPr txBox="1"/>
          <p:nvPr/>
        </p:nvSpPr>
        <p:spPr>
          <a:xfrm>
            <a:off x="3410161" y="701576"/>
            <a:ext cx="545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/>
              <a:t>Myc</a:t>
            </a:r>
            <a:endParaRPr lang="en-US" sz="1600" b="1" dirty="0"/>
          </a:p>
        </p:txBody>
      </p:sp>
      <p:sp>
        <p:nvSpPr>
          <p:cNvPr id="88" name="TextBox 87"/>
          <p:cNvSpPr txBox="1"/>
          <p:nvPr/>
        </p:nvSpPr>
        <p:spPr>
          <a:xfrm>
            <a:off x="3356014" y="2257790"/>
            <a:ext cx="545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/>
              <a:t>Myc</a:t>
            </a:r>
            <a:endParaRPr lang="en-US" sz="1600" b="1" dirty="0"/>
          </a:p>
        </p:txBody>
      </p:sp>
      <p:sp>
        <p:nvSpPr>
          <p:cNvPr id="89" name="TextBox 88"/>
          <p:cNvSpPr txBox="1"/>
          <p:nvPr/>
        </p:nvSpPr>
        <p:spPr>
          <a:xfrm>
            <a:off x="383450" y="381000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</a:t>
            </a:r>
            <a:endParaRPr lang="en-US" dirty="0"/>
          </a:p>
        </p:txBody>
      </p:sp>
      <p:sp>
        <p:nvSpPr>
          <p:cNvPr id="90" name="TextBox 89"/>
          <p:cNvSpPr txBox="1"/>
          <p:nvPr/>
        </p:nvSpPr>
        <p:spPr>
          <a:xfrm>
            <a:off x="383450" y="1934201"/>
            <a:ext cx="25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J</a:t>
            </a:r>
            <a:endParaRPr lang="en-US" dirty="0"/>
          </a:p>
        </p:txBody>
      </p:sp>
      <p:sp>
        <p:nvSpPr>
          <p:cNvPr id="61" name="TextBox 60"/>
          <p:cNvSpPr txBox="1"/>
          <p:nvPr/>
        </p:nvSpPr>
        <p:spPr>
          <a:xfrm>
            <a:off x="389283" y="640080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1 Fig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6653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22</Words>
  <Application>Microsoft Office PowerPoint</Application>
  <PresentationFormat>On-screen Show (4:3)</PresentationFormat>
  <Paragraphs>93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ourier New</vt:lpstr>
      <vt:lpstr>Office Them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sha</dc:creator>
  <cp:lastModifiedBy>Misha</cp:lastModifiedBy>
  <cp:revision>7</cp:revision>
  <dcterms:created xsi:type="dcterms:W3CDTF">2015-08-05T18:13:57Z</dcterms:created>
  <dcterms:modified xsi:type="dcterms:W3CDTF">2016-03-03T23:29:26Z</dcterms:modified>
</cp:coreProperties>
</file>